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microsoft.com/office/2020/02/relationships/classificationlabels" Target="docMetadata/LabelInfo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E8B0"/>
    <a:srgbClr val="ECF1E6"/>
    <a:srgbClr val="4A9E97"/>
    <a:srgbClr val="EE851E"/>
    <a:srgbClr val="054D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44" autoAdjust="0"/>
    <p:restoredTop sz="83643" autoAdjust="0"/>
  </p:normalViewPr>
  <p:slideViewPr>
    <p:cSldViewPr snapToGrid="0">
      <p:cViewPr varScale="1">
        <p:scale>
          <a:sx n="81" d="100"/>
          <a:sy n="81" d="100"/>
        </p:scale>
        <p:origin x="462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BF1134-3B87-450B-8197-6B236F7052BE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EF0EC3-8FCE-4395-8081-69E47CFBD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084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983122E-79D9-8F3F-1BDC-EDD7485299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6E30938-14C1-18E7-44BC-8BB65DF167A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404C57A-A45D-04E2-28D2-BCB4E12E40E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35DB06-6752-7529-F26E-A8B14B3AA91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EF0EC3-8FCE-4395-8081-69E47CFBD8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5919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18604-D5E9-349E-BCD2-341823C70C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F41F65-DBB2-FAB7-33BD-CF2F75BAE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C37D36-FE8F-3364-A070-F56431383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DF7ED-356F-5606-B4C3-C91187AC0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22AF6D-46EF-2901-6D7D-29FC199C1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293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D2F74-79D4-7928-02BC-EBC94FC312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DC186C-F366-6AF7-D8EC-D948B01713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54F98E-02C4-3CD2-7BD7-5A00B01B8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FFA1A4-B93D-A87C-FE51-A9A6A5781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AF25AC-004F-F358-82CB-F0EE1A968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888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9372D0-29E7-99FB-12A1-059ED6CE26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232B58-21BF-8F71-B019-CE4B59FD44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C33B73-1A37-C48E-7F02-CFFDE048E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AC7D5F-F1DC-FEAD-5A43-72B3DEA6E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5D7EE-267F-A1BA-8CBF-3174C4943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590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65AC82-EAB3-D31F-F696-F69CC9CAE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B4E946-ED51-2C57-6015-E5C1DC178B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5F1E06-D1C7-BAC2-BC34-B4F30A297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8CECC3-7209-9C0C-C64B-7D873EACD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F6EAF6-E74C-239E-7803-F7ED34383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755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E373A7-8939-2342-6E59-0CEAFC57D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1FA472-466D-D0AC-7132-9F8204781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FC57E3-CE32-06B1-8CCC-7AF7F9370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382A28-E126-DC64-8682-87915F412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CF8BF2-DE6D-4533-E6AE-3F842D64F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724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BE73F-7CD0-0A41-D74B-D31929F89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A3EDEF-64EF-847C-0ABE-814A2438B7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C5F5F-FA90-9BC8-2A1C-828E118115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8997DA-AE01-03E0-4E76-69BFCDEB4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77C80B-4C57-EAE5-3069-FD2F53FF3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625198-FE2F-9DCE-7C1C-C3CAFE045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004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B820AC-6938-65AC-7011-8EE97C35A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4726CD-E2FC-D604-C83E-8257CBAE37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281CD2-8911-06A5-723E-35FB45483F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FFD291-6639-47FE-AB66-D5DA6037CA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9059D6-8A81-A94D-C72D-366A92F8C9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C02EB4-486E-3F4A-5518-C55EBA053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0D81BB-875B-8BF6-620B-B4EEA46CC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E72D20-5CA5-4F86-2A44-4E4AC5BBE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090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3E16A1-F9F8-4500-C88C-CEC392116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A4FA02-4C68-3793-1D39-C62101790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B1177C-268C-EEC0-E59A-4F3D9678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682439-0FBA-E274-2B58-E18AAE37B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6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5690FD-EF61-3DAF-9B54-066A7B046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6B8B27-B4FD-2257-8BAD-9ADE3CC97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0246E2-0699-4FE1-03AB-2DCD55A98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312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4F6846-25A6-95FF-7489-9E3BDA42D0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5F067C-5FC0-8EB9-E13C-01CD9539F4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C204BF-0A28-1D90-0FA1-8AB3485CF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FE7D4F-8386-E28D-BC4A-7230869AB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BC1CA7-4B2A-E106-B2DA-E34C5908A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8A9473-5F57-3348-0224-DEF64D8B3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59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93C0F-53F5-5977-6B1E-A445D32767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5F8930-AD65-B8B2-D35B-1E69143202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5261F3-BE4E-1002-73A0-DE9D59B27B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779CDD-069F-346D-D49A-BFB6B7D55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688FB5-BDBE-96BE-6DD0-2F8E18490E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12A24E-31BF-E3BE-89AB-7D7F08C2C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307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B9282A-9807-3B7E-3BB2-487EDF222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D2459D-E651-BBB6-342D-FBD1298065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0981F9-4C22-24AD-A04B-B89D2A027A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0172BF-2AEE-4CEE-88A6-424C4FFFC3A2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D6155-823B-27C4-0B8C-C0D73E1FB2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0FC94-C1E2-8318-E799-16B4B9229A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6FF879-1827-4E8B-99E1-20B836026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6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image" Target="../media/image3.png"/><Relationship Id="rId26" Type="http://schemas.openxmlformats.org/officeDocument/2006/relationships/image" Target="../media/image11.png"/><Relationship Id="rId3" Type="http://schemas.openxmlformats.org/officeDocument/2006/relationships/tags" Target="../tags/tag3.xml"/><Relationship Id="rId21" Type="http://schemas.openxmlformats.org/officeDocument/2006/relationships/image" Target="../media/image6.png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image" Target="../media/image2.png"/><Relationship Id="rId25" Type="http://schemas.openxmlformats.org/officeDocument/2006/relationships/image" Target="../media/image10.png"/><Relationship Id="rId2" Type="http://schemas.openxmlformats.org/officeDocument/2006/relationships/tags" Target="../tags/tag2.xml"/><Relationship Id="rId16" Type="http://schemas.openxmlformats.org/officeDocument/2006/relationships/image" Target="../media/image1.svg"/><Relationship Id="rId20" Type="http://schemas.openxmlformats.org/officeDocument/2006/relationships/image" Target="../media/image5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image" Target="../media/image9.png"/><Relationship Id="rId5" Type="http://schemas.openxmlformats.org/officeDocument/2006/relationships/tags" Target="../tags/tag5.xml"/><Relationship Id="rId15" Type="http://schemas.openxmlformats.org/officeDocument/2006/relationships/notesSlide" Target="../notesSlides/notesSlide1.xml"/><Relationship Id="rId23" Type="http://schemas.openxmlformats.org/officeDocument/2006/relationships/image" Target="../media/image8.svg"/><Relationship Id="rId10" Type="http://schemas.openxmlformats.org/officeDocument/2006/relationships/tags" Target="../tags/tag10.xml"/><Relationship Id="rId19" Type="http://schemas.openxmlformats.org/officeDocument/2006/relationships/image" Target="../media/image4.pn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slideLayout" Target="../slideLayouts/slideLayout2.xml"/><Relationship Id="rId22" Type="http://schemas.openxmlformats.org/officeDocument/2006/relationships/image" Target="../media/image7.png"/><Relationship Id="rId27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DC343A-FD97-BE99-43FB-D19269D1A6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30676FAC-6CDC-8238-FB7F-E768D90F19E6}"/>
              </a:ext>
            </a:extLst>
          </p:cNvPr>
          <p:cNvSpPr/>
          <p:nvPr/>
        </p:nvSpPr>
        <p:spPr>
          <a:xfrm>
            <a:off x="3401476" y="1538798"/>
            <a:ext cx="4592580" cy="5240403"/>
          </a:xfrm>
          <a:prstGeom prst="rect">
            <a:avLst/>
          </a:prstGeom>
          <a:solidFill>
            <a:srgbClr val="ECF1E6"/>
          </a:solidFill>
          <a:ln>
            <a:solidFill>
              <a:srgbClr val="054D9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E1DC653-355F-9C9C-0C4D-E2062D82A17B}"/>
              </a:ext>
            </a:extLst>
          </p:cNvPr>
          <p:cNvSpPr/>
          <p:nvPr/>
        </p:nvSpPr>
        <p:spPr>
          <a:xfrm>
            <a:off x="3401476" y="1538798"/>
            <a:ext cx="4592580" cy="539496"/>
          </a:xfrm>
          <a:prstGeom prst="rect">
            <a:avLst/>
          </a:prstGeom>
          <a:solidFill>
            <a:srgbClr val="054D9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Study Design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954EEB9-E20B-E825-06F2-A2B86017EA41}"/>
              </a:ext>
            </a:extLst>
          </p:cNvPr>
          <p:cNvGrpSpPr/>
          <p:nvPr/>
        </p:nvGrpSpPr>
        <p:grpSpPr>
          <a:xfrm>
            <a:off x="3388546" y="2131133"/>
            <a:ext cx="4645961" cy="908207"/>
            <a:chOff x="3388541" y="1968364"/>
            <a:chExt cx="4645961" cy="908207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F04839C0-905E-F415-6770-8102F4667F0F}"/>
                </a:ext>
              </a:extLst>
            </p:cNvPr>
            <p:cNvGrpSpPr/>
            <p:nvPr/>
          </p:nvGrpSpPr>
          <p:grpSpPr>
            <a:xfrm>
              <a:off x="4884261" y="1968364"/>
              <a:ext cx="1654521" cy="726062"/>
              <a:chOff x="5175379" y="2396656"/>
              <a:chExt cx="1685675" cy="914400"/>
            </a:xfrm>
          </p:grpSpPr>
          <p:pic>
            <p:nvPicPr>
              <p:cNvPr id="24" name="Graphic 23" descr="Group with solid fill">
                <a:extLst>
                  <a:ext uri="{FF2B5EF4-FFF2-40B4-BE49-F238E27FC236}">
                    <a16:creationId xmlns:a16="http://schemas.microsoft.com/office/drawing/2014/main" id="{2E135D7C-BCD2-AFC6-367B-78D61C035F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>
                <a:extLst>
                  <a:ext uri="{96DAC541-7B7A-43D3-8B79-37D633B846F1}">
                    <asvg:svgBlip xmlns:asvg="http://schemas.microsoft.com/office/drawing/2016/SVG/main" r:embed="rId16"/>
                  </a:ext>
                </a:extLst>
              </a:blip>
              <a:stretch>
                <a:fillRect/>
              </a:stretch>
            </p:blipFill>
            <p:spPr>
              <a:xfrm>
                <a:off x="5175379" y="2396656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27" name="Graphic 26" descr="Group with solid fill">
                <a:extLst>
                  <a:ext uri="{FF2B5EF4-FFF2-40B4-BE49-F238E27FC236}">
                    <a16:creationId xmlns:a16="http://schemas.microsoft.com/office/drawing/2014/main" id="{69E71A0A-2EA4-3C6A-DCAC-CE07ED5B70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>
                <a:extLst>
                  <a:ext uri="{96DAC541-7B7A-43D3-8B79-37D633B846F1}">
                    <asvg:svgBlip xmlns:asvg="http://schemas.microsoft.com/office/drawing/2016/SVG/main" r:embed="rId16"/>
                  </a:ext>
                </a:extLst>
              </a:blip>
              <a:stretch>
                <a:fillRect/>
              </a:stretch>
            </p:blipFill>
            <p:spPr>
              <a:xfrm>
                <a:off x="5946654" y="2396656"/>
                <a:ext cx="914400" cy="914400"/>
              </a:xfrm>
              <a:prstGeom prst="rect">
                <a:avLst/>
              </a:prstGeom>
            </p:spPr>
          </p:pic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932DE81-9476-5CB2-2EF1-F7F7DECC5AC4}"/>
                </a:ext>
              </a:extLst>
            </p:cNvPr>
            <p:cNvSpPr txBox="1"/>
            <p:nvPr/>
          </p:nvSpPr>
          <p:spPr>
            <a:xfrm>
              <a:off x="3388541" y="2507239"/>
              <a:ext cx="46459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30 African American Y-T2D</a:t>
              </a:r>
            </a:p>
          </p:txBody>
        </p:sp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C3C021B2-B8F1-E119-0FBD-92FF0B3657D6}"/>
              </a:ext>
            </a:extLst>
          </p:cNvPr>
          <p:cNvGrpSpPr/>
          <p:nvPr/>
        </p:nvGrpSpPr>
        <p:grpSpPr>
          <a:xfrm>
            <a:off x="3493880" y="4687883"/>
            <a:ext cx="4435292" cy="1248327"/>
            <a:chOff x="3839730" y="3193698"/>
            <a:chExt cx="4435292" cy="1248327"/>
          </a:xfrm>
        </p:grpSpPr>
        <p:sp>
          <p:nvSpPr>
            <p:cNvPr id="45" name="Rectangle: Rounded Corners 44">
              <a:extLst>
                <a:ext uri="{FF2B5EF4-FFF2-40B4-BE49-F238E27FC236}">
                  <a16:creationId xmlns:a16="http://schemas.microsoft.com/office/drawing/2014/main" id="{BE4E2FF8-5074-A195-2870-9981811874B3}"/>
                </a:ext>
              </a:extLst>
            </p:cNvPr>
            <p:cNvSpPr>
              <a:spLocks/>
            </p:cNvSpPr>
            <p:nvPr/>
          </p:nvSpPr>
          <p:spPr>
            <a:xfrm>
              <a:off x="6050383" y="4005114"/>
              <a:ext cx="2150067" cy="432477"/>
            </a:xfrm>
            <a:prstGeom prst="roundRect">
              <a:avLst/>
            </a:prstGeom>
            <a:solidFill>
              <a:srgbClr val="EE851E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/>
                <a:t>Metformin + Liraglutide</a:t>
              </a:r>
            </a:p>
          </p:txBody>
        </p:sp>
        <p:sp>
          <p:nvSpPr>
            <p:cNvPr id="49" name="Rectangle: Rounded Corners 48">
              <a:extLst>
                <a:ext uri="{FF2B5EF4-FFF2-40B4-BE49-F238E27FC236}">
                  <a16:creationId xmlns:a16="http://schemas.microsoft.com/office/drawing/2014/main" id="{1E997609-2349-9D64-328F-822E9AF9B05E}"/>
                </a:ext>
              </a:extLst>
            </p:cNvPr>
            <p:cNvSpPr/>
            <p:nvPr/>
          </p:nvSpPr>
          <p:spPr>
            <a:xfrm>
              <a:off x="3839730" y="4000679"/>
              <a:ext cx="2150067" cy="441346"/>
            </a:xfrm>
            <a:prstGeom prst="roundRect">
              <a:avLst/>
            </a:prstGeom>
            <a:solidFill>
              <a:srgbClr val="4A9E97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/>
                <a:t>Metformin</a:t>
              </a:r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0FCA010C-B4B7-3C9F-B113-637C647A04AB}"/>
                </a:ext>
              </a:extLst>
            </p:cNvPr>
            <p:cNvPicPr>
              <a:picLocks noChangeAspect="1"/>
            </p:cNvPicPr>
            <p:nvPr>
              <p:custDataLst>
                <p:tags r:id="rId12"/>
              </p:custDataLst>
            </p:nvPr>
          </p:nvPicPr>
          <p:blipFill>
            <a:blip r:embed="rId17"/>
            <a:srcRect l="7392" t="42735" r="79259" b="37990"/>
            <a:stretch>
              <a:fillRect/>
            </a:stretch>
          </p:blipFill>
          <p:spPr>
            <a:xfrm>
              <a:off x="4597015" y="3193698"/>
              <a:ext cx="861750" cy="871049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33B0A2CF-3019-6FB8-0144-A596AD15A3CA}"/>
                </a:ext>
              </a:extLst>
            </p:cNvPr>
            <p:cNvPicPr>
              <a:picLocks noChangeAspect="1"/>
            </p:cNvPicPr>
            <p:nvPr>
              <p:custDataLst>
                <p:tags r:id="rId13"/>
              </p:custDataLst>
            </p:nvPr>
          </p:nvPicPr>
          <p:blipFill>
            <a:blip r:embed="rId17"/>
            <a:srcRect l="31781" t="42735" r="36365" b="37990"/>
            <a:stretch>
              <a:fillRect/>
            </a:stretch>
          </p:blipFill>
          <p:spPr>
            <a:xfrm>
              <a:off x="6218633" y="3213718"/>
              <a:ext cx="2056389" cy="871049"/>
            </a:xfrm>
            <a:prstGeom prst="rect">
              <a:avLst/>
            </a:prstGeom>
          </p:spPr>
        </p:pic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35C174D8-340C-7C96-0D8C-9051396A64C2}"/>
              </a:ext>
            </a:extLst>
          </p:cNvPr>
          <p:cNvGrpSpPr/>
          <p:nvPr/>
        </p:nvGrpSpPr>
        <p:grpSpPr>
          <a:xfrm>
            <a:off x="3537341" y="4035107"/>
            <a:ext cx="4348370" cy="637940"/>
            <a:chOff x="3837977" y="4626853"/>
            <a:chExt cx="4394795" cy="637940"/>
          </a:xfrm>
        </p:grpSpPr>
        <p:sp>
          <p:nvSpPr>
            <p:cNvPr id="101" name="Rectangle: Rounded Corners 100">
              <a:extLst>
                <a:ext uri="{FF2B5EF4-FFF2-40B4-BE49-F238E27FC236}">
                  <a16:creationId xmlns:a16="http://schemas.microsoft.com/office/drawing/2014/main" id="{75B1EC4E-B629-2689-C3B4-C4D4A58D9975}"/>
                </a:ext>
              </a:extLst>
            </p:cNvPr>
            <p:cNvSpPr/>
            <p:nvPr/>
          </p:nvSpPr>
          <p:spPr>
            <a:xfrm>
              <a:off x="3837977" y="4661004"/>
              <a:ext cx="4358064" cy="592414"/>
            </a:xfrm>
            <a:prstGeom prst="roundRect">
              <a:avLst/>
            </a:prstGeom>
            <a:solidFill>
              <a:srgbClr val="FAE8B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5045BBA4-78C7-8D9F-5880-CDFE8BF92983}"/>
                </a:ext>
              </a:extLst>
            </p:cNvPr>
            <p:cNvPicPr>
              <a:picLocks noChangeAspect="1"/>
            </p:cNvPicPr>
            <p:nvPr>
              <p:custDataLst>
                <p:tags r:id="rId11"/>
              </p:custDataLst>
            </p:nvPr>
          </p:nvPicPr>
          <p:blipFill>
            <a:blip r:embed="rId18"/>
            <a:srcRect l="24469" t="3507" r="63647" b="79689"/>
            <a:stretch>
              <a:fillRect/>
            </a:stretch>
          </p:blipFill>
          <p:spPr>
            <a:xfrm>
              <a:off x="3910128" y="4626853"/>
              <a:ext cx="644473" cy="637940"/>
            </a:xfrm>
            <a:prstGeom prst="rect">
              <a:avLst/>
            </a:prstGeom>
          </p:spPr>
        </p:pic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E02AD9C4-95CF-86AD-6136-CA8FE325C557}"/>
                </a:ext>
              </a:extLst>
            </p:cNvPr>
            <p:cNvSpPr txBox="1"/>
            <p:nvPr/>
          </p:nvSpPr>
          <p:spPr>
            <a:xfrm>
              <a:off x="4545801" y="4803322"/>
              <a:ext cx="3686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Randomized 3-month two-arm parallel trial</a:t>
              </a:r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A4AA9884-B854-F751-04FD-5D3D7A809F08}"/>
              </a:ext>
            </a:extLst>
          </p:cNvPr>
          <p:cNvGrpSpPr/>
          <p:nvPr/>
        </p:nvGrpSpPr>
        <p:grpSpPr>
          <a:xfrm>
            <a:off x="3516181" y="6044504"/>
            <a:ext cx="4390690" cy="670690"/>
            <a:chOff x="3837977" y="5251052"/>
            <a:chExt cx="4390690" cy="670690"/>
          </a:xfrm>
        </p:grpSpPr>
        <p:sp>
          <p:nvSpPr>
            <p:cNvPr id="105" name="Rectangle: Rounded Corners 104">
              <a:extLst>
                <a:ext uri="{FF2B5EF4-FFF2-40B4-BE49-F238E27FC236}">
                  <a16:creationId xmlns:a16="http://schemas.microsoft.com/office/drawing/2014/main" id="{58A4A641-957B-561A-47E4-0EB5CA9B0D9D}"/>
                </a:ext>
              </a:extLst>
            </p:cNvPr>
            <p:cNvSpPr/>
            <p:nvPr/>
          </p:nvSpPr>
          <p:spPr>
            <a:xfrm>
              <a:off x="3837977" y="5251052"/>
              <a:ext cx="4358064" cy="670690"/>
            </a:xfrm>
            <a:prstGeom prst="roundRect">
              <a:avLst/>
            </a:prstGeom>
            <a:solidFill>
              <a:srgbClr val="FAE8B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16297207-30D8-8083-552E-9185C5A9875D}"/>
                </a:ext>
              </a:extLst>
            </p:cNvPr>
            <p:cNvGrpSpPr/>
            <p:nvPr/>
          </p:nvGrpSpPr>
          <p:grpSpPr>
            <a:xfrm>
              <a:off x="3866113" y="5281946"/>
              <a:ext cx="4362554" cy="566061"/>
              <a:chOff x="3866113" y="5281946"/>
              <a:chExt cx="4362554" cy="566061"/>
            </a:xfrm>
          </p:grpSpPr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B099138B-9707-B4EA-DD24-D94EA1A0B141}"/>
                  </a:ext>
                </a:extLst>
              </p:cNvPr>
              <p:cNvGrpSpPr/>
              <p:nvPr/>
            </p:nvGrpSpPr>
            <p:grpSpPr>
              <a:xfrm>
                <a:off x="3866113" y="5281946"/>
                <a:ext cx="760637" cy="561520"/>
                <a:chOff x="3824196" y="5349831"/>
                <a:chExt cx="760637" cy="561520"/>
              </a:xfrm>
            </p:grpSpPr>
            <p:pic>
              <p:nvPicPr>
                <p:cNvPr id="94" name="Picture 93">
                  <a:extLst>
                    <a:ext uri="{FF2B5EF4-FFF2-40B4-BE49-F238E27FC236}">
                      <a16:creationId xmlns:a16="http://schemas.microsoft.com/office/drawing/2014/main" id="{2C98DC4A-69EA-BA1F-9339-E0CF1624F8D9}"/>
                    </a:ext>
                  </a:extLst>
                </p:cNvPr>
                <p:cNvPicPr>
                  <a:picLocks noChangeAspect="1"/>
                </p:cNvPicPr>
                <p:nvPr>
                  <p:custDataLst>
                    <p:tags r:id="rId9"/>
                  </p:custDataLst>
                </p:nvPr>
              </p:nvPicPr>
              <p:blipFill>
                <a:blip r:embed="rId19"/>
                <a:srcRect l="75527" t="19911" r="19090" b="58939"/>
                <a:stretch>
                  <a:fillRect/>
                </a:stretch>
              </p:blipFill>
              <p:spPr>
                <a:xfrm>
                  <a:off x="4385109" y="5349831"/>
                  <a:ext cx="199724" cy="549432"/>
                </a:xfrm>
                <a:prstGeom prst="rect">
                  <a:avLst/>
                </a:prstGeom>
              </p:spPr>
            </p:pic>
            <p:pic>
              <p:nvPicPr>
                <p:cNvPr id="95" name="Picture 94">
                  <a:extLst>
                    <a:ext uri="{FF2B5EF4-FFF2-40B4-BE49-F238E27FC236}">
                      <a16:creationId xmlns:a16="http://schemas.microsoft.com/office/drawing/2014/main" id="{F8FD0BE6-1844-A60F-395E-82AB7F684405}"/>
                    </a:ext>
                  </a:extLst>
                </p:cNvPr>
                <p:cNvPicPr>
                  <a:picLocks noChangeAspect="1"/>
                </p:cNvPicPr>
                <p:nvPr>
                  <p:custDataLst>
                    <p:tags r:id="rId10"/>
                  </p:custDataLst>
                </p:nvPr>
              </p:nvPicPr>
              <p:blipFill>
                <a:blip r:embed="rId20"/>
                <a:srcRect l="4014" t="5272" r="79445" b="71514"/>
                <a:stretch>
                  <a:fillRect/>
                </a:stretch>
              </p:blipFill>
              <p:spPr>
                <a:xfrm>
                  <a:off x="3824196" y="5354580"/>
                  <a:ext cx="566773" cy="556771"/>
                </a:xfrm>
                <a:prstGeom prst="rect">
                  <a:avLst/>
                </a:prstGeom>
              </p:spPr>
            </p:pic>
          </p:grp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E732412E-8B72-C16A-CE02-80BACE32197B}"/>
                  </a:ext>
                </a:extLst>
              </p:cNvPr>
              <p:cNvSpPr txBox="1"/>
              <p:nvPr/>
            </p:nvSpPr>
            <p:spPr>
              <a:xfrm>
                <a:off x="4594124" y="5324787"/>
                <a:ext cx="363454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/>
                  <a:t>Serial pharmacokinetic sampling</a:t>
                </a:r>
              </a:p>
              <a:p>
                <a:pPr algn="ctr"/>
                <a:r>
                  <a:rPr lang="en-US" sz="1400" b="1" dirty="0"/>
                  <a:t>Gluconeogenesis using </a:t>
                </a:r>
                <a:r>
                  <a:rPr lang="en-US" sz="1400" b="1" baseline="30000" dirty="0"/>
                  <a:t>2</a:t>
                </a:r>
                <a:r>
                  <a:rPr lang="en-US" sz="1400" b="1" dirty="0"/>
                  <a:t>H</a:t>
                </a:r>
                <a:r>
                  <a:rPr lang="en-US" sz="1400" b="1" baseline="-25000" dirty="0"/>
                  <a:t>2</a:t>
                </a:r>
                <a:r>
                  <a:rPr lang="en-US" sz="1400" b="1" dirty="0"/>
                  <a:t>O tracers</a:t>
                </a:r>
              </a:p>
            </p:txBody>
          </p:sp>
        </p:grp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556E94AC-2E9B-3102-6B4A-6C6A83CC33C7}"/>
              </a:ext>
            </a:extLst>
          </p:cNvPr>
          <p:cNvGrpSpPr/>
          <p:nvPr/>
        </p:nvGrpSpPr>
        <p:grpSpPr>
          <a:xfrm>
            <a:off x="3508120" y="3030342"/>
            <a:ext cx="4406813" cy="637940"/>
            <a:chOff x="3797911" y="3142424"/>
            <a:chExt cx="4489774" cy="719224"/>
          </a:xfrm>
        </p:grpSpPr>
        <p:sp>
          <p:nvSpPr>
            <p:cNvPr id="103" name="Rectangle: Rounded Corners 102">
              <a:extLst>
                <a:ext uri="{FF2B5EF4-FFF2-40B4-BE49-F238E27FC236}">
                  <a16:creationId xmlns:a16="http://schemas.microsoft.com/office/drawing/2014/main" id="{DEF5B21A-7642-9C3C-F2E2-627ED85D027A}"/>
                </a:ext>
              </a:extLst>
            </p:cNvPr>
            <p:cNvSpPr/>
            <p:nvPr/>
          </p:nvSpPr>
          <p:spPr>
            <a:xfrm>
              <a:off x="3827520" y="3142424"/>
              <a:ext cx="4358063" cy="641903"/>
            </a:xfrm>
            <a:prstGeom prst="roundRect">
              <a:avLst/>
            </a:prstGeom>
            <a:solidFill>
              <a:srgbClr val="FAE8B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2F6AB231-F190-E97F-DA7F-5E672A9B74B6}"/>
                </a:ext>
              </a:extLst>
            </p:cNvPr>
            <p:cNvPicPr>
              <a:picLocks noChangeAspect="1"/>
            </p:cNvPicPr>
            <p:nvPr>
              <p:custDataLst>
                <p:tags r:id="rId8"/>
              </p:custDataLst>
            </p:nvPr>
          </p:nvPicPr>
          <p:blipFill>
            <a:blip r:embed="rId21"/>
            <a:srcRect l="28566" t="44536" r="58627" b="39664"/>
            <a:stretch>
              <a:fillRect/>
            </a:stretch>
          </p:blipFill>
          <p:spPr>
            <a:xfrm>
              <a:off x="3797911" y="3153588"/>
              <a:ext cx="819856" cy="708060"/>
            </a:xfrm>
            <a:prstGeom prst="rect">
              <a:avLst/>
            </a:prstGeom>
          </p:spPr>
        </p:pic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6E8070C2-DC6D-EED3-E6B6-1FE2345B1359}"/>
                </a:ext>
              </a:extLst>
            </p:cNvPr>
            <p:cNvSpPr txBox="1"/>
            <p:nvPr/>
          </p:nvSpPr>
          <p:spPr>
            <a:xfrm>
              <a:off x="4394773" y="3312479"/>
              <a:ext cx="38929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Genotype array of known variants</a:t>
              </a:r>
            </a:p>
          </p:txBody>
        </p: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070D7D6C-904A-4DDF-577D-5DB12531013A}"/>
              </a:ext>
            </a:extLst>
          </p:cNvPr>
          <p:cNvSpPr/>
          <p:nvPr/>
        </p:nvSpPr>
        <p:spPr>
          <a:xfrm>
            <a:off x="0" y="0"/>
            <a:ext cx="12192000" cy="1468419"/>
          </a:xfrm>
          <a:prstGeom prst="rect">
            <a:avLst/>
          </a:prstGeom>
          <a:solidFill>
            <a:srgbClr val="054D9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b="1" dirty="0"/>
              <a:t>OCT1 Variants Modulate Metformin Clearance and Gluconeogenesis in African Americans with </a:t>
            </a:r>
            <a:r>
              <a:rPr lang="en-US" sz="2800" b="1" dirty="0">
                <a:solidFill>
                  <a:srgbClr val="FAE8B0"/>
                </a:solidFill>
              </a:rPr>
              <a:t>Youth-Onset Type 2 Diabetes: The MIGHTY Study</a:t>
            </a:r>
            <a:endParaRPr lang="en-US" sz="2800" dirty="0">
              <a:solidFill>
                <a:srgbClr val="FAE8B0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7571547-ADD0-BD66-9A50-C56428685F44}"/>
              </a:ext>
            </a:extLst>
          </p:cNvPr>
          <p:cNvSpPr/>
          <p:nvPr/>
        </p:nvSpPr>
        <p:spPr>
          <a:xfrm>
            <a:off x="8048719" y="1538799"/>
            <a:ext cx="4044475" cy="4685811"/>
          </a:xfrm>
          <a:prstGeom prst="rect">
            <a:avLst/>
          </a:prstGeom>
          <a:solidFill>
            <a:srgbClr val="FAE8B0"/>
          </a:solidFill>
          <a:ln>
            <a:solidFill>
              <a:srgbClr val="054D9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CB412EA-E7B5-FC76-1A41-3AB7A28FE9DD}"/>
              </a:ext>
            </a:extLst>
          </p:cNvPr>
          <p:cNvSpPr/>
          <p:nvPr/>
        </p:nvSpPr>
        <p:spPr>
          <a:xfrm>
            <a:off x="8056759" y="1538798"/>
            <a:ext cx="4036433" cy="539496"/>
          </a:xfrm>
          <a:prstGeom prst="rect">
            <a:avLst/>
          </a:prstGeom>
          <a:solidFill>
            <a:srgbClr val="054D9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Key Findings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C792390A-0A2A-BB5F-E3DB-08B679461F46}"/>
              </a:ext>
            </a:extLst>
          </p:cNvPr>
          <p:cNvGrpSpPr/>
          <p:nvPr/>
        </p:nvGrpSpPr>
        <p:grpSpPr>
          <a:xfrm>
            <a:off x="8139812" y="3737822"/>
            <a:ext cx="3978377" cy="600753"/>
            <a:chOff x="8626252" y="3063864"/>
            <a:chExt cx="3695308" cy="600753"/>
          </a:xfrm>
        </p:grpSpPr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80CE9140-D2D7-4F27-C7C3-BE4F79B3F8B2}"/>
                </a:ext>
              </a:extLst>
            </p:cNvPr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22"/>
            <a:srcRect l="58328" t="45043" r="27911" b="42921"/>
            <a:stretch>
              <a:fillRect/>
            </a:stretch>
          </p:blipFill>
          <p:spPr>
            <a:xfrm>
              <a:off x="8626252" y="3063864"/>
              <a:ext cx="976260" cy="597717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37DA9DB-8A09-077C-E338-BD107953370F}"/>
                </a:ext>
              </a:extLst>
            </p:cNvPr>
            <p:cNvSpPr txBox="1"/>
            <p:nvPr/>
          </p:nvSpPr>
          <p:spPr>
            <a:xfrm>
              <a:off x="9380299" y="3110619"/>
              <a:ext cx="294126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u="sng" dirty="0"/>
                <a:t>rs622342 (A&gt;C) </a:t>
              </a:r>
              <a:r>
                <a:rPr lang="en-US" sz="1400" b="1" i="1" u="sng" dirty="0"/>
                <a:t>OCT1</a:t>
              </a:r>
              <a:r>
                <a:rPr lang="en-US" sz="1400" b="1" u="sng" dirty="0"/>
                <a:t> variant</a:t>
              </a:r>
            </a:p>
            <a:p>
              <a:pPr algn="ctr"/>
              <a:r>
                <a:rPr lang="en-US" sz="200" b="1" dirty="0"/>
                <a:t>      </a:t>
              </a:r>
            </a:p>
            <a:p>
              <a:pPr algn="ctr"/>
              <a:r>
                <a:rPr lang="en-US" sz="1400" b="1" dirty="0"/>
                <a:t>Fractional gluconeogenesis</a:t>
              </a:r>
              <a:r>
                <a:rPr lang="en-US" sz="1400" b="1" u="sng" dirty="0"/>
                <a:t> </a:t>
              </a:r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649E9AA0-E9F5-6287-1964-F7B58666384D}"/>
              </a:ext>
            </a:extLst>
          </p:cNvPr>
          <p:cNvGrpSpPr/>
          <p:nvPr/>
        </p:nvGrpSpPr>
        <p:grpSpPr>
          <a:xfrm>
            <a:off x="8139812" y="4450091"/>
            <a:ext cx="3978377" cy="800219"/>
            <a:chOff x="8637412" y="3202912"/>
            <a:chExt cx="3695308" cy="800219"/>
          </a:xfrm>
        </p:grpSpPr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CBD3AB2D-33E7-BC49-6FA2-958151025B53}"/>
                </a:ext>
              </a:extLst>
            </p:cNvPr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>
            <a:blip r:embed="rId22"/>
            <a:srcRect l="58328" t="45043" r="27911" b="42921"/>
            <a:stretch>
              <a:fillRect/>
            </a:stretch>
          </p:blipFill>
          <p:spPr>
            <a:xfrm>
              <a:off x="8637412" y="3279990"/>
              <a:ext cx="976260" cy="597717"/>
            </a:xfrm>
            <a:prstGeom prst="rect">
              <a:avLst/>
            </a:prstGeom>
          </p:spPr>
        </p:pic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3CCCE24-1C9E-7B17-601C-FB401BFB7FFF}"/>
                </a:ext>
              </a:extLst>
            </p:cNvPr>
            <p:cNvSpPr txBox="1"/>
            <p:nvPr/>
          </p:nvSpPr>
          <p:spPr>
            <a:xfrm>
              <a:off x="9391459" y="3202912"/>
              <a:ext cx="2941261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u="sng" dirty="0"/>
                <a:t>rs7903146 (G&gt;T) </a:t>
              </a:r>
              <a:r>
                <a:rPr lang="en-US" sz="1400" b="1" i="1" u="sng" dirty="0"/>
                <a:t>TCF7L2</a:t>
              </a:r>
              <a:r>
                <a:rPr lang="en-US" sz="1400" b="1" u="sng" dirty="0"/>
                <a:t> variant </a:t>
              </a:r>
            </a:p>
            <a:p>
              <a:pPr algn="ctr"/>
              <a:endParaRPr lang="en-US" sz="200" b="1" dirty="0"/>
            </a:p>
            <a:p>
              <a:pPr algn="ctr"/>
              <a:r>
                <a:rPr lang="en-US" sz="1400" b="1" dirty="0"/>
                <a:t>Plasma glucose</a:t>
              </a:r>
            </a:p>
            <a:p>
              <a:pPr algn="ctr"/>
              <a:endParaRPr lang="en-US" sz="200" b="1" dirty="0"/>
            </a:p>
            <a:p>
              <a:pPr algn="ctr"/>
              <a:r>
                <a:rPr lang="en-US" sz="1400" b="1" dirty="0"/>
                <a:t>[combination </a:t>
              </a:r>
              <a:r>
                <a:rPr lang="en-US" sz="1400" b="1"/>
                <a:t>therapy only]</a:t>
              </a:r>
              <a:endParaRPr lang="en-US" sz="1400" b="1" dirty="0"/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271B43E0-C201-DF89-909A-F1C98619E26E}"/>
              </a:ext>
            </a:extLst>
          </p:cNvPr>
          <p:cNvGrpSpPr/>
          <p:nvPr/>
        </p:nvGrpSpPr>
        <p:grpSpPr>
          <a:xfrm>
            <a:off x="8259905" y="5401687"/>
            <a:ext cx="3719795" cy="824809"/>
            <a:chOff x="8736875" y="5663067"/>
            <a:chExt cx="3455125" cy="824809"/>
          </a:xfrm>
        </p:grpSpPr>
        <p:pic>
          <p:nvPicPr>
            <p:cNvPr id="75" name="Graphic 74" descr="Target with solid fill">
              <a:extLst>
                <a:ext uri="{FF2B5EF4-FFF2-40B4-BE49-F238E27FC236}">
                  <a16:creationId xmlns:a16="http://schemas.microsoft.com/office/drawing/2014/main" id="{EF7DD554-80F3-4067-B588-A08AADD930D5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23"/>
                </a:ext>
              </a:extLst>
            </a:blip>
            <a:stretch>
              <a:fillRect/>
            </a:stretch>
          </p:blipFill>
          <p:spPr>
            <a:xfrm>
              <a:off x="8736875" y="5663067"/>
              <a:ext cx="824809" cy="824809"/>
            </a:xfrm>
            <a:prstGeom prst="rect">
              <a:avLst/>
            </a:prstGeom>
          </p:spPr>
        </p:pic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76E36D8-B17A-2CA3-4DD0-2924C2DCD618}"/>
                </a:ext>
              </a:extLst>
            </p:cNvPr>
            <p:cNvSpPr txBox="1"/>
            <p:nvPr/>
          </p:nvSpPr>
          <p:spPr>
            <a:xfrm>
              <a:off x="9250739" y="5670484"/>
              <a:ext cx="294126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u="sng" dirty="0"/>
                <a:t>Strongest glycemic predictors:     </a:t>
              </a:r>
            </a:p>
            <a:p>
              <a:pPr algn="ctr"/>
              <a:endParaRPr lang="en-US" sz="200" b="1" u="sng" dirty="0"/>
            </a:p>
            <a:p>
              <a:pPr algn="ctr"/>
              <a:r>
                <a:rPr lang="en-US" sz="1400" b="1" dirty="0"/>
                <a:t>Baseline Glucose</a:t>
              </a:r>
            </a:p>
            <a:p>
              <a:pPr algn="ctr"/>
              <a:r>
                <a:rPr lang="en-US" sz="1400" b="1" dirty="0"/>
                <a:t>Baseline Gluconeogenesis</a:t>
              </a:r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12154744-9BD8-8F87-DB2D-7BDC215B72C9}"/>
              </a:ext>
            </a:extLst>
          </p:cNvPr>
          <p:cNvSpPr/>
          <p:nvPr/>
        </p:nvSpPr>
        <p:spPr>
          <a:xfrm>
            <a:off x="73806" y="1538799"/>
            <a:ext cx="3264967" cy="5240402"/>
          </a:xfrm>
          <a:prstGeom prst="rect">
            <a:avLst/>
          </a:prstGeom>
          <a:solidFill>
            <a:srgbClr val="ECF1E6"/>
          </a:solidFill>
          <a:ln>
            <a:solidFill>
              <a:srgbClr val="054D9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7F7A85A-2EDF-5516-96D2-52B33F3BCD8E}"/>
              </a:ext>
            </a:extLst>
          </p:cNvPr>
          <p:cNvSpPr txBox="1"/>
          <p:nvPr/>
        </p:nvSpPr>
        <p:spPr>
          <a:xfrm>
            <a:off x="56657" y="3937221"/>
            <a:ext cx="3290155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u="sng" dirty="0"/>
              <a:t>Organic Cation Transporters (OCTs)</a:t>
            </a:r>
          </a:p>
          <a:p>
            <a:pPr algn="ctr"/>
            <a:r>
              <a:rPr lang="en-US" sz="1300" b="1" dirty="0"/>
              <a:t>May affect metformin pharmacokinetics, fasting glucose, and gluconeogenesi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F0B5B98-0F20-1ECA-F21A-7BC581702E00}"/>
              </a:ext>
            </a:extLst>
          </p:cNvPr>
          <p:cNvSpPr/>
          <p:nvPr/>
        </p:nvSpPr>
        <p:spPr>
          <a:xfrm>
            <a:off x="73806" y="1538798"/>
            <a:ext cx="3264967" cy="536200"/>
          </a:xfrm>
          <a:prstGeom prst="rect">
            <a:avLst/>
          </a:prstGeom>
          <a:solidFill>
            <a:srgbClr val="054D9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Background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3CAFC8B-8104-E5EE-5174-C19FD43C0BB1}"/>
              </a:ext>
            </a:extLst>
          </p:cNvPr>
          <p:cNvSpPr txBox="1"/>
          <p:nvPr/>
        </p:nvSpPr>
        <p:spPr>
          <a:xfrm>
            <a:off x="153048" y="3031055"/>
            <a:ext cx="333241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Youth-Onset Type 2 Diabetes (Y-T2D)</a:t>
            </a:r>
          </a:p>
          <a:p>
            <a:pPr algn="ctr"/>
            <a:r>
              <a:rPr lang="en-US" sz="1300" b="1" dirty="0"/>
              <a:t>High metformin failure rates</a:t>
            </a:r>
          </a:p>
          <a:p>
            <a:pPr algn="ctr"/>
            <a:r>
              <a:rPr lang="en-US" sz="1300" b="1" dirty="0"/>
              <a:t>Metformin response may be heritable</a:t>
            </a:r>
          </a:p>
        </p:txBody>
      </p: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3D0AD308-DC9D-7DCA-A21C-FFB12297DDD8}"/>
              </a:ext>
            </a:extLst>
          </p:cNvPr>
          <p:cNvGrpSpPr/>
          <p:nvPr/>
        </p:nvGrpSpPr>
        <p:grpSpPr>
          <a:xfrm>
            <a:off x="161237" y="5507447"/>
            <a:ext cx="3312671" cy="1065134"/>
            <a:chOff x="103065" y="5209992"/>
            <a:chExt cx="3312671" cy="1065134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4DE5CD8A-D94A-848E-BF54-361E52D84462}"/>
                </a:ext>
              </a:extLst>
            </p:cNvPr>
            <p:cNvSpPr txBox="1"/>
            <p:nvPr/>
          </p:nvSpPr>
          <p:spPr>
            <a:xfrm>
              <a:off x="103065" y="5782683"/>
              <a:ext cx="3312671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/>
                <a:t>Pharmacogenetics in Y-T2D are uncharacterized (</a:t>
              </a:r>
              <a:r>
                <a:rPr lang="en-US" sz="1300" b="1" i="1" dirty="0"/>
                <a:t>OCT1</a:t>
              </a:r>
              <a:r>
                <a:rPr lang="en-US" sz="1300" b="1" dirty="0"/>
                <a:t> variants)</a:t>
              </a:r>
            </a:p>
          </p:txBody>
        </p:sp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3F8BAF95-79DF-9795-B280-6BF8715E3836}"/>
                </a:ext>
              </a:extLst>
            </p:cNvPr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24"/>
            <a:srcRect l="4806" t="46931" r="69658" b="41004"/>
            <a:stretch>
              <a:fillRect/>
            </a:stretch>
          </p:blipFill>
          <p:spPr>
            <a:xfrm>
              <a:off x="797535" y="5209992"/>
              <a:ext cx="1927103" cy="637328"/>
            </a:xfrm>
            <a:prstGeom prst="rect">
              <a:avLst/>
            </a:prstGeom>
          </p:spPr>
        </p:pic>
      </p:grpSp>
      <p:pic>
        <p:nvPicPr>
          <p:cNvPr id="87" name="Picture 86">
            <a:extLst>
              <a:ext uri="{FF2B5EF4-FFF2-40B4-BE49-F238E27FC236}">
                <a16:creationId xmlns:a16="http://schemas.microsoft.com/office/drawing/2014/main" id="{E349BF6C-77E9-A567-648A-966F4FCB87D4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5"/>
          <a:srcRect l="17084" t="21920" r="31816" b="56966"/>
          <a:stretch>
            <a:fillRect/>
          </a:stretch>
        </p:blipFill>
        <p:spPr>
          <a:xfrm>
            <a:off x="212210" y="2131109"/>
            <a:ext cx="3026671" cy="875425"/>
          </a:xfrm>
          <a:prstGeom prst="rect">
            <a:avLst/>
          </a:prstGeom>
        </p:spPr>
      </p:pic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4DC90451-4A77-B810-9092-71CFA1D42791}"/>
              </a:ext>
            </a:extLst>
          </p:cNvPr>
          <p:cNvCxnSpPr>
            <a:cxnSpLocks/>
          </p:cNvCxnSpPr>
          <p:nvPr/>
        </p:nvCxnSpPr>
        <p:spPr>
          <a:xfrm>
            <a:off x="122851" y="3784577"/>
            <a:ext cx="3166875" cy="0"/>
          </a:xfrm>
          <a:prstGeom prst="line">
            <a:avLst/>
          </a:prstGeom>
          <a:ln w="19050">
            <a:solidFill>
              <a:srgbClr val="054D9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4" name="Rectangle 133">
            <a:extLst>
              <a:ext uri="{FF2B5EF4-FFF2-40B4-BE49-F238E27FC236}">
                <a16:creationId xmlns:a16="http://schemas.microsoft.com/office/drawing/2014/main" id="{6B640F96-155E-8599-D15A-AE6F02127653}"/>
              </a:ext>
            </a:extLst>
          </p:cNvPr>
          <p:cNvSpPr/>
          <p:nvPr/>
        </p:nvSpPr>
        <p:spPr>
          <a:xfrm>
            <a:off x="8048720" y="6272685"/>
            <a:ext cx="4047790" cy="506515"/>
          </a:xfrm>
          <a:prstGeom prst="rect">
            <a:avLst/>
          </a:prstGeom>
          <a:solidFill>
            <a:srgbClr val="054D9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b="1" dirty="0">
              <a:solidFill>
                <a:schemeClr val="bg1"/>
              </a:solidFill>
            </a:endParaRPr>
          </a:p>
        </p:txBody>
      </p:sp>
      <p:pic>
        <p:nvPicPr>
          <p:cNvPr id="137" name="Picture 136">
            <a:extLst>
              <a:ext uri="{FF2B5EF4-FFF2-40B4-BE49-F238E27FC236}">
                <a16:creationId xmlns:a16="http://schemas.microsoft.com/office/drawing/2014/main" id="{FD7D81F9-F293-F2D9-5558-C24EB25EEC4A}"/>
              </a:ext>
            </a:extLst>
          </p:cNvPr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26"/>
          <a:srcRect l="41570" t="4732" r="45078" b="77780"/>
          <a:stretch>
            <a:fillRect/>
          </a:stretch>
        </p:blipFill>
        <p:spPr>
          <a:xfrm>
            <a:off x="8081047" y="6261807"/>
            <a:ext cx="635394" cy="582549"/>
          </a:xfrm>
          <a:prstGeom prst="rect">
            <a:avLst/>
          </a:prstGeom>
        </p:spPr>
      </p:pic>
      <p:sp>
        <p:nvSpPr>
          <p:cNvPr id="138" name="TextBox 137">
            <a:extLst>
              <a:ext uri="{FF2B5EF4-FFF2-40B4-BE49-F238E27FC236}">
                <a16:creationId xmlns:a16="http://schemas.microsoft.com/office/drawing/2014/main" id="{0D979A72-7736-4746-AF6C-3E2C72B505E4}"/>
              </a:ext>
            </a:extLst>
          </p:cNvPr>
          <p:cNvSpPr txBox="1"/>
          <p:nvPr/>
        </p:nvSpPr>
        <p:spPr>
          <a:xfrm>
            <a:off x="8646594" y="6290491"/>
            <a:ext cx="3096677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solidFill>
                  <a:schemeClr val="bg1"/>
                </a:solidFill>
              </a:rPr>
              <a:t>Pharmacogenetics → variable response in Youth-Onset Type 2 Diabetes</a:t>
            </a:r>
          </a:p>
          <a:p>
            <a:pPr algn="ctr"/>
            <a:endParaRPr lang="en-US" sz="1300" dirty="0"/>
          </a:p>
        </p:txBody>
      </p:sp>
      <p:cxnSp>
        <p:nvCxnSpPr>
          <p:cNvPr id="140" name="Straight Arrow Connector 139">
            <a:extLst>
              <a:ext uri="{FF2B5EF4-FFF2-40B4-BE49-F238E27FC236}">
                <a16:creationId xmlns:a16="http://schemas.microsoft.com/office/drawing/2014/main" id="{994A6CC4-A75B-4EE5-82D9-E0F4E07CB0EE}"/>
              </a:ext>
            </a:extLst>
          </p:cNvPr>
          <p:cNvCxnSpPr>
            <a:cxnSpLocks/>
          </p:cNvCxnSpPr>
          <p:nvPr/>
        </p:nvCxnSpPr>
        <p:spPr>
          <a:xfrm>
            <a:off x="9782474" y="4712049"/>
            <a:ext cx="0" cy="240941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C4D46BE4-A7BA-4554-ECA9-DBC71A1B3709}"/>
              </a:ext>
            </a:extLst>
          </p:cNvPr>
          <p:cNvCxnSpPr>
            <a:cxnSpLocks/>
          </p:cNvCxnSpPr>
          <p:nvPr/>
        </p:nvCxnSpPr>
        <p:spPr>
          <a:xfrm>
            <a:off x="9309404" y="4075038"/>
            <a:ext cx="0" cy="240941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8" name="Group 77">
            <a:extLst>
              <a:ext uri="{FF2B5EF4-FFF2-40B4-BE49-F238E27FC236}">
                <a16:creationId xmlns:a16="http://schemas.microsoft.com/office/drawing/2014/main" id="{DDF76617-3E04-B7B8-6625-437C5879929A}"/>
              </a:ext>
            </a:extLst>
          </p:cNvPr>
          <p:cNvGrpSpPr/>
          <p:nvPr/>
        </p:nvGrpSpPr>
        <p:grpSpPr>
          <a:xfrm>
            <a:off x="8252014" y="2080126"/>
            <a:ext cx="3703214" cy="765832"/>
            <a:chOff x="8759668" y="2260977"/>
            <a:chExt cx="3439723" cy="765832"/>
          </a:xfrm>
        </p:grpSpPr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5CF86D02-1138-B49A-1FA5-7BF9E7C03471}"/>
                </a:ext>
              </a:extLst>
            </p:cNvPr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27"/>
            <a:srcRect l="71902" t="41687" r="16695" b="41326"/>
            <a:stretch>
              <a:fillRect/>
            </a:stretch>
          </p:blipFill>
          <p:spPr>
            <a:xfrm>
              <a:off x="8759668" y="2276814"/>
              <a:ext cx="719214" cy="749995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E5EDC49-70CE-11FA-790D-AE1796D2681C}"/>
                </a:ext>
              </a:extLst>
            </p:cNvPr>
            <p:cNvSpPr txBox="1"/>
            <p:nvPr/>
          </p:nvSpPr>
          <p:spPr>
            <a:xfrm>
              <a:off x="9258130" y="2260977"/>
              <a:ext cx="294126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u="sng" dirty="0"/>
                <a:t>Metformin pharmacokinetics</a:t>
              </a:r>
            </a:p>
            <a:p>
              <a:pPr algn="ctr"/>
              <a:r>
                <a:rPr lang="en-US" sz="1400" b="1" dirty="0"/>
                <a:t>One-compartment first-order absorption and elimination model</a:t>
              </a:r>
            </a:p>
          </p:txBody>
        </p: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9DDDCA7B-D24F-5D2E-9D6F-30F8D9B01465}"/>
              </a:ext>
            </a:extLst>
          </p:cNvPr>
          <p:cNvGrpSpPr/>
          <p:nvPr/>
        </p:nvGrpSpPr>
        <p:grpSpPr>
          <a:xfrm>
            <a:off x="8135248" y="2826207"/>
            <a:ext cx="3909797" cy="800219"/>
            <a:chOff x="8523270" y="2950740"/>
            <a:chExt cx="3631608" cy="800219"/>
          </a:xfrm>
        </p:grpSpPr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F179BF28-0FAE-1C29-9105-64764E7B095A}"/>
                </a:ext>
              </a:extLst>
            </p:cNvPr>
            <p:cNvGrpSpPr/>
            <p:nvPr/>
          </p:nvGrpSpPr>
          <p:grpSpPr>
            <a:xfrm>
              <a:off x="8523270" y="2950740"/>
              <a:ext cx="3631608" cy="800219"/>
              <a:chOff x="8543880" y="3063274"/>
              <a:chExt cx="3631608" cy="800219"/>
            </a:xfrm>
          </p:grpSpPr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68A97050-2DDE-B1C4-03DC-9C40597E7237}"/>
                  </a:ext>
                </a:extLst>
              </p:cNvPr>
              <p:cNvPicPr>
                <a:picLocks noChangeAspect="1"/>
              </p:cNvPicPr>
              <p:nvPr>
                <p:custDataLst>
                  <p:tags r:id="rId3"/>
                </p:custDataLst>
              </p:nvPr>
            </p:nvPicPr>
            <p:blipFill>
              <a:blip r:embed="rId22"/>
              <a:srcRect l="58328" t="45043" r="27911" b="42921"/>
              <a:stretch>
                <a:fillRect/>
              </a:stretch>
            </p:blipFill>
            <p:spPr>
              <a:xfrm>
                <a:off x="8543880" y="3138074"/>
                <a:ext cx="976260" cy="597717"/>
              </a:xfrm>
              <a:prstGeom prst="rect">
                <a:avLst/>
              </a:prstGeom>
            </p:spPr>
          </p:pic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A939B3EC-7514-38F6-7982-6C0A3E1160DB}"/>
                  </a:ext>
                </a:extLst>
              </p:cNvPr>
              <p:cNvSpPr txBox="1"/>
              <p:nvPr/>
            </p:nvSpPr>
            <p:spPr>
              <a:xfrm>
                <a:off x="9234227" y="3063274"/>
                <a:ext cx="2941261" cy="8002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/>
                  <a:t>     </a:t>
                </a:r>
                <a:r>
                  <a:rPr lang="en-US" sz="1400" b="1" u="sng" dirty="0"/>
                  <a:t>rs628031 (G&gt;A) </a:t>
                </a:r>
                <a:r>
                  <a:rPr lang="en-US" sz="1400" b="1" i="1" u="sng" dirty="0"/>
                  <a:t>OCT1</a:t>
                </a:r>
                <a:r>
                  <a:rPr lang="en-US" sz="1400" b="1" u="sng" dirty="0"/>
                  <a:t> variant</a:t>
                </a:r>
                <a:r>
                  <a:rPr lang="en-US" sz="1400" b="1" dirty="0"/>
                  <a:t> </a:t>
                </a:r>
              </a:p>
              <a:p>
                <a:pPr algn="ctr"/>
                <a:endParaRPr lang="en-US" sz="200" b="1" dirty="0"/>
              </a:p>
              <a:p>
                <a:pPr algn="ctr"/>
                <a:r>
                  <a:rPr lang="en-US" sz="1400" b="1" dirty="0"/>
                  <a:t>Clearance</a:t>
                </a:r>
              </a:p>
              <a:p>
                <a:pPr algn="ctr"/>
                <a:endParaRPr lang="en-US" sz="200" b="1" dirty="0"/>
              </a:p>
              <a:p>
                <a:pPr algn="ctr"/>
                <a:r>
                  <a:rPr lang="en-US" sz="1400" b="1" dirty="0"/>
                  <a:t> Significant model covariate</a:t>
                </a:r>
              </a:p>
            </p:txBody>
          </p:sp>
        </p:grp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4EEC994C-3938-B562-C864-01CB906D8463}"/>
                </a:ext>
              </a:extLst>
            </p:cNvPr>
            <p:cNvCxnSpPr>
              <a:cxnSpLocks/>
            </p:cNvCxnSpPr>
            <p:nvPr/>
          </p:nvCxnSpPr>
          <p:spPr>
            <a:xfrm>
              <a:off x="10140044" y="3225220"/>
              <a:ext cx="0" cy="240941"/>
            </a:xfrm>
            <a:prstGeom prst="straightConnector1">
              <a:avLst/>
            </a:prstGeom>
            <a:ln w="38100">
              <a:solidFill>
                <a:schemeClr val="bg2">
                  <a:lumMod val="75000"/>
                </a:schemeClr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Arrow Connector 143">
              <a:extLst>
                <a:ext uri="{FF2B5EF4-FFF2-40B4-BE49-F238E27FC236}">
                  <a16:creationId xmlns:a16="http://schemas.microsoft.com/office/drawing/2014/main" id="{0415AE6F-BFAC-EC79-56CD-1AF29C85FA48}"/>
                </a:ext>
              </a:extLst>
            </p:cNvPr>
            <p:cNvCxnSpPr>
              <a:cxnSpLocks/>
            </p:cNvCxnSpPr>
            <p:nvPr/>
          </p:nvCxnSpPr>
          <p:spPr>
            <a:xfrm>
              <a:off x="9976760" y="3225220"/>
              <a:ext cx="0" cy="240941"/>
            </a:xfrm>
            <a:prstGeom prst="straightConnector1">
              <a:avLst/>
            </a:prstGeom>
            <a:ln w="38100">
              <a:solidFill>
                <a:schemeClr val="bg2">
                  <a:lumMod val="75000"/>
                </a:schemeClr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22CB5901-1020-9CA0-AD3E-408DBB5641E2}"/>
              </a:ext>
            </a:extLst>
          </p:cNvPr>
          <p:cNvCxnSpPr>
            <a:cxnSpLocks/>
          </p:cNvCxnSpPr>
          <p:nvPr/>
        </p:nvCxnSpPr>
        <p:spPr>
          <a:xfrm>
            <a:off x="8737448" y="3687954"/>
            <a:ext cx="3166875" cy="0"/>
          </a:xfrm>
          <a:prstGeom prst="line">
            <a:avLst/>
          </a:prstGeom>
          <a:ln w="19050">
            <a:solidFill>
              <a:srgbClr val="054D9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3702F32D-5040-23C6-B010-8022CEDD6B0F}"/>
              </a:ext>
            </a:extLst>
          </p:cNvPr>
          <p:cNvCxnSpPr>
            <a:cxnSpLocks/>
          </p:cNvCxnSpPr>
          <p:nvPr/>
        </p:nvCxnSpPr>
        <p:spPr>
          <a:xfrm>
            <a:off x="8737447" y="5333853"/>
            <a:ext cx="3166875" cy="0"/>
          </a:xfrm>
          <a:prstGeom prst="line">
            <a:avLst/>
          </a:prstGeom>
          <a:ln w="19050">
            <a:solidFill>
              <a:srgbClr val="054D9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BD7CAF8B-DC28-A803-1FC4-2050BB96ADC1}"/>
              </a:ext>
            </a:extLst>
          </p:cNvPr>
          <p:cNvSpPr/>
          <p:nvPr/>
        </p:nvSpPr>
        <p:spPr>
          <a:xfrm>
            <a:off x="83912" y="4832520"/>
            <a:ext cx="3254861" cy="536200"/>
          </a:xfrm>
          <a:prstGeom prst="rect">
            <a:avLst/>
          </a:prstGeom>
          <a:solidFill>
            <a:srgbClr val="054D9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Research Ga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36E2A8-A89C-3A72-74DA-75329DA3BDF0}"/>
              </a:ext>
            </a:extLst>
          </p:cNvPr>
          <p:cNvSpPr txBox="1"/>
          <p:nvPr/>
        </p:nvSpPr>
        <p:spPr>
          <a:xfrm>
            <a:off x="7057771" y="2104011"/>
            <a:ext cx="897500" cy="55399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12-25y</a:t>
            </a:r>
          </a:p>
          <a:p>
            <a:pPr algn="r"/>
            <a:r>
              <a:rPr lang="en-US" sz="1000" dirty="0"/>
              <a:t> 53% Female</a:t>
            </a:r>
          </a:p>
          <a:p>
            <a:pPr algn="r"/>
            <a:r>
              <a:rPr lang="en-US" sz="1000" dirty="0"/>
              <a:t>HbA1c 6.7%</a:t>
            </a:r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AB695E46-92CF-B8E6-2D5C-63EB52873205}"/>
              </a:ext>
            </a:extLst>
          </p:cNvPr>
          <p:cNvSpPr/>
          <p:nvPr/>
        </p:nvSpPr>
        <p:spPr>
          <a:xfrm>
            <a:off x="5511385" y="3662808"/>
            <a:ext cx="400283" cy="331897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20349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843528424"/>
  <p:tag name="VERSION" val="1773843519819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,&quot;715bbc95-2221-48e5-a0b2-e1ae84faa96a&quot;:{&quot;id&quot;:&quot;715bbc95-2221-48e5-a0b2-e1ae84faa96a&quot;,&quot;name&quot;:&quot;Glucose meter&quot;,&quot;displayName&quot;:&quot;&quot;,&quot;type&quot;:&quot;FIGURE_OBJECT&quot;,&quot;relativeTransform&quot;:{&quot;translate&quot;:{&quot;x&quot;:-374.8627450980392,&quot;y&quot;:127.5},&quot;rotate&quot;:0,&quot;skewX&quot;:0,&quot;scale&quot;:{&quot;x&quot;:0.2551633986928105,&quot;y&quot;:0.2551633986928105}},&quot;image&quot;:{&quot;url&quot;:&quot;https://icons.cdn.biorender.com/biorender/5cc36f64df35f43300d5ab9e/20190426205306/image/5cc36f64df35f43300d5ab9e.png&quot;,&quot;isPremium&quot;:false,&quot;isOrgIcon&quot;:false,&quot;size&quot;:{&quot;x&quot;:150,&quot;y&quot;:310.13513513513516}},&quot;source&quot;:{&quot;id&quot;:&quot;5cc36f64df35f43300d5ab9e&quot;,&quot;version&quot;:&quot;20190426205306&quot;,&quot;type&quot;:&quot;ASSETS&quot;},&quot;isPremium&quot;:false,&quot;parent&quot;:{&quot;type&quot;:&quot;CHILD&quot;,&quot;parentId&quot;:&quot;228b698d-4cee-4aaf-8d74-c84d91114676&quot;,&quot;order&quot;:&quot;97&quot;}},&quot;5f9c25af-4e61-4d01-a7f9-bc96f00ec0a3&quot;:{&quot;id&quot;:&quot;5f9c25af-4e61-4d01-a7f9-bc96f00ec0a3&quot;,&quot;name&quot;:&quot;Child 3 (head, gender-neutral, stage I obesity, anterior)&quot;,&quot;displayName&quot;:&quot;&quot;,&quot;type&quot;:&quot;FIGURE_OBJECT&quot;,&quot;relativeTransform&quot;:{&quot;translate&quot;:{&quot;x&quot;:-294,&quot;y&quot;:145},&quot;rotate&quot;:0,&quot;skewX&quot;:0,&quot;scale&quot;:{&quot;x&quot;:1,&quot;y&quot;:1}},&quot;image&quot;:{&quot;url&quot;:&quot;https://icons.cdn.biorender.com/biorender/671a9e69bdca4c36b346d6be/671a9e50bdca4c36b346d679.png&quot;,&quot;isPremium&quot;:true,&quot;isOrgIcon&quot;:false,&quot;size&quot;:{&quot;x&quot;:150,&quot;y&quot;:140.3485254691689},&quot;fallbackUrl&quot;:&quot;sources/icons/671a9e69bdca4c36b346d6be/671a9e50bdca4c36b346d679.svg&quot;},&quot;source&quot;:{&quot;id&quot;:&quot;671a9e50bdca4c36b346d679&quot;,&quot;version&quot;:&quot;20241024192203&quot;,&quot;type&quot;:&quot;ASSETS&quot;},&quot;isPremium&quot;:true,&quot;parent&quot;:{&quot;type&quot;:&quot;CHILD&quot;,&quot;parentId&quot;:&quot;228b698d-4cee-4aaf-8d74-c84d91114676&quot;,&quot;order&quot;:&quot;98&quot;}},&quot;3bbfb5a3-190d-4c8e-8632-87cfbfcbc871&quot;:{&quot;relativeTransform&quot;:{&quot;translate&quot;:{&quot;x&quot;:-149.81948063774848,&quot;y&quot;:364.7558646383225},&quot;rotate&quot;:0,&quot;skewX&quot;:0,&quot;scale&quot;:{&quot;x&quot;:1,&quot;y&quot;:1}},&quot;type&quot;:&quot;FIGURE_OBJECT&quot;,&quot;id&quot;:&quot;3bbfb5a3-190d-4c8e-8632-87cfbfcbc871&quot;,&quot;parent&quot;:{&quot;type&quot;:&quot;CHILD&quot;,&quot;parentId&quot;:&quot;228b698d-4cee-4aaf-8d74-c84d91114676&quot;,&quot;order&quot;:&quot;99&quot;},&quot;name&quot;:&quot;Pill cluster&quot;,&quot;displayName&quot;:&quot;Pill cluster&quot;,&quot;source&quot;:{&quot;id&quot;:&quot;608aeff9ac44b300a20aaf63&quot;,&quot;type&quot;:&quot;ASSETS&quot;},&quot;isPremium&quot;:true},&quot;69882f09-baa4-49ed-abcd-6bf96fb71bd7&quot;:{&quot;id&quot;:&quot;69882f09-baa4-49ed-abcd-6bf96fb71bd7&quot;,&quot;name&quot;:&quot;Pill&quot;,&quot;type&quot;:&quot;FIGURE_OBJECT&quot;,&quot;relativeTransform&quot;:{&quot;translate&quot;:{&quot;x&quot;:-54.567779158393485,&quot;y&quot;:-259.7289704286371},&quot;rotate&quot;:-0.22017744070666753,&quot;skewX&quot;:0,&quot;scale&quot;:{&quot;x&quot;:0.55162259114342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2&quot;}},&quot;ffc78527-3a89-4f6b-b297-88c031402b45&quot;:{&quot;id&quot;:&quot;ffc78527-3a89-4f6b-b297-88c031402b45&quot;,&quot;name&quot;:&quot;Pill&quot;,&quot;type&quot;:&quot;FIGURE_OBJECT&quot;,&quot;relativeTransform&quot;:{&quot;translate&quot;:{&quot;x&quot;:-38.0779636962714,&quot;y&quot;:-232.27741754225076},&quot;rotate&quot;:2.731657600636832,&quot;skewX&quot;:9.12149764969962e-17,&quot;scale&quot;:{&quot;x&quot;:0.551622591143428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5&quot;},&quot;opacity&quot;:0.78},&quot;ee11c06a-3576-4aa5-bb01-3a4c719cd33b&quot;:{&quot;id&quot;:&quot;ee11c06a-3576-4aa5-bb01-3a4c719cd33b&quot;,&quot;name&quot;:&quot;Pill&quot;,&quot;type&quot;:&quot;FIGURE_OBJECT&quot;,&quot;relativeTransform&quot;:{&quot;translate&quot;:{&quot;x&quot;:-52.58371747724082,&quot;y&quot;:-214.37741536307334},&quot;rotate&quot;:-7.642229304742056e-17,&quot;skewX&quot;:-7.642229304742057e-17,&quot;scale&quot;:{&quot;x&quot;:0.5516225911434285,&quot;y&quot;:0.5516225911434287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7&quot;}},&quot;dbf3c7e6-af9c-4614-aaa1-0ec60faa16bc&quot;:{&quot;id&quot;:&quot;dbf3c7e6-af9c-4614-aaa1-0ec60faa16bc&quot;,&quot;name&quot;:&quot;Absorption (ADMET, symbol)&quot;,&quot;displayName&quot;:&quot;&quot;,&quot;type&quot;:&quot;FIGURE_OBJECT&quot;,&quot;relativeTransform&quot;:{&quot;translate&quot;:{&quot;x&quot;:-86,&quot;y&quot;:-114.67426273458443},&quot;rotate&quot;:0,&quot;skewX&quot;:0,&quot;scale&quot;:{&quot;x&quot;:1,&quot;y&quot;:1}},&quot;image&quot;:{&quot;url&quot;:&quot;https://icons.cdn.biorender.com/biorender/67f5906e8036a7aacbd4cedb/20250408211342/image/67f5906e8036a7aacbd4cedb.png&quot;,&quot;isPremium&quot;:false,&quot;isOrgIcon&quot;:false,&quot;size&quot;:{&quot;x&quot;:100,&quot;y&quot;:100}},&quot;source&quot;:{&quot;id&quot;:&quot;67f5906e8036a7aacbd4cedb&quot;,&quot;version&quot;:&quot;20250408211342&quot;,&quot;type&quot;:&quot;ASSETS&quot;},&quot;isPremium&quot;:false,&quot;parent&quot;:{&quot;type&quot;:&quot;CHILD&quot;,&quot;parentId&quot;:&quot;228b698d-4cee-4aaf-8d74-c84d91114676&quot;,&quot;order&quot;:&quot;995&quot;}},&quot;64a73b3b-f713-499c-8bb0-94022021977b&quot;:{&quot;id&quot;:&quot;64a73b3b-f713-499c-8bb0-94022021977b&quot;,&quot;name&quot;:&quot;Metabolism (ADMET, symbol)&quot;,&quot;displayName&quot;:&quot;&quot;,&quot;type&quot;:&quot;FIGURE_OBJECT&quot;,&quot;relativeTransform&quot;:{&quot;translate&quot;:{&quot;x&quot;:25,&quot;y&quot;:-116.67426273458443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97&quot;}},&quot;ac397bb5-a291-43a5-8402-3dd47a8fd2de&quot;:{&quot;id&quot;:&quot;ac397bb5-a291-43a5-8402-3dd47a8fd2de&quot;,&quot;name&quot;:&quot;Excretion (ADMET, symbol)&quot;,&quot;displayName&quot;:&quot;&quot;,&quot;type&quot;:&quot;FIGURE_OBJECT&quot;,&quot;relativeTransform&quot;:{&quot;translate&quot;:{&quot;x&quot;:124,&quot;y&quot;:-117.67426273458443},&quot;rotate&quot;:0,&quot;skewX&quot;:0,&quot;scale&quot;:{&quot;x&quot;:1,&quot;y&quot;:1}},&quot;image&quot;:{&quot;url&quot;:&quot;https://icons.cdn.biorender.com/biorender/67f5952f8036a7aacbd4d1e9/20250408212945/image/67f5952f8036a7aacbd4d1e9.png&quot;,&quot;isPremium&quot;:false,&quot;isOrgIcon&quot;:false,&quot;size&quot;:{&quot;x&quot;:100,&quot;y&quot;:100}},&quot;source&quot;:{&quot;id&quot;:&quot;67f5952f8036a7aacbd4d1e9&quot;,&quot;version&quot;:&quot;20250408212945&quot;,&quot;type&quot;:&quot;ASSETS&quot;},&quot;isPremium&quot;:false,&quot;parent&quot;:{&quot;type&quot;:&quot;CHILD&quot;,&quot;parentId&quot;:&quot;228b698d-4cee-4aaf-8d74-c84d91114676&quot;,&quot;order&quot;:&quot;998&quot;}},&quot;be10db81-2c63-4af8-9a80-2e62a491e20b&quot;:{&quot;relativeTransform&quot;:{&quot;translate&quot;:{&quot;x&quot;:195.54388195061262,&quot;y&quot;:-34.44402995059181},&quot;rotate&quot;:0,&quot;skewX&quot;:0,&quot;scale&quot;:{&quot;x&quot;:1,&quot;y&quot;:1}},&quot;type&quot;:&quot;FIGURE_OBJECT&quot;,&quot;id&quot;:&quot;be10db81-2c63-4af8-9a80-2e62a491e20b&quot;,&quot;parent&quot;:{&quot;type&quot;:&quot;CHILD&quot;,&quot;parentId&quot;:&quot;228b698d-4cee-4aaf-8d74-c84d91114676&quot;,&quot;order&quot;:&quot;999&quot;},&quot;name&quot;:&quot;Adult male head (lateral, taking oral medication)&quot;,&quot;displayName&quot;:&quot;Adult male head (lateral, taking oral medication)&quot;,&quot;source&quot;:{&quot;id&quot;:&quot;63bc4d3e69764ef572715e51&quot;,&quot;type&quot;:&quot;ASSETS&quot;},&quot;isPremium&quot;:true},&quot;5ea02427-5ca5-48b7-ba18-a6b04e8fa193&quot;:{&quot;id&quot;:&quot;5ea02427-5ca5-48b7-ba18-a6b04e8fa193&quot;,&quot;name&quot;:&quot;Adult male head (lateral, open mouth)&quot;,&quot;displayName&quot;:&quot;&quot;,&quot;type&quot;:&quot;FIGURE_OBJECT&quot;,&quot;relativeTransform&quot;:{&quot;translate&quot;:{&quot;x&quot;:-44.69765631434586,&quot;y&quot;:181.4440299505918},&quot;rotate&quot;:0,&quot;skewX&quot;:0,&quot;scale&quot;:{&quot;x&quot;:1,&quot;y&quot;:1}},&quot;image&quot;:{&quot;url&quot;:&quot;https://icons.biorender.com/biorender/5ecd2dd9fc86fd00280efee8/20200526150009/image/adult-male-head-lateral-open-mouth.png&quot;,&quot;fallbackUrl&quot;:&quot;https://res.cloudinary.com/dlcjuc3ej/image/upload/v1590505209/cy467owkhsyjy1wjgwgy.svg#/keystone/api/icons/5ecd2dd9fc86fd00280efee8/20200526150009/image/adult-male-head-lateral-open-mouth.svg&quot;,&quot;isPremium&quot;:true,&quot;size&quot;:{&quot;x&quot;:100,&quot;y&quot;:145.95744680851064}},&quot;source&quot;:{&quot;id&quot;:&quot;5ecd2dd9fc86fd00280efee8&quot;,&quot;type&quot;:&quot;ASSETS&quot;},&quot;isPremium&quot;:true,&quot;parent&quot;:{&quot;type&quot;:&quot;CHILD&quot;,&quot;parentId&quot;:&quot;be10db81-2c63-4af8-9a80-2e62a491e20b&quot;,&quot;order&quot;:&quot;2&quot;}},&quot;2d92d51c-362e-4192-a6f0-afdf04b10350&quot;:{&quot;relativeTransform&quot;:{&quot;translate&quot;:{&quot;x&quot;:-108.89939975206015,&quot;y&quot;:269.268809325843},&quot;rotate&quot;:0,&quot;skewX&quot;:0,&quot;scale&quot;:{&quot;x&quot;:1,&quot;y&quot;:1}},&quot;type&quot;:&quot;FIGURE_OBJECT&quot;,&quot;id&quot;:&quot;2d92d51c-362e-4192-a6f0-afdf04b10350&quot;,&quot;parent&quot;:{&quot;type&quot;:&quot;CHILD&quot;,&quot;parentId&quot;:&quot;be10db81-2c63-4af8-9a80-2e62a491e20b&quot;,&quot;order&quot;:&quot;5&quot;},&quot;name&quot;:&quot;Pill cluster&quot;,&quot;displayName&quot;:&quot;Pill cluster&quot;,&quot;source&quot;:{&quot;id&quot;:&quot;608aeff9ac44b300a20aaf63&quot;,&quot;type&quot;:&quot;ASSETS&quot;},&quot;isPremium&quot;:true},&quot;bd97b65a-b41e-46e2-b85d-b1bdb8a18e50&quot;:{&quot;id&quot;:&quot;bd97b65a-b41e-46e2-b85d-b1bdb8a18e50&quot;,&quot;name&quot;:&quot;Pill&quot;,&quot;type&quot;:&quot;FIGURE_OBJECT&quot;,&quot;relativeTransform&quot;:{&quot;translate&quot;:{&quot;x&quot;:-14.310552926061176,&quot;y&quot;:-87.29506398454491},&quot;rotate&quot;:2.731657600636832,&quot;skewX&quot;:8.072550417700369e-17,&quot;scale&quot;:{&quot;x&quot;:0.20731214380936094,&quot;y&quot;:0.20731214380936125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5&quot;},&quot;opacity&quot;:0.78},&quot;2bd74ecf-0680-441a-ba07-3bf38a42c93e&quot;:{&quot;id&quot;:&quot;2bd74ecf-0680-441a-ba07-3bf38a42c93e&quot;,&quot;name&quot;:&quot;Pill&quot;,&quot;type&quot;:&quot;FIGURE_OBJECT&quot;,&quot;relativeTransform&quot;:{&quot;translate&quot;:{&quot;x&quot;:-19.762140591588093,&quot;y&quot;:-80.56784163082403},&quot;rotate&quot;:-7.642229304742056e-17,&quot;skewX&quot;:-7.642229304742064e-17,&quot;scale&quot;:{&quot;x&quot;:0.20731214380936086,&quot;y&quot;:0.2073121438093609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7&quot;}},&quot;4e9da238-c226-4237-9fff-754465ad1147&quot;:{&quot;id&quot;:&quot;4e9da238-c226-4237-9fff-754465ad1147&quot;,&quot;name&quot;:&quot;Pill&quot;,&quot;type&quot;:&quot;FIGURE_OBJECT&quot;,&quot;relativeTransform&quot;:{&quot;translate&quot;:{&quot;x&quot;:-20.507795478051605,&quot;y&quot;:-97.61197335545403},&quot;rotate&quot;:-0.2201774407066676,&quot;skewX&quot;:0,&quot;scale&quot;:{&quot;x&quot;:0.20731214380936067,&quot;y&quot;:0.207312143809361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2&quot;}},&quot;34dbf796-49a7-4ab6-adb2-dfb7c143995c&quot;:{&quot;type&quot;:&quot;FIGURE_OBJECT&quot;,&quot;id&quot;:&quot;34dbf796-49a7-4ab6-adb2-dfb7c143995c&quot;,&quot;relativeTransform&quot;:{&quot;translate&quot;:{&quot;x&quot;:-97.31827780975603,&quot;y&quot;:179.09500275996288},&quot;rotate&quot;:0,&quot;skewX&quot;:0,&quot;scale&quot;:{&quot;x&quot;:1,&quot;y&quot;:1}},&quot;opacity&quot;:1,&quot;path&quot;:{&quot;type&quot;:&quot;POLY_LINE&quot;,&quot;points&quot;:[{&quot;x&quot;:-12.144126817834582,&quot;y&quot;:0},{&quot;x&quot;:-0.8333192585170209,&quot;y&quot;:0},{&quot;x&quot;:12.14412681783459,&quot;y&quot;:0}],&quot;closed&quot;:false,&quot;cornerRounding&quot;:{&quot;type&quot;:&quot;ARC_LENGTH&quot;,&quot;global&quot;:58.813885746365806}},&quot;pathStyles&quot;:[{&quot;type&quot;:&quot;FILL&quot;,&quot;fillStyle&quot;:&quot;transparent&quot;},{&quot;type&quot;:&quot;STROKE&quot;,&quot;strokeStyle&quot;:&quot;#232323&quot;,&quot;lineWidth&quot;:1.348508802440510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e10db81-2c63-4af8-9a80-2e62a491e20b&quot;,&quot;order&quot;:&quot;7&quot;}},&quot;40426b1f-f4a2-48f4-9ae7-77808da3515c&quot;:{&quot;id&quot;:&quot;40426b1f-f4a2-48f4-9ae7-77808da3515c&quot;,&quot;name&quot;:&quot;Adult (gender-neutral, lateral, taking pill) &quot;,&quot;displayName&quot;:&quot;&quot;,&quot;type&quot;:&quot;FIGURE_OBJECT&quot;,&quot;relativeTransform&quot;:{&quot;translate&quot;:{&quot;x&quot;:-221,&quot;y&quot;:-122},&quot;rotate&quot;:0,&quot;skewX&quot;:0,&quot;scale&quot;:{&quot;x&quot;:1,&quot;y&quot;:1}},&quot;image&quot;:{&quot;url&quot;:&quot;https://icons.cdn.biorender.com/biorender/672d005c9105801996905713/672ce05854021394a7d1b3c5.png&quot;,&quot;isPremium&quot;:false,&quot;isOrgIcon&quot;:false,&quot;size&quot;:{&quot;x&quot;:150,&quot;y&quot;:140.3485254691689},&quot;fallbackUrl&quot;:&quot;sources/icons/672d005c9105801996905713/672ce05854021394a7d1b3c5.svg&quot;},&quot;source&quot;:{&quot;id&quot;:&quot;672ce05854021394a7d1b3c5&quot;,&quot;version&quot;:&quot;20241107180047&quot;,&quot;type&quot;:&quot;ASSETS&quot;},&quot;isPremium&quot;:false,&quot;parent&quot;:{&quot;type&quot;:&quot;CHILD&quot;,&quot;parentId&quot;:&quot;228b698d-4cee-4aaf-8d74-c84d91114676&quot;,&quot;order&quot;:&quot;9995&quot;}}}}"/>
  <p:tag name="TITLE" val="Untitled"/>
  <p:tag name="CREATORNAME" val="Samson Cantor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,&quot;715bbc95-2221-48e5-a0b2-e1ae84faa96a&quot;:{&quot;id&quot;:&quot;715bbc95-2221-48e5-a0b2-e1ae84faa96a&quot;,&quot;name&quot;:&quot;Glucose meter&quot;,&quot;displayName&quot;:&quot;&quot;,&quot;type&quot;:&quot;FIGURE_OBJECT&quot;,&quot;relativeTransform&quot;:{&quot;translate&quot;:{&quot;x&quot;:-374.8627450980392,&quot;y&quot;:127.5},&quot;rotate&quot;:0,&quot;skewX&quot;:0,&quot;scale&quot;:{&quot;x&quot;:0.2551633986928105,&quot;y&quot;:0.2551633986928105}},&quot;image&quot;:{&quot;url&quot;:&quot;https://icons.cdn.biorender.com/biorender/5cc36f64df35f43300d5ab9e/20190426205306/image/5cc36f64df35f43300d5ab9e.png&quot;,&quot;isPremium&quot;:false,&quot;isOrgIcon&quot;:false,&quot;size&quot;:{&quot;x&quot;:150,&quot;y&quot;:310.13513513513516}},&quot;source&quot;:{&quot;id&quot;:&quot;5cc36f64df35f43300d5ab9e&quot;,&quot;version&quot;:&quot;20190426205306&quot;,&quot;type&quot;:&quot;ASSETS&quot;},&quot;isPremium&quot;:false,&quot;parent&quot;:{&quot;type&quot;:&quot;CHILD&quot;,&quot;parentId&quot;:&quot;228b698d-4cee-4aaf-8d74-c84d91114676&quot;,&quot;order&quot;:&quot;97&quot;}},&quot;5f9c25af-4e61-4d01-a7f9-bc96f00ec0a3&quot;:{&quot;id&quot;:&quot;5f9c25af-4e61-4d01-a7f9-bc96f00ec0a3&quot;,&quot;name&quot;:&quot;Child 3 (head, gender-neutral, stage I obesity, anterior)&quot;,&quot;displayName&quot;:&quot;&quot;,&quot;type&quot;:&quot;FIGURE_OBJECT&quot;,&quot;relativeTransform&quot;:{&quot;translate&quot;:{&quot;x&quot;:-294,&quot;y&quot;:145},&quot;rotate&quot;:0,&quot;skewX&quot;:0,&quot;scale&quot;:{&quot;x&quot;:1,&quot;y&quot;:1}},&quot;image&quot;:{&quot;url&quot;:&quot;https://icons.cdn.biorender.com/biorender/671a9e69bdca4c36b346d6be/671a9e50bdca4c36b346d679.png&quot;,&quot;isPremium&quot;:true,&quot;isOrgIcon&quot;:false,&quot;size&quot;:{&quot;x&quot;:150,&quot;y&quot;:140.3485254691689},&quot;fallbackUrl&quot;:&quot;sources/icons/671a9e69bdca4c36b346d6be/671a9e50bdca4c36b346d679.svg&quot;},&quot;source&quot;:{&quot;id&quot;:&quot;671a9e50bdca4c36b346d679&quot;,&quot;version&quot;:&quot;20241024192203&quot;,&quot;type&quot;:&quot;ASSETS&quot;},&quot;isPremium&quot;:true,&quot;parent&quot;:{&quot;type&quot;:&quot;CHILD&quot;,&quot;parentId&quot;:&quot;228b698d-4cee-4aaf-8d74-c84d91114676&quot;,&quot;order&quot;:&quot;98&quot;}},&quot;3bbfb5a3-190d-4c8e-8632-87cfbfcbc871&quot;:{&quot;relativeTransform&quot;:{&quot;translate&quot;:{&quot;x&quot;:-149.81948063774848,&quot;y&quot;:364.7558646383225},&quot;rotate&quot;:0,&quot;skewX&quot;:0,&quot;scale&quot;:{&quot;x&quot;:1,&quot;y&quot;:1}},&quot;type&quot;:&quot;FIGURE_OBJECT&quot;,&quot;id&quot;:&quot;3bbfb5a3-190d-4c8e-8632-87cfbfcbc871&quot;,&quot;parent&quot;:{&quot;type&quot;:&quot;CHILD&quot;,&quot;parentId&quot;:&quot;228b698d-4cee-4aaf-8d74-c84d91114676&quot;,&quot;order&quot;:&quot;99&quot;},&quot;name&quot;:&quot;Pill cluster&quot;,&quot;displayName&quot;:&quot;Pill cluster&quot;,&quot;source&quot;:{&quot;id&quot;:&quot;608aeff9ac44b300a20aaf63&quot;,&quot;type&quot;:&quot;ASSETS&quot;},&quot;isPremium&quot;:true},&quot;69882f09-baa4-49ed-abcd-6bf96fb71bd7&quot;:{&quot;id&quot;:&quot;69882f09-baa4-49ed-abcd-6bf96fb71bd7&quot;,&quot;name&quot;:&quot;Pill&quot;,&quot;type&quot;:&quot;FIGURE_OBJECT&quot;,&quot;relativeTransform&quot;:{&quot;translate&quot;:{&quot;x&quot;:-54.567779158393485,&quot;y&quot;:-259.7289704286371},&quot;rotate&quot;:-0.22017744070666753,&quot;skewX&quot;:0,&quot;scale&quot;:{&quot;x&quot;:0.55162259114342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2&quot;}},&quot;ffc78527-3a89-4f6b-b297-88c031402b45&quot;:{&quot;id&quot;:&quot;ffc78527-3a89-4f6b-b297-88c031402b45&quot;,&quot;name&quot;:&quot;Pill&quot;,&quot;type&quot;:&quot;FIGURE_OBJECT&quot;,&quot;relativeTransform&quot;:{&quot;translate&quot;:{&quot;x&quot;:-38.0779636962714,&quot;y&quot;:-232.27741754225076},&quot;rotate&quot;:2.731657600636832,&quot;skewX&quot;:9.12149764969962e-17,&quot;scale&quot;:{&quot;x&quot;:0.551622591143428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5&quot;},&quot;opacity&quot;:0.78},&quot;ee11c06a-3576-4aa5-bb01-3a4c719cd33b&quot;:{&quot;id&quot;:&quot;ee11c06a-3576-4aa5-bb01-3a4c719cd33b&quot;,&quot;name&quot;:&quot;Pill&quot;,&quot;type&quot;:&quot;FIGURE_OBJECT&quot;,&quot;relativeTransform&quot;:{&quot;translate&quot;:{&quot;x&quot;:-52.58371747724082,&quot;y&quot;:-214.37741536307334},&quot;rotate&quot;:-7.642229304742056e-17,&quot;skewX&quot;:-7.642229304742057e-17,&quot;scale&quot;:{&quot;x&quot;:0.5516225911434285,&quot;y&quot;:0.5516225911434287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7&quot;}},&quot;dbf3c7e6-af9c-4614-aaa1-0ec60faa16bc&quot;:{&quot;id&quot;:&quot;dbf3c7e6-af9c-4614-aaa1-0ec60faa16bc&quot;,&quot;name&quot;:&quot;Absorption (ADMET, symbol)&quot;,&quot;displayName&quot;:&quot;&quot;,&quot;type&quot;:&quot;FIGURE_OBJECT&quot;,&quot;relativeTransform&quot;:{&quot;translate&quot;:{&quot;x&quot;:-86,&quot;y&quot;:-114.67426273458443},&quot;rotate&quot;:0,&quot;skewX&quot;:0,&quot;scale&quot;:{&quot;x&quot;:1,&quot;y&quot;:1}},&quot;image&quot;:{&quot;url&quot;:&quot;https://icons.cdn.biorender.com/biorender/67f5906e8036a7aacbd4cedb/20250408211342/image/67f5906e8036a7aacbd4cedb.png&quot;,&quot;isPremium&quot;:false,&quot;isOrgIcon&quot;:false,&quot;size&quot;:{&quot;x&quot;:100,&quot;y&quot;:100}},&quot;source&quot;:{&quot;id&quot;:&quot;67f5906e8036a7aacbd4cedb&quot;,&quot;version&quot;:&quot;20250408211342&quot;,&quot;type&quot;:&quot;ASSETS&quot;},&quot;isPremium&quot;:false,&quot;parent&quot;:{&quot;type&quot;:&quot;CHILD&quot;,&quot;parentId&quot;:&quot;228b698d-4cee-4aaf-8d74-c84d91114676&quot;,&quot;order&quot;:&quot;995&quot;}},&quot;64a73b3b-f713-499c-8bb0-94022021977b&quot;:{&quot;id&quot;:&quot;64a73b3b-f713-499c-8bb0-94022021977b&quot;,&quot;name&quot;:&quot;Metabolism (ADMET, symbol)&quot;,&quot;displayName&quot;:&quot;&quot;,&quot;type&quot;:&quot;FIGURE_OBJECT&quot;,&quot;relativeTransform&quot;:{&quot;translate&quot;:{&quot;x&quot;:25,&quot;y&quot;:-116.67426273458443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97&quot;}},&quot;ac397bb5-a291-43a5-8402-3dd47a8fd2de&quot;:{&quot;id&quot;:&quot;ac397bb5-a291-43a5-8402-3dd47a8fd2de&quot;,&quot;name&quot;:&quot;Excretion (ADMET, symbol)&quot;,&quot;displayName&quot;:&quot;&quot;,&quot;type&quot;:&quot;FIGURE_OBJECT&quot;,&quot;relativeTransform&quot;:{&quot;translate&quot;:{&quot;x&quot;:124,&quot;y&quot;:-117.67426273458443},&quot;rotate&quot;:0,&quot;skewX&quot;:0,&quot;scale&quot;:{&quot;x&quot;:1,&quot;y&quot;:1}},&quot;image&quot;:{&quot;url&quot;:&quot;https://icons.cdn.biorender.com/biorender/67f5952f8036a7aacbd4d1e9/20250408212945/image/67f5952f8036a7aacbd4d1e9.png&quot;,&quot;isPremium&quot;:false,&quot;isOrgIcon&quot;:false,&quot;size&quot;:{&quot;x&quot;:100,&quot;y&quot;:100}},&quot;source&quot;:{&quot;id&quot;:&quot;67f5952f8036a7aacbd4d1e9&quot;,&quot;version&quot;:&quot;20250408212945&quot;,&quot;type&quot;:&quot;ASSETS&quot;},&quot;isPremium&quot;:false,&quot;parent&quot;:{&quot;type&quot;:&quot;CHILD&quot;,&quot;parentId&quot;:&quot;228b698d-4cee-4aaf-8d74-c84d91114676&quot;,&quot;order&quot;:&quot;998&quot;}},&quot;be10db81-2c63-4af8-9a80-2e62a491e20b&quot;:{&quot;relativeTransform&quot;:{&quot;translate&quot;:{&quot;x&quot;:195.54388195061262,&quot;y&quot;:-34.44402995059181},&quot;rotate&quot;:0,&quot;skewX&quot;:0,&quot;scale&quot;:{&quot;x&quot;:1,&quot;y&quot;:1}},&quot;type&quot;:&quot;FIGURE_OBJECT&quot;,&quot;id&quot;:&quot;be10db81-2c63-4af8-9a80-2e62a491e20b&quot;,&quot;parent&quot;:{&quot;type&quot;:&quot;CHILD&quot;,&quot;parentId&quot;:&quot;228b698d-4cee-4aaf-8d74-c84d91114676&quot;,&quot;order&quot;:&quot;999&quot;},&quot;name&quot;:&quot;Adult male head (lateral, taking oral medication)&quot;,&quot;displayName&quot;:&quot;Adult male head (lateral, taking oral medication)&quot;,&quot;source&quot;:{&quot;id&quot;:&quot;63bc4d3e69764ef572715e51&quot;,&quot;type&quot;:&quot;ASSETS&quot;},&quot;isPremium&quot;:true},&quot;5ea02427-5ca5-48b7-ba18-a6b04e8fa193&quot;:{&quot;id&quot;:&quot;5ea02427-5ca5-48b7-ba18-a6b04e8fa193&quot;,&quot;name&quot;:&quot;Adult male head (lateral, open mouth)&quot;,&quot;displayName&quot;:&quot;&quot;,&quot;type&quot;:&quot;FIGURE_OBJECT&quot;,&quot;relativeTransform&quot;:{&quot;translate&quot;:{&quot;x&quot;:-44.69765631434586,&quot;y&quot;:181.4440299505918},&quot;rotate&quot;:0,&quot;skewX&quot;:0,&quot;scale&quot;:{&quot;x&quot;:1,&quot;y&quot;:1}},&quot;image&quot;:{&quot;url&quot;:&quot;https://icons.biorender.com/biorender/5ecd2dd9fc86fd00280efee8/20200526150009/image/adult-male-head-lateral-open-mouth.png&quot;,&quot;fallbackUrl&quot;:&quot;https://res.cloudinary.com/dlcjuc3ej/image/upload/v1590505209/cy467owkhsyjy1wjgwgy.svg#/keystone/api/icons/5ecd2dd9fc86fd00280efee8/20200526150009/image/adult-male-head-lateral-open-mouth.svg&quot;,&quot;isPremium&quot;:true,&quot;size&quot;:{&quot;x&quot;:100,&quot;y&quot;:145.95744680851064}},&quot;source&quot;:{&quot;id&quot;:&quot;5ecd2dd9fc86fd00280efee8&quot;,&quot;type&quot;:&quot;ASSETS&quot;},&quot;isPremium&quot;:true,&quot;parent&quot;:{&quot;type&quot;:&quot;CHILD&quot;,&quot;parentId&quot;:&quot;be10db81-2c63-4af8-9a80-2e62a491e20b&quot;,&quot;order&quot;:&quot;2&quot;}},&quot;2d92d51c-362e-4192-a6f0-afdf04b10350&quot;:{&quot;relativeTransform&quot;:{&quot;translate&quot;:{&quot;x&quot;:-108.89939975206015,&quot;y&quot;:269.268809325843},&quot;rotate&quot;:0,&quot;skewX&quot;:0,&quot;scale&quot;:{&quot;x&quot;:1,&quot;y&quot;:1}},&quot;type&quot;:&quot;FIGURE_OBJECT&quot;,&quot;id&quot;:&quot;2d92d51c-362e-4192-a6f0-afdf04b10350&quot;,&quot;parent&quot;:{&quot;type&quot;:&quot;CHILD&quot;,&quot;parentId&quot;:&quot;be10db81-2c63-4af8-9a80-2e62a491e20b&quot;,&quot;order&quot;:&quot;5&quot;},&quot;name&quot;:&quot;Pill cluster&quot;,&quot;displayName&quot;:&quot;Pill cluster&quot;,&quot;source&quot;:{&quot;id&quot;:&quot;608aeff9ac44b300a20aaf63&quot;,&quot;type&quot;:&quot;ASSETS&quot;},&quot;isPremium&quot;:true},&quot;bd97b65a-b41e-46e2-b85d-b1bdb8a18e50&quot;:{&quot;id&quot;:&quot;bd97b65a-b41e-46e2-b85d-b1bdb8a18e50&quot;,&quot;name&quot;:&quot;Pill&quot;,&quot;type&quot;:&quot;FIGURE_OBJECT&quot;,&quot;relativeTransform&quot;:{&quot;translate&quot;:{&quot;x&quot;:-14.310552926061176,&quot;y&quot;:-87.29506398454491},&quot;rotate&quot;:2.731657600636832,&quot;skewX&quot;:8.072550417700369e-17,&quot;scale&quot;:{&quot;x&quot;:0.20731214380936094,&quot;y&quot;:0.20731214380936125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5&quot;},&quot;opacity&quot;:0.78},&quot;2bd74ecf-0680-441a-ba07-3bf38a42c93e&quot;:{&quot;id&quot;:&quot;2bd74ecf-0680-441a-ba07-3bf38a42c93e&quot;,&quot;name&quot;:&quot;Pill&quot;,&quot;type&quot;:&quot;FIGURE_OBJECT&quot;,&quot;relativeTransform&quot;:{&quot;translate&quot;:{&quot;x&quot;:-19.762140591588093,&quot;y&quot;:-80.56784163082403},&quot;rotate&quot;:-7.642229304742056e-17,&quot;skewX&quot;:-7.642229304742064e-17,&quot;scale&quot;:{&quot;x&quot;:0.20731214380936086,&quot;y&quot;:0.2073121438093609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7&quot;}},&quot;4e9da238-c226-4237-9fff-754465ad1147&quot;:{&quot;id&quot;:&quot;4e9da238-c226-4237-9fff-754465ad1147&quot;,&quot;name&quot;:&quot;Pill&quot;,&quot;type&quot;:&quot;FIGURE_OBJECT&quot;,&quot;relativeTransform&quot;:{&quot;translate&quot;:{&quot;x&quot;:-20.507795478051605,&quot;y&quot;:-97.61197335545403},&quot;rotate&quot;:-0.2201774407066676,&quot;skewX&quot;:0,&quot;scale&quot;:{&quot;x&quot;:0.20731214380936067,&quot;y&quot;:0.207312143809361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2&quot;}},&quot;34dbf796-49a7-4ab6-adb2-dfb7c143995c&quot;:{&quot;type&quot;:&quot;FIGURE_OBJECT&quot;,&quot;id&quot;:&quot;34dbf796-49a7-4ab6-adb2-dfb7c143995c&quot;,&quot;relativeTransform&quot;:{&quot;translate&quot;:{&quot;x&quot;:-97.31827780975603,&quot;y&quot;:179.09500275996288},&quot;rotate&quot;:0,&quot;skewX&quot;:0,&quot;scale&quot;:{&quot;x&quot;:1,&quot;y&quot;:1}},&quot;opacity&quot;:1,&quot;path&quot;:{&quot;type&quot;:&quot;POLY_LINE&quot;,&quot;points&quot;:[{&quot;x&quot;:-12.144126817834582,&quot;y&quot;:0},{&quot;x&quot;:-0.8333192585170209,&quot;y&quot;:0},{&quot;x&quot;:12.14412681783459,&quot;y&quot;:0}],&quot;closed&quot;:false,&quot;cornerRounding&quot;:{&quot;type&quot;:&quot;ARC_LENGTH&quot;,&quot;global&quot;:58.813885746365806}},&quot;pathStyles&quot;:[{&quot;type&quot;:&quot;FILL&quot;,&quot;fillStyle&quot;:&quot;transparent&quot;},{&quot;type&quot;:&quot;STROKE&quot;,&quot;strokeStyle&quot;:&quot;#232323&quot;,&quot;lineWidth&quot;:1.348508802440510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e10db81-2c63-4af8-9a80-2e62a491e20b&quot;,&quot;order&quot;:&quot;7&quot;}},&quot;40426b1f-f4a2-48f4-9ae7-77808da3515c&quot;:{&quot;id&quot;:&quot;40426b1f-f4a2-48f4-9ae7-77808da3515c&quot;,&quot;name&quot;:&quot;Adult (gender-neutral, lateral, taking pill) &quot;,&quot;displayName&quot;:&quot;&quot;,&quot;type&quot;:&quot;FIGURE_OBJECT&quot;,&quot;relativeTransform&quot;:{&quot;translate&quot;:{&quot;x&quot;:-221,&quot;y&quot;:-122},&quot;rotate&quot;:0,&quot;skewX&quot;:0,&quot;scale&quot;:{&quot;x&quot;:1,&quot;y&quot;:1}},&quot;image&quot;:{&quot;url&quot;:&quot;https://icons.cdn.biorender.com/biorender/672d005c9105801996905713/672ce05854021394a7d1b3c5.png&quot;,&quot;isPremium&quot;:false,&quot;isOrgIcon&quot;:false,&quot;size&quot;:{&quot;x&quot;:150,&quot;y&quot;:140.3485254691689},&quot;fallbackUrl&quot;:&quot;sources/icons/672d005c9105801996905713/672ce05854021394a7d1b3c5.svg&quot;},&quot;source&quot;:{&quot;id&quot;:&quot;672ce05854021394a7d1b3c5&quot;,&quot;version&quot;:&quot;20241107180047&quot;,&quot;type&quot;:&quot;ASSETS&quot;},&quot;isPremium&quot;:false,&quot;parent&quot;:{&quot;type&quot;:&quot;CHILD&quot;,&quot;parentId&quot;:&quot;228b698d-4cee-4aaf-8d74-c84d91114676&quot;,&quot;order&quot;:&quot;9995&quot;}},&quot;051254f3-c91c-46d4-904a-4f56f1f36c6c&quot;:{&quot;relativeTransform&quot;:{&quot;translate&quot;:{&quot;x&quot;:266.29771864996013,&quot;y&quot;:-129},&quot;rotate&quot;:0},&quot;type&quot;:&quot;FIGURE_OBJECT&quot;,&quot;id&quot;:&quot;051254f3-c91c-46d4-904a-4f56f1f36c6c&quot;,&quot;name&quot;:&quot;Blood vial (with blood and label, capped)&quot;,&quot;displayName&quot;:&quot;Blood vial (with blood and label, capped)&quot;,&quot;opacity&quot;:1,&quot;source&quot;:{&quot;id&quot;:&quot;5dbb01b84ef0b000810d2b0e&quot;,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7&quot;},&quot;isPremium&quot;:true},&quot;ed197ed7-7fe7-4847-881d-92ed223786f5&quot;:{&quot;type&quot;:&quot;FIGURE_OBJECT&quot;,&quot;id&quot;:&quot;ed197ed7-7fe7-4847-881d-92ed223786f5&quot;,&quot;name&quot;:&quot;Blood vial (labelled)&quot;,&quot;relativeTransform&quot;:{&quot;translate&quot;:{&quot;x&quot;:2.0318280249341756e-15,&quot;y&quot;:12.889965271685073},&quot;rotate&quot;:0,&quot;skewX&quot;:0,&quot;scale&quot;:{&quot;x&quot;:0.439929804614158,&quot;y&quot;:0.4399298046141579}},&quot;opacity&quot;:1,&quot;image&quot;:{&quot;url&quot;:&quot;https://res.cloudinary.com/dlcjuc3ej/image/upload/v1572535485/xokmqyvumsqposaheemj.svg#/keystone/api/icons/5dbafc93c9e7d80004b85b52/20191031152445/image/blood-vial-labelled.svg&quot;,&quot;fallbackUrl&quot;:&quot;https://res.cloudinary.com/dlcjuc3ej/image/upload/v1572535485/xokmqyvumsqposaheemj.svg#/keystone/api/icons/5dbafc93c9e7d80004b85b52/20191031152445/image/blood-vial-labelled.svg&quot;,&quot;size&quot;:{&quot;x&quot;:65,&quot;y&quot;:239},&quot;isPremium&quot;:false},&quot;source&quot;:{&quot;id&quot;:&quot;5dbafc93c9e7d80004b85b52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2&quot;}},&quot;0fbbfeea-2f9a-462e-b3dc-ddbe005602ac&quot;:{&quot;type&quot;:&quot;FIGURE_OBJECT&quot;,&quot;id&quot;:&quot;0fbbfeea-2f9a-462e-b3dc-ddbe005602ac&quot;,&quot;name&quot;:&quot;Blood vial cap&quot;,&quot;relativeTransform&quot;:{&quot;translate&quot;:{&quot;x&quot;:0,&quot;y&quot;:-48.08434964081768},&quot;rotate&quot;:0,&quot;skewX&quot;:0,&quot;scale&quot;:{&quot;x&quot;:0.4399298046141579,&quot;y&quot;:0.4399298046141579}},&quot;opacity&quot;:1,&quot;image&quot;:{&quot;url&quot;:&quot;https://icons.biorender.com/biorender/5dbafea2c9e7d80004b85b5f/20191031153357/image/blood-vial-cap.png&quot;,&quot;fallbackUrl&quot;:&quot;https://res.cloudinary.com/dlcjuc3ej/image/upload/v1572536037/xpaz3jnhluv07ckoqfe9.svg#/keystone/api/icons/5dbafea2c9e7d80004b85b5f/20191031153357/image/blood-vial-cap.svg&quot;,&quot;size&quot;:{&quot;x&quot;:65,&quot;y&quot;:79},&quot;isPremium&quot;:false},&quot;source&quot;:{&quot;id&quot;:&quot;5dbafea2c9e7d80004b85b5f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5&quot;}},&quot;7481b1fa-6cb6-48fe-a710-775100739e89&quot;:{&quot;relativeTransform&quot;:{&quot;translate&quot;:{&quot;x&quot;:-548.806,&quot;y&quot;:-80.596},&quot;rotate&quot;:0,&quot;skewX&quot;:0,&quot;scale&quot;:{&quot;x&quot;:1,&quot;y&quot;:1}},&quot;type&quot;:&quot;FIGURE_OBJECT&quot;,&quot;id&quot;:&quot;7481b1fa-6cb6-48fe-a710-775100739e89&quot;,&quot;parent&quot;:{&quot;type&quot;:&quot;CHILD&quot;,&quot;parentId&quot;:&quot;228b698d-4cee-4aaf-8d74-c84d91114676&quot;,&quot;order&quot;:&quot;9998&quot;},&quot;name&quot;:&quot;Clock&quot;,&quot;displayName&quot;:&quot;Clock&quot;,&quot;source&quot;:{&quot;id&quot;:&quot;61eb03a724d1c700a3a723ca&quot;,&quot;type&quot;:&quot;ASSETS&quot;},&quot;isPremium&quot;:true},&quot;b51a099c-1383-4790-a3a8-d93f5d4b8b5b&quot;:{&quot;type&quot;:&quot;FIGURE_OBJECT&quot;,&quot;id&quot;:&quot;b51a099c-1383-4790-a3a8-d93f5d4b8b5b&quot;,&quot;parent&quot;:{&quot;type&quot;:&quot;CHILD&quot;,&quot;parentId&quot;:&quot;7481b1fa-6cb6-48fe-a710-775100739e89&quot;,&quot;order&quot;:&quot;5&quot;},&quot;relativeTransform&quot;:{&quot;translate&quot;:{&quot;x&quot;:0,&quot;y&quot;:0},&quot;rotate&quot;:0}},&quot;e8f29d53-2ec1-4399-92a2-16534b58ccad&quot;:{&quot;type&quot;:&quot;FIGURE_OBJECT&quot;,&quot;id&quot;:&quot;e8f29d53-2ec1-4399-92a2-16534b58ccad&quot;,&quot;relativeTransform&quot;:{&quot;translate&quot;:{&quot;x&quot;:189.3573041196277,&quot;y&quot;:-154.8040334618941},&quot;rotate&quot;:0},&quot;opacity&quot;:1,&quot;path&quot;:{&quot;type&quot;:&quot;POLY_LINE&quot;,&quot;points&quot;:[{&quot;x&quot;:0,&quot;y&quot;:-12.657150968338991},{&quot;x&quot;:0,&quot;y&quot;:12.657150968338991}],&quot;closed&quot;:false},&quot;pathStyles&quot;:[{&quot;type&quot;:&quot;FILL&quot;,&quot;fillStyle&quot;:&quot;rgba(0,0,0,0)&quot;},{&quot;type&quot;:&quot;STROKE&quot;,&quot;strokeStyle&quot;:&quot;rgba(61, 61, 61, 1)&quot;,&quot;lineWidth&quot;:2.5,&quot;lineJoin&quot;:&quot;round&quot;,&quot;dashArray&quot;:[0]}],&quot;isLocked&quot;:false,&quot;parent&quot;:{&quot;type&quot;:&quot;CHILD&quot;,&quot;parentId&quot;:&quot;b51a099c-1383-4790-a3a8-d93f5d4b8b5b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0cde3c1e-db5d-48c6-8c78-d02bcb0ea33a&quot;:{&quot;type&quot;:&quot;FIGURE_OBJECT&quot;,&quot;id&quot;:&quot;0cde3c1e-db5d-48c6-8c78-d02bcb0ea33a&quot;,&quot;parent&quot;:{&quot;type&quot;:&quot;CROP&quot;,&quot;parentId&quot;:&quot;b51a099c-1383-4790-a3a8-d93f5d4b8b5b&quot;,&quot;order&quot;:&quot;5&quot;},&quot;relativeTransform&quot;:{&quot;translate&quot;:{&quot;x&quot;:189.3573041196277,&quot;y&quot;:-139.4040334618941},&quot;rotate&quot;:0,&quot;skewX&quot;:0,&quot;scale&quot;:{&quot;x&quot;:1.85,&quot;y&quot;:29.407150968338986}},&quot;path&quot;:{&quot;type&quot;:&quot;RECT&quot;,&quot;size&quot;:{&quot;x&quot;:2,&quot;y&quot;:2}},&quot;pathStyles&quot;:[{&quot;type&quot;:&quot;FILL&quot;,&quot;fillStyle&quot;:&quot;#fff&quot;}],&quot;isFrozen&quot;:true},&quot;7705654d-dbc6-46b6-bce6-6280dc15caf7&quot;:{&quot;type&quot;:&quot;FIGURE_OBJECT&quot;,&quot;id&quot;:&quot;7705654d-dbc6-46b6-bce6-6280dc15caf7&quot;,&quot;parent&quot;:{&quot;type&quot;:&quot;CHILD&quot;,&quot;parentId&quot;:&quot;7481b1fa-6cb6-48fe-a710-775100739e89&quot;,&quot;order&quot;:&quot;7&quot;},&quot;relativeTransform&quot;:{&quot;translate&quot;:{&quot;x&quot;:0,&quot;y&quot;:0},&quot;rotate&quot;:0}},&quot;25822147-62ea-4acf-a377-5ceec3b33d2c&quot;:{&quot;type&quot;:&quot;FIGURE_OBJECT&quot;,&quot;id&quot;:&quot;25822147-62ea-4acf-a377-5ceec3b33d2c&quot;,&quot;relativeTransform&quot;:{&quot;translate&quot;:{&quot;x&quot;:205.1143635164609,&quot;y&quot;:-139.4474797871799},&quot;rotate&quot;:1.5707963267948966},&quot;opacity&quot;:1,&quot;path&quot;:{&quot;type&quot;:&quot;POLY_LINE&quot;,&quot;points&quot;:[{&quot;x&quot;:-0.2074942849213386,&quot;y&quot;:-6.6398167056200155},{&quot;x&quot;:0,&quot;y&quot;:12.657150968338991}],&quot;closed&quot;:false},&quot;pathStyles&quot;:[{&quot;type&quot;:&quot;FILL&quot;,&quot;fillStyle&quot;:&quot;rgba(0,0,0,0)&quot;},{&quot;type&quot;:&quot;STROKE&quot;,&quot;strokeStyle&quot;:&quot;rgba(61, 61, 61, 1)&quot;,&quot;lineWidth&quot;:2.5,&quot;lineJoin&quot;:&quot;round&quot;,&quot;dashArray&quot;:[0]}],&quot;isLocked&quot;:false,&quot;parent&quot;:{&quot;type&quot;:&quot;CHILD&quot;,&quot;parentId&quot;:&quot;7705654d-dbc6-46b6-bce6-6280dc15caf7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8ead36af-d5c0-4972-b481-c4fdae9ed34c&quot;:{&quot;type&quot;:&quot;FIGURE_OBJECT&quot;,&quot;id&quot;:&quot;8ead36af-d5c0-4972-b481-c4fdae9ed34c&quot;,&quot;parent&quot;:{&quot;type&quot;:&quot;CROP&quot;,&quot;parentId&quot;:&quot;7705654d-dbc6-46b6-bce6-6280dc15caf7&quot;,&quot;order&quot;:&quot;5&quot;},&quot;relativeTransform&quot;:{&quot;translate&quot;:{&quot;x&quot;:189.8056963851014,&quot;y&quot;:-139.55122692964056},&quot;rotate&quot;:0,&quot;skewX&quot;:0,&quot;scale&quot;:{&quot;x&quot;:23.496610265749162,&quot;y&quot;:1.6518735712303312}},&quot;path&quot;:{&quot;type&quot;:&quot;RECT&quot;,&quot;size&quot;:{&quot;x&quot;:2,&quot;y&quot;:2}},&quot;pathStyles&quot;:[{&quot;type&quot;:&quot;FILL&quot;,&quot;fillStyle&quot;:&quot;#fff&quot;}],&quot;isFrozen&quot;:true},&quot;e68872fb-aab0-4c06-9100-f0883069a56c&quot;:{&quot;id&quot;:&quot;e68872fb-aab0-4c06-9100-f0883069a56c&quot;,&quot;name&quot;:&quot;Clock (no hands)&quot;,&quot;type&quot;:&quot;FIGURE_OBJECT&quot;,&quot;relativeTransform&quot;:{&quot;translate&quot;:{&quot;x&quot;:189.80600000000004,&quot;y&quot;:-139.404},&quot;rotate&quot;:0,&quot;skewX&quot;:0,&quot;scale&quot;:{&quot;x&quot;:1,&quot;y&quot;:1}},&quot;image&quot;:{&quot;url&quot;:&quot;https://icons.biorender.com/biorender/61eafb6fa57cec0029a1480b/20220121183627/image/clock-no-hands-1.png&quot;,&quot;fallbackUrl&quot;:&quot;https://res.cloudinary.com/dlcjuc3ej/image/upload/v1642790187/jnm2u1bo1dpkmdmlx92k.svg#/keystone/api/icons/61eafb6fa57cec0029a1480b/20220121183627/image/clock-no-hands-1.svg&quot;,&quot;isPremium&quot;:false,&quot;isPacked&quot;:true,&quot;size&quot;:{&quot;x&quot;:100,&quot;y&quot;:100}},&quot;source&quot;:{&quot;id&quot;:&quot;61eafb6fa57cec0029a1480b&quot;,&quot;type&quot;:&quot;ASSETS&quot;},&quot;isPremium&quot;:false,&quot;parent&quot;:{&quot;type&quot;:&quot;CHILD&quot;,&quot;parentId&quot;:&quot;7481b1fa-6cb6-48fe-a710-775100739e89&quot;,&quot;order&quot;:&quot;2&quot;}},&quot;8ec2639d-7aa5-4bae-9926-529cfcbfacfa&quot;:{&quot;type&quot;:&quot;FIGURE_OBJECT&quot;,&quot;id&quot;:&quot;8ec2639d-7aa5-4bae-9926-529cfcbfacfa&quot;,&quot;relativeTransform&quot;:{&quot;translate&quot;:{&quot;x&quot;:-356.2141448486328,&quot;y&quot;:-216.85584146728516},&quot;rotate&quot;:0,&quot;skewX&quot;:0,&quot;scale&quot;:{&quot;x&quot;:0.79,&quot;y&quot;:0.79}},&quot;opacity&quot;:1,&quot;source&quot;:{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9&quot;}},&quot;42beb668-011a-4f33-acce-f24f3f00b276&quot;:{&quot;type&quot;:&quot;FIGURE_OBJECT&quot;,&quot;id&quot;:&quot;42beb668-011a-4f33-acce-f24f3f00b276&quot;,&quot;relativeTransform&quot;:{&quot;translate&quot;:{&quot;x&quot;:9.568657805025573,&quot;y&quot;:67.98753325297047},&quot;rotate&quot;:0,&quot;skewX&quot;:0,&quot;scale&quot;:{&quot;x&quot;:1,&quot;y&quot;:1}},&quot;opacity&quot;:1,&quot;path&quot;:{&quot;type&quot;:&quot;POLY_LINE&quot;,&quot;points&quot;:[{&quot;x&quot;:-57.21865780502557,&quot;y&quot;:5.222466747029529},{&quot;x&quot;:3.447629105299715,&quot;y&quot;:14.727387500866172},{&quot;x&quot;:57.21865780502558,&quot;y&quot;:-18.375794573561436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1&quot;}},&quot;c3965932-a251-46c9-91ee-694c432c3a6b&quot;:{&quot;type&quot;:&quot;FIGURE_OBJECT&quot;,&quot;id&quot;:&quot;c3965932-a251-46c9-91ee-694c432c3a6b&quot;,&quot;relativeTransform&quot;:{&quot;translate&quot;:{&quot;x&quot;:63.642415150172965,&quot;y&quot;:-22.603506741225722},&quot;rotate&quot;:0,&quot;skewX&quot;:0,&quot;scale&quot;:{&quot;x&quot;:1,&quot;y&quot;:1}},&quot;opacity&quot;:1,&quot;path&quot;:{&quot;type&quot;:&quot;POLY_LINE&quot;,&quot;points&quot;:[{&quot;x&quot;:11.87758484982703,&quot;y&quot;:59.07350674122572},{&quot;x&quot;:16.80114955627178,&quot;y&quot;:-8.177406785637139},{&quot;x&quot;:-22.788566480644,&quot;y&quot;:-59.07350674122572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2&quot;}},&quot;f2defbbd-11ca-4b6c-8dcb-e22638ad41c8&quot;:{&quot;type&quot;:&quot;FIGURE_OBJECT&quot;,&quot;id&quot;:&quot;f2defbbd-11ca-4b6c-8dcb-e22638ad41c8&quot;,&quot;relativeTransform&quot;:{&quot;translate&quot;:{&quot;x&quot;:-33.74439927369357,&quot;y&quot;:-69.20847869470347},&quot;rotate&quot;:0,&quot;skewX&quot;:0,&quot;scale&quot;:{&quot;x&quot;:1,&quot;y&quot;:1}},&quot;opacity&quot;:1,&quot;path&quot;:{&quot;type&quot;:&quot;POLY_LINE&quot;,&quot;points&quot;:[{&quot;x&quot;:50.74439927369357,&quot;y&quot;:-21.261521305296526},{&quot;x&quot;:-10.393001779168841,&quot;y&quot;:-15.722465712878815},{&quot;x&quot;:-50.74439927369357,&quot;y&quot;:25.312225478436844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5&quot;}},&quot;7efad75f-dc2a-4504-85a2-b45203b45ee1&quot;:{&quot;type&quot;:&quot;FIGURE_OBJECT&quot;,&quot;id&quot;:&quot;7efad75f-dc2a-4504-85a2-b45203b45ee1&quot;,&quot;relativeTransform&quot;:{&quot;translate&quot;:{&quot;x&quot;:-77.75747291427902,&quot;y&quot;:19.107910461425778},&quot;rotate&quot;:0,&quot;skewX&quot;:0,&quot;scale&quot;:{&quot;x&quot;:1,&quot;y&quot;:1}},&quot;opacity&quot;:1,&quot;path&quot;:{&quot;type&quot;:&quot;POLY_LINE&quot;,&quot;points&quot;:[{&quot;x&quot;:-12.812527085720973,&quot;y&quot;:-47.22791046142578},{&quot;x&quot;:-11.00116428512284,&quot;y&quot;:4.328242034912108},{&quot;x&quot;:16.80452567917159,&quot;y&quot;:47.22791046142578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7&quot;}}}}"/>
  <p:tag name="TRANSPARENTBACKGROUND" val="true"/>
  <p:tag name="VERSION" val="1773845082006"/>
  <p:tag name="TITLE" val="Untitled"/>
  <p:tag name="CREATORNAME" val="Samson Cantor"/>
  <p:tag name="DATEINSERTED" val="1773845100897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,&quot;715bbc95-2221-48e5-a0b2-e1ae84faa96a&quot;:{&quot;id&quot;:&quot;715bbc95-2221-48e5-a0b2-e1ae84faa96a&quot;,&quot;name&quot;:&quot;Glucose meter&quot;,&quot;displayName&quot;:&quot;&quot;,&quot;type&quot;:&quot;FIGURE_OBJECT&quot;,&quot;relativeTransform&quot;:{&quot;translate&quot;:{&quot;x&quot;:-374.8627450980392,&quot;y&quot;:127.5},&quot;rotate&quot;:0,&quot;skewX&quot;:0,&quot;scale&quot;:{&quot;x&quot;:0.2551633986928105,&quot;y&quot;:0.2551633986928105}},&quot;image&quot;:{&quot;url&quot;:&quot;https://icons.cdn.biorender.com/biorender/5cc36f64df35f43300d5ab9e/20190426205306/image/5cc36f64df35f43300d5ab9e.png&quot;,&quot;isPremium&quot;:false,&quot;isOrgIcon&quot;:false,&quot;size&quot;:{&quot;x&quot;:150,&quot;y&quot;:310.13513513513516}},&quot;source&quot;:{&quot;id&quot;:&quot;5cc36f64df35f43300d5ab9e&quot;,&quot;version&quot;:&quot;20190426205306&quot;,&quot;type&quot;:&quot;ASSETS&quot;},&quot;isPremium&quot;:false,&quot;parent&quot;:{&quot;type&quot;:&quot;CHILD&quot;,&quot;parentId&quot;:&quot;228b698d-4cee-4aaf-8d74-c84d91114676&quot;,&quot;order&quot;:&quot;97&quot;}},&quot;5f9c25af-4e61-4d01-a7f9-bc96f00ec0a3&quot;:{&quot;id&quot;:&quot;5f9c25af-4e61-4d01-a7f9-bc96f00ec0a3&quot;,&quot;name&quot;:&quot;Child 3 (head, gender-neutral, stage I obesity, anterior)&quot;,&quot;displayName&quot;:&quot;&quot;,&quot;type&quot;:&quot;FIGURE_OBJECT&quot;,&quot;relativeTransform&quot;:{&quot;translate&quot;:{&quot;x&quot;:-294,&quot;y&quot;:145},&quot;rotate&quot;:0,&quot;skewX&quot;:0,&quot;scale&quot;:{&quot;x&quot;:1,&quot;y&quot;:1}},&quot;image&quot;:{&quot;url&quot;:&quot;https://icons.cdn.biorender.com/biorender/671a9e69bdca4c36b346d6be/671a9e50bdca4c36b346d679.png&quot;,&quot;isPremium&quot;:true,&quot;isOrgIcon&quot;:false,&quot;size&quot;:{&quot;x&quot;:150,&quot;y&quot;:140.3485254691689},&quot;fallbackUrl&quot;:&quot;sources/icons/671a9e69bdca4c36b346d6be/671a9e50bdca4c36b346d679.svg&quot;},&quot;source&quot;:{&quot;id&quot;:&quot;671a9e50bdca4c36b346d679&quot;,&quot;version&quot;:&quot;20241024192203&quot;,&quot;type&quot;:&quot;ASSETS&quot;},&quot;isPremium&quot;:true,&quot;parent&quot;:{&quot;type&quot;:&quot;CHILD&quot;,&quot;parentId&quot;:&quot;228b698d-4cee-4aaf-8d74-c84d91114676&quot;,&quot;order&quot;:&quot;98&quot;}},&quot;3bbfb5a3-190d-4c8e-8632-87cfbfcbc871&quot;:{&quot;relativeTransform&quot;:{&quot;translate&quot;:{&quot;x&quot;:-149.81948063774848,&quot;y&quot;:364.7558646383225},&quot;rotate&quot;:0,&quot;skewX&quot;:0,&quot;scale&quot;:{&quot;x&quot;:1,&quot;y&quot;:1}},&quot;type&quot;:&quot;FIGURE_OBJECT&quot;,&quot;id&quot;:&quot;3bbfb5a3-190d-4c8e-8632-87cfbfcbc871&quot;,&quot;parent&quot;:{&quot;type&quot;:&quot;CHILD&quot;,&quot;parentId&quot;:&quot;228b698d-4cee-4aaf-8d74-c84d91114676&quot;,&quot;order&quot;:&quot;99&quot;},&quot;name&quot;:&quot;Pill cluster&quot;,&quot;displayName&quot;:&quot;Pill cluster&quot;,&quot;source&quot;:{&quot;id&quot;:&quot;608aeff9ac44b300a20aaf63&quot;,&quot;type&quot;:&quot;ASSETS&quot;},&quot;isPremium&quot;:true},&quot;69882f09-baa4-49ed-abcd-6bf96fb71bd7&quot;:{&quot;id&quot;:&quot;69882f09-baa4-49ed-abcd-6bf96fb71bd7&quot;,&quot;name&quot;:&quot;Pill&quot;,&quot;type&quot;:&quot;FIGURE_OBJECT&quot;,&quot;relativeTransform&quot;:{&quot;translate&quot;:{&quot;x&quot;:-54.567779158393485,&quot;y&quot;:-259.7289704286371},&quot;rotate&quot;:-0.22017744070666753,&quot;skewX&quot;:0,&quot;scale&quot;:{&quot;x&quot;:0.55162259114342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2&quot;}},&quot;ffc78527-3a89-4f6b-b297-88c031402b45&quot;:{&quot;id&quot;:&quot;ffc78527-3a89-4f6b-b297-88c031402b45&quot;,&quot;name&quot;:&quot;Pill&quot;,&quot;type&quot;:&quot;FIGURE_OBJECT&quot;,&quot;relativeTransform&quot;:{&quot;translate&quot;:{&quot;x&quot;:-38.0779636962714,&quot;y&quot;:-232.27741754225076},&quot;rotate&quot;:2.731657600636832,&quot;skewX&quot;:9.12149764969962e-17,&quot;scale&quot;:{&quot;x&quot;:0.551622591143428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5&quot;},&quot;opacity&quot;:0.78},&quot;ee11c06a-3576-4aa5-bb01-3a4c719cd33b&quot;:{&quot;id&quot;:&quot;ee11c06a-3576-4aa5-bb01-3a4c719cd33b&quot;,&quot;name&quot;:&quot;Pill&quot;,&quot;type&quot;:&quot;FIGURE_OBJECT&quot;,&quot;relativeTransform&quot;:{&quot;translate&quot;:{&quot;x&quot;:-52.58371747724082,&quot;y&quot;:-214.37741536307334},&quot;rotate&quot;:-7.642229304742056e-17,&quot;skewX&quot;:-7.642229304742057e-17,&quot;scale&quot;:{&quot;x&quot;:0.5516225911434285,&quot;y&quot;:0.5516225911434287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7&quot;}},&quot;dbf3c7e6-af9c-4614-aaa1-0ec60faa16bc&quot;:{&quot;id&quot;:&quot;dbf3c7e6-af9c-4614-aaa1-0ec60faa16bc&quot;,&quot;name&quot;:&quot;Absorption (ADMET, symbol)&quot;,&quot;displayName&quot;:&quot;&quot;,&quot;type&quot;:&quot;FIGURE_OBJECT&quot;,&quot;relativeTransform&quot;:{&quot;translate&quot;:{&quot;x&quot;:-86,&quot;y&quot;:-114.67426273458443},&quot;rotate&quot;:0,&quot;skewX&quot;:0,&quot;scale&quot;:{&quot;x&quot;:1,&quot;y&quot;:1}},&quot;image&quot;:{&quot;url&quot;:&quot;https://icons.cdn.biorender.com/biorender/67f5906e8036a7aacbd4cedb/20250408211342/image/67f5906e8036a7aacbd4cedb.png&quot;,&quot;isPremium&quot;:false,&quot;isOrgIcon&quot;:false,&quot;size&quot;:{&quot;x&quot;:100,&quot;y&quot;:100}},&quot;source&quot;:{&quot;id&quot;:&quot;67f5906e8036a7aacbd4cedb&quot;,&quot;version&quot;:&quot;20250408211342&quot;,&quot;type&quot;:&quot;ASSETS&quot;},&quot;isPremium&quot;:false,&quot;parent&quot;:{&quot;type&quot;:&quot;CHILD&quot;,&quot;parentId&quot;:&quot;228b698d-4cee-4aaf-8d74-c84d91114676&quot;,&quot;order&quot;:&quot;995&quot;}},&quot;64a73b3b-f713-499c-8bb0-94022021977b&quot;:{&quot;id&quot;:&quot;64a73b3b-f713-499c-8bb0-94022021977b&quot;,&quot;name&quot;:&quot;Metabolism (ADMET, symbol)&quot;,&quot;displayName&quot;:&quot;&quot;,&quot;type&quot;:&quot;FIGURE_OBJECT&quot;,&quot;relativeTransform&quot;:{&quot;translate&quot;:{&quot;x&quot;:25,&quot;y&quot;:-116.67426273458443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97&quot;}},&quot;ac397bb5-a291-43a5-8402-3dd47a8fd2de&quot;:{&quot;id&quot;:&quot;ac397bb5-a291-43a5-8402-3dd47a8fd2de&quot;,&quot;name&quot;:&quot;Excretion (ADMET, symbol)&quot;,&quot;displayName&quot;:&quot;&quot;,&quot;type&quot;:&quot;FIGURE_OBJECT&quot;,&quot;relativeTransform&quot;:{&quot;translate&quot;:{&quot;x&quot;:124,&quot;y&quot;:-117.67426273458443},&quot;rotate&quot;:0,&quot;skewX&quot;:0,&quot;scale&quot;:{&quot;x&quot;:1,&quot;y&quot;:1}},&quot;image&quot;:{&quot;url&quot;:&quot;https://icons.cdn.biorender.com/biorender/67f5952f8036a7aacbd4d1e9/20250408212945/image/67f5952f8036a7aacbd4d1e9.png&quot;,&quot;isPremium&quot;:false,&quot;isOrgIcon&quot;:false,&quot;size&quot;:{&quot;x&quot;:100,&quot;y&quot;:100}},&quot;source&quot;:{&quot;id&quot;:&quot;67f5952f8036a7aacbd4d1e9&quot;,&quot;version&quot;:&quot;20250408212945&quot;,&quot;type&quot;:&quot;ASSETS&quot;},&quot;isPremium&quot;:false,&quot;parent&quot;:{&quot;type&quot;:&quot;CHILD&quot;,&quot;parentId&quot;:&quot;228b698d-4cee-4aaf-8d74-c84d91114676&quot;,&quot;order&quot;:&quot;998&quot;}},&quot;be10db81-2c63-4af8-9a80-2e62a491e20b&quot;:{&quot;relativeTransform&quot;:{&quot;translate&quot;:{&quot;x&quot;:195.54388195061262,&quot;y&quot;:-34.44402995059181},&quot;rotate&quot;:0,&quot;skewX&quot;:0,&quot;scale&quot;:{&quot;x&quot;:1,&quot;y&quot;:1}},&quot;type&quot;:&quot;FIGURE_OBJECT&quot;,&quot;id&quot;:&quot;be10db81-2c63-4af8-9a80-2e62a491e20b&quot;,&quot;parent&quot;:{&quot;type&quot;:&quot;CHILD&quot;,&quot;parentId&quot;:&quot;228b698d-4cee-4aaf-8d74-c84d91114676&quot;,&quot;order&quot;:&quot;999&quot;},&quot;name&quot;:&quot;Adult male head (lateral, taking oral medication)&quot;,&quot;displayName&quot;:&quot;Adult male head (lateral, taking oral medication)&quot;,&quot;source&quot;:{&quot;id&quot;:&quot;63bc4d3e69764ef572715e51&quot;,&quot;type&quot;:&quot;ASSETS&quot;},&quot;isPremium&quot;:true},&quot;5ea02427-5ca5-48b7-ba18-a6b04e8fa193&quot;:{&quot;id&quot;:&quot;5ea02427-5ca5-48b7-ba18-a6b04e8fa193&quot;,&quot;name&quot;:&quot;Adult male head (lateral, open mouth)&quot;,&quot;displayName&quot;:&quot;&quot;,&quot;type&quot;:&quot;FIGURE_OBJECT&quot;,&quot;relativeTransform&quot;:{&quot;translate&quot;:{&quot;x&quot;:-44.69765631434586,&quot;y&quot;:181.4440299505918},&quot;rotate&quot;:0,&quot;skewX&quot;:0,&quot;scale&quot;:{&quot;x&quot;:1,&quot;y&quot;:1}},&quot;image&quot;:{&quot;url&quot;:&quot;https://icons.biorender.com/biorender/5ecd2dd9fc86fd00280efee8/20200526150009/image/adult-male-head-lateral-open-mouth.png&quot;,&quot;fallbackUrl&quot;:&quot;https://res.cloudinary.com/dlcjuc3ej/image/upload/v1590505209/cy467owkhsyjy1wjgwgy.svg#/keystone/api/icons/5ecd2dd9fc86fd00280efee8/20200526150009/image/adult-male-head-lateral-open-mouth.svg&quot;,&quot;isPremium&quot;:true,&quot;size&quot;:{&quot;x&quot;:100,&quot;y&quot;:145.95744680851064}},&quot;source&quot;:{&quot;id&quot;:&quot;5ecd2dd9fc86fd00280efee8&quot;,&quot;type&quot;:&quot;ASSETS&quot;},&quot;isPremium&quot;:true,&quot;parent&quot;:{&quot;type&quot;:&quot;CHILD&quot;,&quot;parentId&quot;:&quot;be10db81-2c63-4af8-9a80-2e62a491e20b&quot;,&quot;order&quot;:&quot;2&quot;}},&quot;2d92d51c-362e-4192-a6f0-afdf04b10350&quot;:{&quot;relativeTransform&quot;:{&quot;translate&quot;:{&quot;x&quot;:-108.89939975206015,&quot;y&quot;:269.268809325843},&quot;rotate&quot;:0,&quot;skewX&quot;:0,&quot;scale&quot;:{&quot;x&quot;:1,&quot;y&quot;:1}},&quot;type&quot;:&quot;FIGURE_OBJECT&quot;,&quot;id&quot;:&quot;2d92d51c-362e-4192-a6f0-afdf04b10350&quot;,&quot;parent&quot;:{&quot;type&quot;:&quot;CHILD&quot;,&quot;parentId&quot;:&quot;be10db81-2c63-4af8-9a80-2e62a491e20b&quot;,&quot;order&quot;:&quot;5&quot;},&quot;name&quot;:&quot;Pill cluster&quot;,&quot;displayName&quot;:&quot;Pill cluster&quot;,&quot;source&quot;:{&quot;id&quot;:&quot;608aeff9ac44b300a20aaf63&quot;,&quot;type&quot;:&quot;ASSETS&quot;},&quot;isPremium&quot;:true},&quot;bd97b65a-b41e-46e2-b85d-b1bdb8a18e50&quot;:{&quot;id&quot;:&quot;bd97b65a-b41e-46e2-b85d-b1bdb8a18e50&quot;,&quot;name&quot;:&quot;Pill&quot;,&quot;type&quot;:&quot;FIGURE_OBJECT&quot;,&quot;relativeTransform&quot;:{&quot;translate&quot;:{&quot;x&quot;:-14.310552926061176,&quot;y&quot;:-87.29506398454491},&quot;rotate&quot;:2.731657600636832,&quot;skewX&quot;:8.072550417700369e-17,&quot;scale&quot;:{&quot;x&quot;:0.20731214380936094,&quot;y&quot;:0.20731214380936125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5&quot;},&quot;opacity&quot;:0.78},&quot;2bd74ecf-0680-441a-ba07-3bf38a42c93e&quot;:{&quot;id&quot;:&quot;2bd74ecf-0680-441a-ba07-3bf38a42c93e&quot;,&quot;name&quot;:&quot;Pill&quot;,&quot;type&quot;:&quot;FIGURE_OBJECT&quot;,&quot;relativeTransform&quot;:{&quot;translate&quot;:{&quot;x&quot;:-19.762140591588093,&quot;y&quot;:-80.56784163082403},&quot;rotate&quot;:-7.642229304742056e-17,&quot;skewX&quot;:-7.642229304742064e-17,&quot;scale&quot;:{&quot;x&quot;:0.20731214380936086,&quot;y&quot;:0.2073121438093609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7&quot;}},&quot;4e9da238-c226-4237-9fff-754465ad1147&quot;:{&quot;id&quot;:&quot;4e9da238-c226-4237-9fff-754465ad1147&quot;,&quot;name&quot;:&quot;Pill&quot;,&quot;type&quot;:&quot;FIGURE_OBJECT&quot;,&quot;relativeTransform&quot;:{&quot;translate&quot;:{&quot;x&quot;:-20.507795478051605,&quot;y&quot;:-97.61197335545403},&quot;rotate&quot;:-0.2201774407066676,&quot;skewX&quot;:0,&quot;scale&quot;:{&quot;x&quot;:0.20731214380936067,&quot;y&quot;:0.207312143809361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2&quot;}},&quot;34dbf796-49a7-4ab6-adb2-dfb7c143995c&quot;:{&quot;type&quot;:&quot;FIGURE_OBJECT&quot;,&quot;id&quot;:&quot;34dbf796-49a7-4ab6-adb2-dfb7c143995c&quot;,&quot;relativeTransform&quot;:{&quot;translate&quot;:{&quot;x&quot;:-97.31827780975603,&quot;y&quot;:179.09500275996288},&quot;rotate&quot;:0,&quot;skewX&quot;:0,&quot;scale&quot;:{&quot;x&quot;:1,&quot;y&quot;:1}},&quot;opacity&quot;:1,&quot;path&quot;:{&quot;type&quot;:&quot;POLY_LINE&quot;,&quot;points&quot;:[{&quot;x&quot;:-12.144126817834582,&quot;y&quot;:0},{&quot;x&quot;:-0.8333192585170209,&quot;y&quot;:0},{&quot;x&quot;:12.14412681783459,&quot;y&quot;:0}],&quot;closed&quot;:false,&quot;cornerRounding&quot;:{&quot;type&quot;:&quot;ARC_LENGTH&quot;,&quot;global&quot;:58.813885746365806}},&quot;pathStyles&quot;:[{&quot;type&quot;:&quot;FILL&quot;,&quot;fillStyle&quot;:&quot;transparent&quot;},{&quot;type&quot;:&quot;STROKE&quot;,&quot;strokeStyle&quot;:&quot;#232323&quot;,&quot;lineWidth&quot;:1.348508802440510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e10db81-2c63-4af8-9a80-2e62a491e20b&quot;,&quot;order&quot;:&quot;7&quot;}},&quot;40426b1f-f4a2-48f4-9ae7-77808da3515c&quot;:{&quot;id&quot;:&quot;40426b1f-f4a2-48f4-9ae7-77808da3515c&quot;,&quot;name&quot;:&quot;Adult (gender-neutral, lateral, taking pill) &quot;,&quot;displayName&quot;:&quot;&quot;,&quot;type&quot;:&quot;FIGURE_OBJECT&quot;,&quot;relativeTransform&quot;:{&quot;translate&quot;:{&quot;x&quot;:-221,&quot;y&quot;:-122},&quot;rotate&quot;:0,&quot;skewX&quot;:0,&quot;scale&quot;:{&quot;x&quot;:1,&quot;y&quot;:1}},&quot;image&quot;:{&quot;url&quot;:&quot;https://icons.cdn.biorender.com/biorender/672d005c9105801996905713/672ce05854021394a7d1b3c5.png&quot;,&quot;isPremium&quot;:false,&quot;isOrgIcon&quot;:false,&quot;size&quot;:{&quot;x&quot;:150,&quot;y&quot;:140.3485254691689},&quot;fallbackUrl&quot;:&quot;sources/icons/672d005c9105801996905713/672ce05854021394a7d1b3c5.svg&quot;},&quot;source&quot;:{&quot;id&quot;:&quot;672ce05854021394a7d1b3c5&quot;,&quot;version&quot;:&quot;20241107180047&quot;,&quot;type&quot;:&quot;ASSETS&quot;},&quot;isPremium&quot;:false,&quot;parent&quot;:{&quot;type&quot;:&quot;CHILD&quot;,&quot;parentId&quot;:&quot;228b698d-4cee-4aaf-8d74-c84d91114676&quot;,&quot;order&quot;:&quot;9995&quot;}},&quot;051254f3-c91c-46d4-904a-4f56f1f36c6c&quot;:{&quot;relativeTransform&quot;:{&quot;translate&quot;:{&quot;x&quot;:266.29771864996013,&quot;y&quot;:-129},&quot;rotate&quot;:0},&quot;type&quot;:&quot;FIGURE_OBJECT&quot;,&quot;id&quot;:&quot;051254f3-c91c-46d4-904a-4f56f1f36c6c&quot;,&quot;name&quot;:&quot;Blood vial (with blood and label, capped)&quot;,&quot;displayName&quot;:&quot;Blood vial (with blood and label, capped)&quot;,&quot;opacity&quot;:1,&quot;source&quot;:{&quot;id&quot;:&quot;5dbb01b84ef0b000810d2b0e&quot;,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7&quot;},&quot;isPremium&quot;:true},&quot;ed197ed7-7fe7-4847-881d-92ed223786f5&quot;:{&quot;type&quot;:&quot;FIGURE_OBJECT&quot;,&quot;id&quot;:&quot;ed197ed7-7fe7-4847-881d-92ed223786f5&quot;,&quot;name&quot;:&quot;Blood vial (labelled)&quot;,&quot;relativeTransform&quot;:{&quot;translate&quot;:{&quot;x&quot;:2.0318280249341756e-15,&quot;y&quot;:12.889965271685073},&quot;rotate&quot;:0,&quot;skewX&quot;:0,&quot;scale&quot;:{&quot;x&quot;:0.439929804614158,&quot;y&quot;:0.4399298046141579}},&quot;opacity&quot;:1,&quot;image&quot;:{&quot;url&quot;:&quot;https://res.cloudinary.com/dlcjuc3ej/image/upload/v1572535485/xokmqyvumsqposaheemj.svg#/keystone/api/icons/5dbafc93c9e7d80004b85b52/20191031152445/image/blood-vial-labelled.svg&quot;,&quot;fallbackUrl&quot;:&quot;https://res.cloudinary.com/dlcjuc3ej/image/upload/v1572535485/xokmqyvumsqposaheemj.svg#/keystone/api/icons/5dbafc93c9e7d80004b85b52/20191031152445/image/blood-vial-labelled.svg&quot;,&quot;size&quot;:{&quot;x&quot;:65,&quot;y&quot;:239},&quot;isPremium&quot;:false},&quot;source&quot;:{&quot;id&quot;:&quot;5dbafc93c9e7d80004b85b52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2&quot;}},&quot;0fbbfeea-2f9a-462e-b3dc-ddbe005602ac&quot;:{&quot;type&quot;:&quot;FIGURE_OBJECT&quot;,&quot;id&quot;:&quot;0fbbfeea-2f9a-462e-b3dc-ddbe005602ac&quot;,&quot;name&quot;:&quot;Blood vial cap&quot;,&quot;relativeTransform&quot;:{&quot;translate&quot;:{&quot;x&quot;:0,&quot;y&quot;:-48.08434964081768},&quot;rotate&quot;:0,&quot;skewX&quot;:0,&quot;scale&quot;:{&quot;x&quot;:0.4399298046141579,&quot;y&quot;:0.4399298046141579}},&quot;opacity&quot;:1,&quot;image&quot;:{&quot;url&quot;:&quot;https://icons.biorender.com/biorender/5dbafea2c9e7d80004b85b5f/20191031153357/image/blood-vial-cap.png&quot;,&quot;fallbackUrl&quot;:&quot;https://res.cloudinary.com/dlcjuc3ej/image/upload/v1572536037/xpaz3jnhluv07ckoqfe9.svg#/keystone/api/icons/5dbafea2c9e7d80004b85b5f/20191031153357/image/blood-vial-cap.svg&quot;,&quot;size&quot;:{&quot;x&quot;:65,&quot;y&quot;:79},&quot;isPremium&quot;:false},&quot;source&quot;:{&quot;id&quot;:&quot;5dbafea2c9e7d80004b85b5f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5&quot;}},&quot;7481b1fa-6cb6-48fe-a710-775100739e89&quot;:{&quot;relativeTransform&quot;:{&quot;translate&quot;:{&quot;x&quot;:-548.806,&quot;y&quot;:-80.596},&quot;rotate&quot;:0,&quot;skewX&quot;:0,&quot;scale&quot;:{&quot;x&quot;:1,&quot;y&quot;:1}},&quot;type&quot;:&quot;FIGURE_OBJECT&quot;,&quot;id&quot;:&quot;7481b1fa-6cb6-48fe-a710-775100739e89&quot;,&quot;parent&quot;:{&quot;type&quot;:&quot;CHILD&quot;,&quot;parentId&quot;:&quot;228b698d-4cee-4aaf-8d74-c84d91114676&quot;,&quot;order&quot;:&quot;9998&quot;},&quot;name&quot;:&quot;Clock&quot;,&quot;displayName&quot;:&quot;Clock&quot;,&quot;source&quot;:{&quot;id&quot;:&quot;61eb03a724d1c700a3a723ca&quot;,&quot;type&quot;:&quot;ASSETS&quot;},&quot;isPremium&quot;:true},&quot;b51a099c-1383-4790-a3a8-d93f5d4b8b5b&quot;:{&quot;type&quot;:&quot;FIGURE_OBJECT&quot;,&quot;id&quot;:&quot;b51a099c-1383-4790-a3a8-d93f5d4b8b5b&quot;,&quot;parent&quot;:{&quot;type&quot;:&quot;CHILD&quot;,&quot;parentId&quot;:&quot;7481b1fa-6cb6-48fe-a710-775100739e89&quot;,&quot;order&quot;:&quot;5&quot;},&quot;relativeTransform&quot;:{&quot;translate&quot;:{&quot;x&quot;:0,&quot;y&quot;:0},&quot;rotate&quot;:0}},&quot;e8f29d53-2ec1-4399-92a2-16534b58ccad&quot;:{&quot;type&quot;:&quot;FIGURE_OBJECT&quot;,&quot;id&quot;:&quot;e8f29d53-2ec1-4399-92a2-16534b58ccad&quot;,&quot;relativeTransform&quot;:{&quot;translate&quot;:{&quot;x&quot;:189.3573041196277,&quot;y&quot;:-154.8040334618941},&quot;rotate&quot;:0},&quot;opacity&quot;:1,&quot;path&quot;:{&quot;type&quot;:&quot;POLY_LINE&quot;,&quot;points&quot;:[{&quot;x&quot;:0,&quot;y&quot;:-12.657150968338991},{&quot;x&quot;:0,&quot;y&quot;:12.657150968338991}],&quot;closed&quot;:false},&quot;pathStyles&quot;:[{&quot;type&quot;:&quot;FILL&quot;,&quot;fillStyle&quot;:&quot;rgba(0,0,0,0)&quot;},{&quot;type&quot;:&quot;STROKE&quot;,&quot;strokeStyle&quot;:&quot;rgba(61, 61, 61, 1)&quot;,&quot;lineWidth&quot;:2.5,&quot;lineJoin&quot;:&quot;round&quot;,&quot;dashArray&quot;:[0]}],&quot;isLocked&quot;:false,&quot;parent&quot;:{&quot;type&quot;:&quot;CHILD&quot;,&quot;parentId&quot;:&quot;b51a099c-1383-4790-a3a8-d93f5d4b8b5b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0cde3c1e-db5d-48c6-8c78-d02bcb0ea33a&quot;:{&quot;type&quot;:&quot;FIGURE_OBJECT&quot;,&quot;id&quot;:&quot;0cde3c1e-db5d-48c6-8c78-d02bcb0ea33a&quot;,&quot;parent&quot;:{&quot;type&quot;:&quot;CROP&quot;,&quot;parentId&quot;:&quot;b51a099c-1383-4790-a3a8-d93f5d4b8b5b&quot;,&quot;order&quot;:&quot;5&quot;},&quot;relativeTransform&quot;:{&quot;translate&quot;:{&quot;x&quot;:189.3573041196277,&quot;y&quot;:-139.4040334618941},&quot;rotate&quot;:0,&quot;skewX&quot;:0,&quot;scale&quot;:{&quot;x&quot;:1.85,&quot;y&quot;:29.407150968338986}},&quot;path&quot;:{&quot;type&quot;:&quot;RECT&quot;,&quot;size&quot;:{&quot;x&quot;:2,&quot;y&quot;:2}},&quot;pathStyles&quot;:[{&quot;type&quot;:&quot;FILL&quot;,&quot;fillStyle&quot;:&quot;#fff&quot;}],&quot;isFrozen&quot;:true},&quot;7705654d-dbc6-46b6-bce6-6280dc15caf7&quot;:{&quot;type&quot;:&quot;FIGURE_OBJECT&quot;,&quot;id&quot;:&quot;7705654d-dbc6-46b6-bce6-6280dc15caf7&quot;,&quot;parent&quot;:{&quot;type&quot;:&quot;CHILD&quot;,&quot;parentId&quot;:&quot;7481b1fa-6cb6-48fe-a710-775100739e89&quot;,&quot;order&quot;:&quot;7&quot;},&quot;relativeTransform&quot;:{&quot;translate&quot;:{&quot;x&quot;:0,&quot;y&quot;:0},&quot;rotate&quot;:0}},&quot;25822147-62ea-4acf-a377-5ceec3b33d2c&quot;:{&quot;type&quot;:&quot;FIGURE_OBJECT&quot;,&quot;id&quot;:&quot;25822147-62ea-4acf-a377-5ceec3b33d2c&quot;,&quot;relativeTransform&quot;:{&quot;translate&quot;:{&quot;x&quot;:205.1143635164609,&quot;y&quot;:-139.4474797871799},&quot;rotate&quot;:1.5707963267948966},&quot;opacity&quot;:1,&quot;path&quot;:{&quot;type&quot;:&quot;POLY_LINE&quot;,&quot;points&quot;:[{&quot;x&quot;:-0.2074942849213386,&quot;y&quot;:-6.6398167056200155},{&quot;x&quot;:0,&quot;y&quot;:12.657150968338991}],&quot;closed&quot;:false},&quot;pathStyles&quot;:[{&quot;type&quot;:&quot;FILL&quot;,&quot;fillStyle&quot;:&quot;rgba(0,0,0,0)&quot;},{&quot;type&quot;:&quot;STROKE&quot;,&quot;strokeStyle&quot;:&quot;rgba(61, 61, 61, 1)&quot;,&quot;lineWidth&quot;:2.5,&quot;lineJoin&quot;:&quot;round&quot;,&quot;dashArray&quot;:[0]}],&quot;isLocked&quot;:false,&quot;parent&quot;:{&quot;type&quot;:&quot;CHILD&quot;,&quot;parentId&quot;:&quot;7705654d-dbc6-46b6-bce6-6280dc15caf7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8ead36af-d5c0-4972-b481-c4fdae9ed34c&quot;:{&quot;type&quot;:&quot;FIGURE_OBJECT&quot;,&quot;id&quot;:&quot;8ead36af-d5c0-4972-b481-c4fdae9ed34c&quot;,&quot;parent&quot;:{&quot;type&quot;:&quot;CROP&quot;,&quot;parentId&quot;:&quot;7705654d-dbc6-46b6-bce6-6280dc15caf7&quot;,&quot;order&quot;:&quot;5&quot;},&quot;relativeTransform&quot;:{&quot;translate&quot;:{&quot;x&quot;:189.8056963851014,&quot;y&quot;:-139.55122692964056},&quot;rotate&quot;:0,&quot;skewX&quot;:0,&quot;scale&quot;:{&quot;x&quot;:23.496610265749162,&quot;y&quot;:1.6518735712303312}},&quot;path&quot;:{&quot;type&quot;:&quot;RECT&quot;,&quot;size&quot;:{&quot;x&quot;:2,&quot;y&quot;:2}},&quot;pathStyles&quot;:[{&quot;type&quot;:&quot;FILL&quot;,&quot;fillStyle&quot;:&quot;#fff&quot;}],&quot;isFrozen&quot;:true},&quot;e68872fb-aab0-4c06-9100-f0883069a56c&quot;:{&quot;id&quot;:&quot;e68872fb-aab0-4c06-9100-f0883069a56c&quot;,&quot;name&quot;:&quot;Clock (no hands)&quot;,&quot;type&quot;:&quot;FIGURE_OBJECT&quot;,&quot;relativeTransform&quot;:{&quot;translate&quot;:{&quot;x&quot;:189.80600000000004,&quot;y&quot;:-139.404},&quot;rotate&quot;:0,&quot;skewX&quot;:0,&quot;scale&quot;:{&quot;x&quot;:1,&quot;y&quot;:1}},&quot;image&quot;:{&quot;url&quot;:&quot;https://icons.biorender.com/biorender/61eafb6fa57cec0029a1480b/20220121183627/image/clock-no-hands-1.png&quot;,&quot;fallbackUrl&quot;:&quot;https://res.cloudinary.com/dlcjuc3ej/image/upload/v1642790187/jnm2u1bo1dpkmdmlx92k.svg#/keystone/api/icons/61eafb6fa57cec0029a1480b/20220121183627/image/clock-no-hands-1.svg&quot;,&quot;isPremium&quot;:false,&quot;isPacked&quot;:true,&quot;size&quot;:{&quot;x&quot;:100,&quot;y&quot;:100}},&quot;source&quot;:{&quot;id&quot;:&quot;61eafb6fa57cec0029a1480b&quot;,&quot;type&quot;:&quot;ASSETS&quot;},&quot;isPremium&quot;:false,&quot;parent&quot;:{&quot;type&quot;:&quot;CHILD&quot;,&quot;parentId&quot;:&quot;7481b1fa-6cb6-48fe-a710-775100739e89&quot;,&quot;order&quot;:&quot;2&quot;}},&quot;8ec2639d-7aa5-4bae-9926-529cfcbfacfa&quot;:{&quot;type&quot;:&quot;FIGURE_OBJECT&quot;,&quot;id&quot;:&quot;8ec2639d-7aa5-4bae-9926-529cfcbfacfa&quot;,&quot;relativeTransform&quot;:{&quot;translate&quot;:{&quot;x&quot;:-356.2141448486328,&quot;y&quot;:-216.85584146728516},&quot;rotate&quot;:0,&quot;skewX&quot;:0,&quot;scale&quot;:{&quot;x&quot;:0.79,&quot;y&quot;:0.79}},&quot;opacity&quot;:1,&quot;source&quot;:{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9&quot;}},&quot;42beb668-011a-4f33-acce-f24f3f00b276&quot;:{&quot;type&quot;:&quot;FIGURE_OBJECT&quot;,&quot;id&quot;:&quot;42beb668-011a-4f33-acce-f24f3f00b276&quot;,&quot;relativeTransform&quot;:{&quot;translate&quot;:{&quot;x&quot;:9.568657805025573,&quot;y&quot;:67.98753325297047},&quot;rotate&quot;:0,&quot;skewX&quot;:0,&quot;scale&quot;:{&quot;x&quot;:1,&quot;y&quot;:1}},&quot;opacity&quot;:1,&quot;path&quot;:{&quot;type&quot;:&quot;POLY_LINE&quot;,&quot;points&quot;:[{&quot;x&quot;:-57.21865780502557,&quot;y&quot;:5.222466747029529},{&quot;x&quot;:3.447629105299715,&quot;y&quot;:14.727387500866172},{&quot;x&quot;:57.21865780502558,&quot;y&quot;:-18.375794573561436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1&quot;}},&quot;c3965932-a251-46c9-91ee-694c432c3a6b&quot;:{&quot;type&quot;:&quot;FIGURE_OBJECT&quot;,&quot;id&quot;:&quot;c3965932-a251-46c9-91ee-694c432c3a6b&quot;,&quot;relativeTransform&quot;:{&quot;translate&quot;:{&quot;x&quot;:63.642415150172965,&quot;y&quot;:-22.603506741225722},&quot;rotate&quot;:0,&quot;skewX&quot;:0,&quot;scale&quot;:{&quot;x&quot;:1,&quot;y&quot;:1}},&quot;opacity&quot;:1,&quot;path&quot;:{&quot;type&quot;:&quot;POLY_LINE&quot;,&quot;points&quot;:[{&quot;x&quot;:11.87758484982703,&quot;y&quot;:59.07350674122572},{&quot;x&quot;:16.80114955627178,&quot;y&quot;:-8.177406785637139},{&quot;x&quot;:-22.788566480644,&quot;y&quot;:-59.07350674122572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2&quot;}},&quot;f2defbbd-11ca-4b6c-8dcb-e22638ad41c8&quot;:{&quot;type&quot;:&quot;FIGURE_OBJECT&quot;,&quot;id&quot;:&quot;f2defbbd-11ca-4b6c-8dcb-e22638ad41c8&quot;,&quot;relativeTransform&quot;:{&quot;translate&quot;:{&quot;x&quot;:-33.74439927369357,&quot;y&quot;:-69.20847869470347},&quot;rotate&quot;:0,&quot;skewX&quot;:0,&quot;scale&quot;:{&quot;x&quot;:1,&quot;y&quot;:1}},&quot;opacity&quot;:1,&quot;path&quot;:{&quot;type&quot;:&quot;POLY_LINE&quot;,&quot;points&quot;:[{&quot;x&quot;:50.74439927369357,&quot;y&quot;:-21.261521305296526},{&quot;x&quot;:-10.393001779168841,&quot;y&quot;:-15.722465712878815},{&quot;x&quot;:-50.74439927369357,&quot;y&quot;:25.312225478436844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5&quot;}},&quot;7efad75f-dc2a-4504-85a2-b45203b45ee1&quot;:{&quot;type&quot;:&quot;FIGURE_OBJECT&quot;,&quot;id&quot;:&quot;7efad75f-dc2a-4504-85a2-b45203b45ee1&quot;,&quot;relativeTransform&quot;:{&quot;translate&quot;:{&quot;x&quot;:-77.75747291427902,&quot;y&quot;:19.107910461425778},&quot;rotate&quot;:0,&quot;skewX&quot;:0,&quot;scale&quot;:{&quot;x&quot;:1,&quot;y&quot;:1}},&quot;opacity&quot;:1,&quot;path&quot;:{&quot;type&quot;:&quot;POLY_LINE&quot;,&quot;points&quot;:[{&quot;x&quot;:-12.812527085720973,&quot;y&quot;:-47.22791046142578},{&quot;x&quot;:-11.00116428512284,&quot;y&quot;:4.328242034912108},{&quot;x&quot;:16.80452567917159,&quot;y&quot;:47.22791046142578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7&quot;}},&quot;101f89c8-8037-4165-a066-69a254ec3dfd&quot;:{&quot;id&quot;:&quot;101f89c8-8037-4165-a066-69a254ec3dfd&quot;,&quot;name&quot;:&quot;Calendar (symbol)&quot;,&quot;displayName&quot;:&quot;&quot;,&quot;type&quot;:&quot;FIGURE_OBJECT&quot;,&quot;relativeTransform&quot;:{&quot;translate&quot;:{&quot;x&quot;:-191,&quot;y&quot;:-256},&quot;rotate&quot;:0,&quot;skewX&quot;:0,&quot;scale&quot;:{&quot;x&quot;:1,&quot;y&quot;:1}},&quot;image&quot;:{&quot;url&quot;:&quot;https://icons.cdn.biorender.com/biorender/608c5188f4c35b0027d51951/20210430185154/image/608c5188f4c35b0027d51951.png&quot;,&quot;isPremium&quot;:false,&quot;isOrgIcon&quot;:false,&quot;size&quot;:{&quot;x&quot;:100,&quot;y&quot;:100}},&quot;source&quot;:{&quot;id&quot;:&quot;608c5188f4c35b0027d51951&quot;,&quot;version&quot;:&quot;20210430185154&quot;,&quot;type&quot;:&quot;ASSETS&quot;},&quot;isPremium&quot;:false,&quot;parent&quot;:{&quot;type&quot;:&quot;CHILD&quot;,&quot;parentId&quot;:&quot;228b698d-4cee-4aaf-8d74-c84d91114676&quot;,&quot;order&quot;:&quot;99995&quot;}}}}"/>
  <p:tag name="TRANSPARENTBACKGROUND" val="true"/>
  <p:tag name="VERSION" val="1773845276751"/>
  <p:tag name="TITLE" val="Untitled"/>
  <p:tag name="CREATORNAME" val="Samson Cantor"/>
  <p:tag name="DATEINSERTED" val="1773845291863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5345067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670997d4-a714-4aa9-b2a4-61cb35802eec&quot;:{&quot;relativeTransform&quot;:{&quot;translate&quot;:{&quot;x&quot;:28.371115221094215,&quot;y&quot;:-14.275179179840293},&quot;rotate&quot;:0,&quot;skewX&quot;:0,&quot;scale&quot;:{&quot;x&quot;:1,&quot;y&quot;:1}},&quot;type&quot;:&quot;FIGURE_OBJECT&quot;,&quot;id&quot;:&quot;670997d4-a714-4aa9-b2a4-61cb35802eec&quot;,&quot;parent&quot;:{&quot;type&quot;:&quot;CHILD&quot;,&quot;parentId&quot;:&quot;228b698d-4cee-4aaf-8d74-c84d91114676&quot;,&quot;order&quot;:&quot;97&quot;},&quot;name&quot;:&quot;Injection vial with syringe&quot;,&quot;displayName&quot;:&quot;Injection vial with syringe&quot;,&quot;source&quot;:{&quot;id&quot;:&quot;66febd2e6965cf3a9cf9ed78&quot;,&quot;type&quot;:&quot;ASSETS&quot;},&quot;isPremium&quot;:false},&quot;d9e12ab1-a7a1-46da-88b8-f08b6f350b04&quot;:{&quot;type&quot;:&quot;FIGURE_OBJECT&quot;,&quot;id&quot;:&quot;d9e12ab1-a7a1-46da-88b8-f08b6f350b04&quot;,&quot;name&quot;:&quot;Injection vial (large)&quot;,&quot;relativeTransform&quot;:{&quot;translate&quot;:{&quot;x&quot;:-6.370793461500696,&quot;y&quot;:27.92106985693198},&quot;rotate&quot;:0,&quot;skewX&quot;:0,&quot;scale&quot;:{&quot;x&quot;:0.23904614583337438,&quot;y&quot;:0.23904614583337438}},&quot;opacity&quot;:1,&quot;image&quot;:{&quot;url&quot;:&quot;https://icons.biorender.com/biorender/5bb389b435024313003c81ac/20181002150759/image/injection-vial-large.png&quot;,&quot;fallbackUrl&quot;:&quot;https://res.cloudinary.com/dlcjuc3ej/image/upload/v1538492879/np77fakf5l35px4eqg70.svg#/keystone/api/icons/5bb389b435024313003c81ac/20181002150759/image/injection-vial-large.svg&quot;,&quot;size&quot;:{&quot;x&quot;:215,&quot;y&quot;:407},&quot;isPremium&quot;:false,&quot;isPacked&quot;:true},&quot;source&quot;:{&quot;id&quot;:&quot;5bb389b435024313003c81ac&quot;,&quot;type&quot;:&quot;ASSETS&quot;},&quot;pathStyles&quot;:[{&quot;type&quot;:&quot;FILL&quot;,&quot;fillStyle&quot;:&quot;rgb(0,0,0)&quot;}],&quot;isLocked&quot;:false,&quot;parent&quot;:{&quot;type&quot;:&quot;CHILD&quot;,&quot;parentId&quot;:&quot;670997d4-a714-4aa9-b2a4-61cb35802eec&quot;,&quot;order&quot;:&quot;5&quot;}},&quot;b922c988-cbc2-4ba5-9601-1e1753f144b6&quot;:{&quot;type&quot;:&quot;FIGURE_OBJECT&quot;,&quot;id&quot;:&quot;b922c988-cbc2-4ba5-9601-1e1753f144b6&quot;,&quot;parent&quot;:{&quot;type&quot;:&quot;CHILD&quot;,&quot;parentId&quot;:&quot;670997d4-a714-4aa9-b2a4-61cb35802eec&quot;,&quot;order&quot;:&quot;2&quot;},&quot;relativeTransform&quot;:{}},&quot;74e13485-2989-4c97-b98f-147c540129a5&quot;:{&quot;type&quot;:&quot;FIGURE_OBJECT&quot;,&quot;id&quot;:&quot;74e13485-2989-4c97-b98f-147c540129a5&quot;,&quot;name&quot;:&quot;Syringe (with needle)&quot;,&quot;relativeTransform&quot;:{&quot;translate&quot;:{&quot;x&quot;:-6.371115221094211,&quot;y&quot;:47.34788722216385},&quot;rotate&quot;:0.4714777059238735,&quot;skewX&quot;:3.2534363668812695e-16,&quot;scale&quot;:{&quot;x&quot;:0.8261310669881501,&quot;y&quot;:0.8307083130915582}},&quot;opacity&quot;:0.46,&quot;image&quot;:{&quot;url&quot;:&quot;https://icons.biorender.com/biorender/5b3e2ef1d9a69e00140f73cd/syringe-with-needle.png&quot;,&quot;fallbackUrl&quot;:&quot;https://res.cloudinary.com/dlcjuc3ej/image/upload/v1530801899/y4apdxujaybwhddeo5bf.svg#/keystone/api/icons/5b3e2ef1d9a69e00140f73cd/syringe-with-needle.svg&quot;,&quot;size&quot;:{&quot;x&quot;:170,&quot;y&quot;:168},&quot;isPremium&quot;:false,&quot;isPacked&quot;:true},&quot;source&quot;:{&quot;id&quot;:&quot;5b0eb70f1f006b0014601db3&quot;,&quot;type&quot;:&quot;ASSETS&quot;},&quot;pathStyles&quot;:[{&quot;type&quot;:&quot;FILL&quot;,&quot;fillStyle&quot;:&quot;rgb(0,0,0)&quot;}],&quot;isLocked&quot;:false,&quot;parent&quot;:{&quot;type&quot;:&quot;CHILD&quot;,&quot;parentId&quot;:&quot;b922c988-cbc2-4ba5-9601-1e1753f144b6&quot;,&quot;order&quot;:&quot;5&quot;}},&quot;955b741f-5a5f-4cc1-b179-4b6b95f773a3&quot;:{&quot;type&quot;:&quot;FIGURE_OBJECT&quot;,&quot;id&quot;:&quot;955b741f-5a5f-4cc1-b179-4b6b95f773a3&quot;,&quot;parent&quot;:{&quot;type&quot;:&quot;CROP&quot;,&quot;parentId&quot;:&quot;b922c988-cbc2-4ba5-9601-1e1753f144b6&quot;,&quot;order&quot;:&quot;5&quot;},&quot;relativeTransform&quot;:{&quot;translate&quot;:{&quot;x&quot;:-6.371115221094215,&quot;y&quot;:43.348120688311354},&quot;rotate&quot;:0,&quot;skewX&quot;:0,&quot;scale&quot;:{&quot;x&quot;:94.25395561904125,&quot;y&quot;:37.55734854172579}},&quot;path&quot;:{&quot;type&quot;:&quot;RECT&quot;,&quot;size&quot;:{&quot;x&quot;:2,&quot;y&quot;:2}},&quot;pathStyles&quot;:[{&quot;type&quot;:&quot;FILL&quot;,&quot;fillStyle&quot;:&quot;#fff&quot;}],&quot;isFrozen&quot;:true},&quot;013d3fea-15bc-4869-956d-f60e4f101feb&quot;:{&quot;id&quot;:&quot;013d3fea-15bc-4869-956d-f60e4f101feb&quot;,&quot;name&quot;:&quot;Pill bottle (symbol)&quot;,&quot;displayName&quot;:&quot;&quot;,&quot;type&quot;:&quot;FIGURE_OBJECT&quot;,&quot;relativeTransform&quot;:{&quot;translate&quot;:{&quot;x&quot;:-344,&quot;y&quot;:15},&quot;rotate&quot;:0,&quot;skewX&quot;:0,&quot;scale&quot;:{&quot;x&quot;:1,&quot;y&quot;:1}},&quot;image&quot;:{&quot;url&quot;:&quot;https://icons.cdn.biorender.com/biorender/608c5b9cf4c35b0027d51a9b/20210430193501/image/608c5b9cf4c35b0027d51a9b.png&quot;,&quot;isPremium&quot;:false,&quot;isOrgIcon&quot;:false,&quot;size&quot;:{&quot;x&quot;:100,&quot;y&quot;:100}},&quot;source&quot;:{&quot;id&quot;:&quot;608c5b9cf4c35b0027d51a9b&quot;,&quot;version&quot;:&quot;20210430193501&quot;,&quot;type&quot;:&quot;ASSETS&quot;},&quot;isPremium&quot;:false,&quot;parent&quot;:{&quot;type&quot;:&quot;CHILD&quot;,&quot;parentId&quot;:&quot;228b698d-4cee-4aaf-8d74-c84d91114676&quot;,&quot;order&quot;:&quot;98&quot;}},&quot;d7ff55a7-aca3-4016-b8b6-724f1e5f3a7f&quot;:{&quot;id&quot;:&quot;d7ff55a7-aca3-4016-b8b6-724f1e5f3a7f&quot;,&quot;name&quot;:&quot;Pill bottle (symbol)&quot;,&quot;displayName&quot;:&quot;&quot;,&quot;type&quot;:&quot;FIGURE_OBJECT&quot;,&quot;relativeTransform&quot;:{&quot;translate&quot;:{&quot;x&quot;:-118,&quot;y&quot;:15},&quot;rotate&quot;:0,&quot;skewX&quot;:0,&quot;scale&quot;:{&quot;x&quot;:1,&quot;y&quot;:1}},&quot;image&quot;:{&quot;url&quot;:&quot;https://icons.cdn.biorender.com/biorender/608c5b9cf4c35b0027d51a9b/20210430193501/image/608c5b9cf4c35b0027d51a9b.png&quot;,&quot;isPremium&quot;:false,&quot;isOrgIcon&quot;:false,&quot;size&quot;:{&quot;x&quot;:100,&quot;y&quot;:100}},&quot;source&quot;:{&quot;id&quot;:&quot;608c5b9cf4c35b0027d51a9b&quot;,&quot;version&quot;:&quot;20210430193501&quot;,&quot;type&quot;:&quot;ASSETS&quot;},&quot;isPremium&quot;:false,&quot;parent&quot;:{&quot;type&quot;:&quot;CHILD&quot;,&quot;parentId&quot;:&quot;228b698d-4cee-4aaf-8d74-c84d91114676&quot;,&quot;order&quot;:&quot;99&quot;}}}}"/>
  <p:tag name="TITLE" val="Untitled"/>
  <p:tag name="CREATORNAME" val="Samson Cantor"/>
  <p:tag name="VERSION" val="1773775344206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5345067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670997d4-a714-4aa9-b2a4-61cb35802eec&quot;:{&quot;relativeTransform&quot;:{&quot;translate&quot;:{&quot;x&quot;:28.371115221094215,&quot;y&quot;:-14.275179179840293},&quot;rotate&quot;:0,&quot;skewX&quot;:0,&quot;scale&quot;:{&quot;x&quot;:1,&quot;y&quot;:1}},&quot;type&quot;:&quot;FIGURE_OBJECT&quot;,&quot;id&quot;:&quot;670997d4-a714-4aa9-b2a4-61cb35802eec&quot;,&quot;parent&quot;:{&quot;type&quot;:&quot;CHILD&quot;,&quot;parentId&quot;:&quot;228b698d-4cee-4aaf-8d74-c84d91114676&quot;,&quot;order&quot;:&quot;97&quot;},&quot;name&quot;:&quot;Injection vial with syringe&quot;,&quot;displayName&quot;:&quot;Injection vial with syringe&quot;,&quot;source&quot;:{&quot;id&quot;:&quot;66febd2e6965cf3a9cf9ed78&quot;,&quot;type&quot;:&quot;ASSETS&quot;},&quot;isPremium&quot;:false},&quot;d9e12ab1-a7a1-46da-88b8-f08b6f350b04&quot;:{&quot;type&quot;:&quot;FIGURE_OBJECT&quot;,&quot;id&quot;:&quot;d9e12ab1-a7a1-46da-88b8-f08b6f350b04&quot;,&quot;name&quot;:&quot;Injection vial (large)&quot;,&quot;relativeTransform&quot;:{&quot;translate&quot;:{&quot;x&quot;:-6.370793461500696,&quot;y&quot;:27.92106985693198},&quot;rotate&quot;:0,&quot;skewX&quot;:0,&quot;scale&quot;:{&quot;x&quot;:0.23904614583337438,&quot;y&quot;:0.23904614583337438}},&quot;opacity&quot;:1,&quot;image&quot;:{&quot;url&quot;:&quot;https://icons.biorender.com/biorender/5bb389b435024313003c81ac/20181002150759/image/injection-vial-large.png&quot;,&quot;fallbackUrl&quot;:&quot;https://res.cloudinary.com/dlcjuc3ej/image/upload/v1538492879/np77fakf5l35px4eqg70.svg#/keystone/api/icons/5bb389b435024313003c81ac/20181002150759/image/injection-vial-large.svg&quot;,&quot;size&quot;:{&quot;x&quot;:215,&quot;y&quot;:407},&quot;isPremium&quot;:false,&quot;isPacked&quot;:true},&quot;source&quot;:{&quot;id&quot;:&quot;5bb389b435024313003c81ac&quot;,&quot;type&quot;:&quot;ASSETS&quot;},&quot;pathStyles&quot;:[{&quot;type&quot;:&quot;FILL&quot;,&quot;fillStyle&quot;:&quot;rgb(0,0,0)&quot;}],&quot;isLocked&quot;:false,&quot;parent&quot;:{&quot;type&quot;:&quot;CHILD&quot;,&quot;parentId&quot;:&quot;670997d4-a714-4aa9-b2a4-61cb35802eec&quot;,&quot;order&quot;:&quot;5&quot;}},&quot;b922c988-cbc2-4ba5-9601-1e1753f144b6&quot;:{&quot;type&quot;:&quot;FIGURE_OBJECT&quot;,&quot;id&quot;:&quot;b922c988-cbc2-4ba5-9601-1e1753f144b6&quot;,&quot;parent&quot;:{&quot;type&quot;:&quot;CHILD&quot;,&quot;parentId&quot;:&quot;670997d4-a714-4aa9-b2a4-61cb35802eec&quot;,&quot;order&quot;:&quot;2&quot;},&quot;relativeTransform&quot;:{}},&quot;74e13485-2989-4c97-b98f-147c540129a5&quot;:{&quot;type&quot;:&quot;FIGURE_OBJECT&quot;,&quot;id&quot;:&quot;74e13485-2989-4c97-b98f-147c540129a5&quot;,&quot;name&quot;:&quot;Syringe (with needle)&quot;,&quot;relativeTransform&quot;:{&quot;translate&quot;:{&quot;x&quot;:-6.371115221094211,&quot;y&quot;:47.34788722216385},&quot;rotate&quot;:0.4714777059238735,&quot;skewX&quot;:3.2534363668812695e-16,&quot;scale&quot;:{&quot;x&quot;:0.8261310669881501,&quot;y&quot;:0.8307083130915582}},&quot;opacity&quot;:0.46,&quot;image&quot;:{&quot;url&quot;:&quot;https://icons.biorender.com/biorender/5b3e2ef1d9a69e00140f73cd/syringe-with-needle.png&quot;,&quot;fallbackUrl&quot;:&quot;https://res.cloudinary.com/dlcjuc3ej/image/upload/v1530801899/y4apdxujaybwhddeo5bf.svg#/keystone/api/icons/5b3e2ef1d9a69e00140f73cd/syringe-with-needle.svg&quot;,&quot;size&quot;:{&quot;x&quot;:170,&quot;y&quot;:168},&quot;isPremium&quot;:false,&quot;isPacked&quot;:true},&quot;source&quot;:{&quot;id&quot;:&quot;5b0eb70f1f006b0014601db3&quot;,&quot;type&quot;:&quot;ASSETS&quot;},&quot;pathStyles&quot;:[{&quot;type&quot;:&quot;FILL&quot;,&quot;fillStyle&quot;:&quot;rgb(0,0,0)&quot;}],&quot;isLocked&quot;:false,&quot;parent&quot;:{&quot;type&quot;:&quot;CHILD&quot;,&quot;parentId&quot;:&quot;b922c988-cbc2-4ba5-9601-1e1753f144b6&quot;,&quot;order&quot;:&quot;5&quot;}},&quot;955b741f-5a5f-4cc1-b179-4b6b95f773a3&quot;:{&quot;type&quot;:&quot;FIGURE_OBJECT&quot;,&quot;id&quot;:&quot;955b741f-5a5f-4cc1-b179-4b6b95f773a3&quot;,&quot;parent&quot;:{&quot;type&quot;:&quot;CROP&quot;,&quot;parentId&quot;:&quot;b922c988-cbc2-4ba5-9601-1e1753f144b6&quot;,&quot;order&quot;:&quot;5&quot;},&quot;relativeTransform&quot;:{&quot;translate&quot;:{&quot;x&quot;:-6.371115221094215,&quot;y&quot;:43.348120688311354},&quot;rotate&quot;:0,&quot;skewX&quot;:0,&quot;scale&quot;:{&quot;x&quot;:94.25395561904125,&quot;y&quot;:37.55734854172579}},&quot;path&quot;:{&quot;type&quot;:&quot;RECT&quot;,&quot;size&quot;:{&quot;x&quot;:2,&quot;y&quot;:2}},&quot;pathStyles&quot;:[{&quot;type&quot;:&quot;FILL&quot;,&quot;fillStyle&quot;:&quot;#fff&quot;}],&quot;isFrozen&quot;:true},&quot;013d3fea-15bc-4869-956d-f60e4f101feb&quot;:{&quot;id&quot;:&quot;013d3fea-15bc-4869-956d-f60e4f101feb&quot;,&quot;name&quot;:&quot;Pill bottle (symbol)&quot;,&quot;displayName&quot;:&quot;&quot;,&quot;type&quot;:&quot;FIGURE_OBJECT&quot;,&quot;relativeTransform&quot;:{&quot;translate&quot;:{&quot;x&quot;:-344,&quot;y&quot;:15},&quot;rotate&quot;:0,&quot;skewX&quot;:0,&quot;scale&quot;:{&quot;x&quot;:1,&quot;y&quot;:1}},&quot;image&quot;:{&quot;url&quot;:&quot;https://icons.cdn.biorender.com/biorender/608c5b9cf4c35b0027d51a9b/20210430193501/image/608c5b9cf4c35b0027d51a9b.png&quot;,&quot;isPremium&quot;:false,&quot;isOrgIcon&quot;:false,&quot;size&quot;:{&quot;x&quot;:100,&quot;y&quot;:100}},&quot;source&quot;:{&quot;id&quot;:&quot;608c5b9cf4c35b0027d51a9b&quot;,&quot;version&quot;:&quot;20210430193501&quot;,&quot;type&quot;:&quot;ASSETS&quot;},&quot;isPremium&quot;:false,&quot;parent&quot;:{&quot;type&quot;:&quot;CHILD&quot;,&quot;parentId&quot;:&quot;228b698d-4cee-4aaf-8d74-c84d91114676&quot;,&quot;order&quot;:&quot;98&quot;}},&quot;d7ff55a7-aca3-4016-b8b6-724f1e5f3a7f&quot;:{&quot;id&quot;:&quot;d7ff55a7-aca3-4016-b8b6-724f1e5f3a7f&quot;,&quot;name&quot;:&quot;Pill bottle (symbol)&quot;,&quot;displayName&quot;:&quot;&quot;,&quot;type&quot;:&quot;FIGURE_OBJECT&quot;,&quot;relativeTransform&quot;:{&quot;translate&quot;:{&quot;x&quot;:-118,&quot;y&quot;:15},&quot;rotate&quot;:0,&quot;skewX&quot;:0,&quot;scale&quot;:{&quot;x&quot;:1,&quot;y&quot;:1}},&quot;image&quot;:{&quot;url&quot;:&quot;https://icons.cdn.biorender.com/biorender/608c5b9cf4c35b0027d51a9b/20210430193501/image/608c5b9cf4c35b0027d51a9b.png&quot;,&quot;isPremium&quot;:false,&quot;isOrgIcon&quot;:false,&quot;size&quot;:{&quot;x&quot;:100,&quot;y&quot;:100}},&quot;source&quot;:{&quot;id&quot;:&quot;608c5b9cf4c35b0027d51a9b&quot;,&quot;version&quot;:&quot;20210430193501&quot;,&quot;type&quot;:&quot;ASSETS&quot;},&quot;isPremium&quot;:false,&quot;parent&quot;:{&quot;type&quot;:&quot;CHILD&quot;,&quot;parentId&quot;:&quot;228b698d-4cee-4aaf-8d74-c84d91114676&quot;,&quot;order&quot;:&quot;99&quot;}}}}"/>
  <p:tag name="TITLE" val="Untitled"/>
  <p:tag name="CREATORNAME" val="Samson Cantor"/>
  <p:tag name="VERSION" val="1773775344206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851396836"/>
  <p:tag name="VERSION" val="1773851394180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,&quot;715bbc95-2221-48e5-a0b2-e1ae84faa96a&quot;:{&quot;id&quot;:&quot;715bbc95-2221-48e5-a0b2-e1ae84faa96a&quot;,&quot;name&quot;:&quot;Glucose meter&quot;,&quot;displayName&quot;:&quot;&quot;,&quot;type&quot;:&quot;FIGURE_OBJECT&quot;,&quot;relativeTransform&quot;:{&quot;translate&quot;:{&quot;x&quot;:-374.8627450980392,&quot;y&quot;:127.5},&quot;rotate&quot;:0,&quot;skewX&quot;:0,&quot;scale&quot;:{&quot;x&quot;:0.2551633986928105,&quot;y&quot;:0.2551633986928105}},&quot;image&quot;:{&quot;url&quot;:&quot;https://icons.cdn.biorender.com/biorender/5cc36f64df35f43300d5ab9e/20190426205306/image/5cc36f64df35f43300d5ab9e.png&quot;,&quot;isPremium&quot;:false,&quot;isOrgIcon&quot;:false,&quot;size&quot;:{&quot;x&quot;:150,&quot;y&quot;:310.13513513513516}},&quot;source&quot;:{&quot;id&quot;:&quot;5cc36f64df35f43300d5ab9e&quot;,&quot;version&quot;:&quot;20190426205306&quot;,&quot;type&quot;:&quot;ASSETS&quot;},&quot;isPremium&quot;:false,&quot;parent&quot;:{&quot;type&quot;:&quot;CHILD&quot;,&quot;parentId&quot;:&quot;228b698d-4cee-4aaf-8d74-c84d91114676&quot;,&quot;order&quot;:&quot;97&quot;}},&quot;5f9c25af-4e61-4d01-a7f9-bc96f00ec0a3&quot;:{&quot;id&quot;:&quot;5f9c25af-4e61-4d01-a7f9-bc96f00ec0a3&quot;,&quot;name&quot;:&quot;Child 3 (head, gender-neutral, stage I obesity, anterior)&quot;,&quot;displayName&quot;:&quot;&quot;,&quot;type&quot;:&quot;FIGURE_OBJECT&quot;,&quot;relativeTransform&quot;:{&quot;translate&quot;:{&quot;x&quot;:-294,&quot;y&quot;:145},&quot;rotate&quot;:0,&quot;skewX&quot;:0,&quot;scale&quot;:{&quot;x&quot;:1,&quot;y&quot;:1}},&quot;image&quot;:{&quot;url&quot;:&quot;https://icons.cdn.biorender.com/biorender/671a9e69bdca4c36b346d6be/671a9e50bdca4c36b346d679.png&quot;,&quot;isPremium&quot;:true,&quot;isOrgIcon&quot;:false,&quot;size&quot;:{&quot;x&quot;:150,&quot;y&quot;:140.3485254691689},&quot;fallbackUrl&quot;:&quot;sources/icons/671a9e69bdca4c36b346d6be/671a9e50bdca4c36b346d679.svg&quot;},&quot;source&quot;:{&quot;id&quot;:&quot;671a9e50bdca4c36b346d679&quot;,&quot;version&quot;:&quot;20241024192203&quot;,&quot;type&quot;:&quot;ASSETS&quot;},&quot;isPremium&quot;:true,&quot;parent&quot;:{&quot;type&quot;:&quot;CHILD&quot;,&quot;parentId&quot;:&quot;228b698d-4cee-4aaf-8d74-c84d91114676&quot;,&quot;order&quot;:&quot;98&quot;}},&quot;3bbfb5a3-190d-4c8e-8632-87cfbfcbc871&quot;:{&quot;relativeTransform&quot;:{&quot;translate&quot;:{&quot;x&quot;:-149.81948063774848,&quot;y&quot;:364.7558646383225},&quot;rotate&quot;:0,&quot;skewX&quot;:0,&quot;scale&quot;:{&quot;x&quot;:1,&quot;y&quot;:1}},&quot;type&quot;:&quot;FIGURE_OBJECT&quot;,&quot;id&quot;:&quot;3bbfb5a3-190d-4c8e-8632-87cfbfcbc871&quot;,&quot;parent&quot;:{&quot;type&quot;:&quot;CHILD&quot;,&quot;parentId&quot;:&quot;228b698d-4cee-4aaf-8d74-c84d91114676&quot;,&quot;order&quot;:&quot;99&quot;},&quot;name&quot;:&quot;Pill cluster&quot;,&quot;displayName&quot;:&quot;Pill cluster&quot;,&quot;source&quot;:{&quot;id&quot;:&quot;608aeff9ac44b300a20aaf63&quot;,&quot;type&quot;:&quot;ASSETS&quot;},&quot;isPremium&quot;:true},&quot;69882f09-baa4-49ed-abcd-6bf96fb71bd7&quot;:{&quot;id&quot;:&quot;69882f09-baa4-49ed-abcd-6bf96fb71bd7&quot;,&quot;name&quot;:&quot;Pill&quot;,&quot;type&quot;:&quot;FIGURE_OBJECT&quot;,&quot;relativeTransform&quot;:{&quot;translate&quot;:{&quot;x&quot;:-54.567779158393485,&quot;y&quot;:-259.7289704286371},&quot;rotate&quot;:-0.22017744070666753,&quot;skewX&quot;:0,&quot;scale&quot;:{&quot;x&quot;:0.55162259114342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2&quot;}},&quot;ffc78527-3a89-4f6b-b297-88c031402b45&quot;:{&quot;id&quot;:&quot;ffc78527-3a89-4f6b-b297-88c031402b45&quot;,&quot;name&quot;:&quot;Pill&quot;,&quot;type&quot;:&quot;FIGURE_OBJECT&quot;,&quot;relativeTransform&quot;:{&quot;translate&quot;:{&quot;x&quot;:-38.0779636962714,&quot;y&quot;:-232.27741754225076},&quot;rotate&quot;:2.731657600636832,&quot;skewX&quot;:9.12149764969962e-17,&quot;scale&quot;:{&quot;x&quot;:0.551622591143428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5&quot;},&quot;opacity&quot;:0.78},&quot;ee11c06a-3576-4aa5-bb01-3a4c719cd33b&quot;:{&quot;id&quot;:&quot;ee11c06a-3576-4aa5-bb01-3a4c719cd33b&quot;,&quot;name&quot;:&quot;Pill&quot;,&quot;type&quot;:&quot;FIGURE_OBJECT&quot;,&quot;relativeTransform&quot;:{&quot;translate&quot;:{&quot;x&quot;:-52.58371747724082,&quot;y&quot;:-214.37741536307334},&quot;rotate&quot;:-7.642229304742056e-17,&quot;skewX&quot;:-7.642229304742057e-17,&quot;scale&quot;:{&quot;x&quot;:0.5516225911434285,&quot;y&quot;:0.5516225911434287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7&quot;}},&quot;dbf3c7e6-af9c-4614-aaa1-0ec60faa16bc&quot;:{&quot;id&quot;:&quot;dbf3c7e6-af9c-4614-aaa1-0ec60faa16bc&quot;,&quot;name&quot;:&quot;Absorption (ADMET, symbol)&quot;,&quot;displayName&quot;:&quot;&quot;,&quot;type&quot;:&quot;FIGURE_OBJECT&quot;,&quot;relativeTransform&quot;:{&quot;translate&quot;:{&quot;x&quot;:-86,&quot;y&quot;:-114.67426273458443},&quot;rotate&quot;:0,&quot;skewX&quot;:0,&quot;scale&quot;:{&quot;x&quot;:1,&quot;y&quot;:1}},&quot;image&quot;:{&quot;url&quot;:&quot;https://icons.cdn.biorender.com/biorender/67f5906e8036a7aacbd4cedb/20250408211342/image/67f5906e8036a7aacbd4cedb.png&quot;,&quot;isPremium&quot;:false,&quot;isOrgIcon&quot;:false,&quot;size&quot;:{&quot;x&quot;:100,&quot;y&quot;:100}},&quot;source&quot;:{&quot;id&quot;:&quot;67f5906e8036a7aacbd4cedb&quot;,&quot;version&quot;:&quot;20250408211342&quot;,&quot;type&quot;:&quot;ASSETS&quot;},&quot;isPremium&quot;:false,&quot;parent&quot;:{&quot;type&quot;:&quot;CHILD&quot;,&quot;parentId&quot;:&quot;228b698d-4cee-4aaf-8d74-c84d91114676&quot;,&quot;order&quot;:&quot;995&quot;}},&quot;64a73b3b-f713-499c-8bb0-94022021977b&quot;:{&quot;id&quot;:&quot;64a73b3b-f713-499c-8bb0-94022021977b&quot;,&quot;name&quot;:&quot;Metabolism (ADMET, symbol)&quot;,&quot;displayName&quot;:&quot;&quot;,&quot;type&quot;:&quot;FIGURE_OBJECT&quot;,&quot;relativeTransform&quot;:{&quot;translate&quot;:{&quot;x&quot;:25,&quot;y&quot;:-116.67426273458443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97&quot;}},&quot;ac397bb5-a291-43a5-8402-3dd47a8fd2de&quot;:{&quot;id&quot;:&quot;ac397bb5-a291-43a5-8402-3dd47a8fd2de&quot;,&quot;name&quot;:&quot;Excretion (ADMET, symbol)&quot;,&quot;displayName&quot;:&quot;&quot;,&quot;type&quot;:&quot;FIGURE_OBJECT&quot;,&quot;relativeTransform&quot;:{&quot;translate&quot;:{&quot;x&quot;:124,&quot;y&quot;:-117.67426273458443},&quot;rotate&quot;:0,&quot;skewX&quot;:0,&quot;scale&quot;:{&quot;x&quot;:1,&quot;y&quot;:1}},&quot;image&quot;:{&quot;url&quot;:&quot;https://icons.cdn.biorender.com/biorender/67f5952f8036a7aacbd4d1e9/20250408212945/image/67f5952f8036a7aacbd4d1e9.png&quot;,&quot;isPremium&quot;:false,&quot;isOrgIcon&quot;:false,&quot;size&quot;:{&quot;x&quot;:100,&quot;y&quot;:100}},&quot;source&quot;:{&quot;id&quot;:&quot;67f5952f8036a7aacbd4d1e9&quot;,&quot;version&quot;:&quot;20250408212945&quot;,&quot;type&quot;:&quot;ASSETS&quot;},&quot;isPremium&quot;:false,&quot;parent&quot;:{&quot;type&quot;:&quot;CHILD&quot;,&quot;parentId&quot;:&quot;228b698d-4cee-4aaf-8d74-c84d91114676&quot;,&quot;order&quot;:&quot;998&quot;}},&quot;be10db81-2c63-4af8-9a80-2e62a491e20b&quot;:{&quot;relativeTransform&quot;:{&quot;translate&quot;:{&quot;x&quot;:195.54388195061262,&quot;y&quot;:-34.44402995059181},&quot;rotate&quot;:0,&quot;skewX&quot;:0,&quot;scale&quot;:{&quot;x&quot;:1,&quot;y&quot;:1}},&quot;type&quot;:&quot;FIGURE_OBJECT&quot;,&quot;id&quot;:&quot;be10db81-2c63-4af8-9a80-2e62a491e20b&quot;,&quot;parent&quot;:{&quot;type&quot;:&quot;CHILD&quot;,&quot;parentId&quot;:&quot;228b698d-4cee-4aaf-8d74-c84d91114676&quot;,&quot;order&quot;:&quot;999&quot;},&quot;name&quot;:&quot;Adult male head (lateral, taking oral medication)&quot;,&quot;displayName&quot;:&quot;Adult male head (lateral, taking oral medication)&quot;,&quot;source&quot;:{&quot;id&quot;:&quot;63bc4d3e69764ef572715e51&quot;,&quot;type&quot;:&quot;ASSETS&quot;},&quot;isPremium&quot;:true},&quot;5ea02427-5ca5-48b7-ba18-a6b04e8fa193&quot;:{&quot;id&quot;:&quot;5ea02427-5ca5-48b7-ba18-a6b04e8fa193&quot;,&quot;name&quot;:&quot;Adult male head (lateral, open mouth)&quot;,&quot;displayName&quot;:&quot;&quot;,&quot;type&quot;:&quot;FIGURE_OBJECT&quot;,&quot;relativeTransform&quot;:{&quot;translate&quot;:{&quot;x&quot;:-44.69765631434586,&quot;y&quot;:181.4440299505918},&quot;rotate&quot;:0,&quot;skewX&quot;:0,&quot;scale&quot;:{&quot;x&quot;:1,&quot;y&quot;:1}},&quot;image&quot;:{&quot;url&quot;:&quot;https://icons.biorender.com/biorender/5ecd2dd9fc86fd00280efee8/20200526150009/image/adult-male-head-lateral-open-mouth.png&quot;,&quot;fallbackUrl&quot;:&quot;https://res.cloudinary.com/dlcjuc3ej/image/upload/v1590505209/cy467owkhsyjy1wjgwgy.svg#/keystone/api/icons/5ecd2dd9fc86fd00280efee8/20200526150009/image/adult-male-head-lateral-open-mouth.svg&quot;,&quot;isPremium&quot;:true,&quot;size&quot;:{&quot;x&quot;:100,&quot;y&quot;:145.95744680851064}},&quot;source&quot;:{&quot;id&quot;:&quot;5ecd2dd9fc86fd00280efee8&quot;,&quot;type&quot;:&quot;ASSETS&quot;},&quot;isPremium&quot;:true,&quot;parent&quot;:{&quot;type&quot;:&quot;CHILD&quot;,&quot;parentId&quot;:&quot;be10db81-2c63-4af8-9a80-2e62a491e20b&quot;,&quot;order&quot;:&quot;2&quot;}},&quot;2d92d51c-362e-4192-a6f0-afdf04b10350&quot;:{&quot;relativeTransform&quot;:{&quot;translate&quot;:{&quot;x&quot;:-108.89939975206015,&quot;y&quot;:269.268809325843},&quot;rotate&quot;:0,&quot;skewX&quot;:0,&quot;scale&quot;:{&quot;x&quot;:1,&quot;y&quot;:1}},&quot;type&quot;:&quot;FIGURE_OBJECT&quot;,&quot;id&quot;:&quot;2d92d51c-362e-4192-a6f0-afdf04b10350&quot;,&quot;parent&quot;:{&quot;type&quot;:&quot;CHILD&quot;,&quot;parentId&quot;:&quot;be10db81-2c63-4af8-9a80-2e62a491e20b&quot;,&quot;order&quot;:&quot;5&quot;},&quot;name&quot;:&quot;Pill cluster&quot;,&quot;displayName&quot;:&quot;Pill cluster&quot;,&quot;source&quot;:{&quot;id&quot;:&quot;608aeff9ac44b300a20aaf63&quot;,&quot;type&quot;:&quot;ASSETS&quot;},&quot;isPremium&quot;:true},&quot;bd97b65a-b41e-46e2-b85d-b1bdb8a18e50&quot;:{&quot;id&quot;:&quot;bd97b65a-b41e-46e2-b85d-b1bdb8a18e50&quot;,&quot;name&quot;:&quot;Pill&quot;,&quot;type&quot;:&quot;FIGURE_OBJECT&quot;,&quot;relativeTransform&quot;:{&quot;translate&quot;:{&quot;x&quot;:-14.310552926061176,&quot;y&quot;:-87.29506398454491},&quot;rotate&quot;:2.731657600636832,&quot;skewX&quot;:8.072550417700369e-17,&quot;scale&quot;:{&quot;x&quot;:0.20731214380936094,&quot;y&quot;:0.20731214380936125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5&quot;},&quot;opacity&quot;:0.78},&quot;2bd74ecf-0680-441a-ba07-3bf38a42c93e&quot;:{&quot;id&quot;:&quot;2bd74ecf-0680-441a-ba07-3bf38a42c93e&quot;,&quot;name&quot;:&quot;Pill&quot;,&quot;type&quot;:&quot;FIGURE_OBJECT&quot;,&quot;relativeTransform&quot;:{&quot;translate&quot;:{&quot;x&quot;:-19.762140591588093,&quot;y&quot;:-80.56784163082403},&quot;rotate&quot;:-7.642229304742056e-17,&quot;skewX&quot;:-7.642229304742064e-17,&quot;scale&quot;:{&quot;x&quot;:0.20731214380936086,&quot;y&quot;:0.2073121438093609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7&quot;}},&quot;4e9da238-c226-4237-9fff-754465ad1147&quot;:{&quot;id&quot;:&quot;4e9da238-c226-4237-9fff-754465ad1147&quot;,&quot;name&quot;:&quot;Pill&quot;,&quot;type&quot;:&quot;FIGURE_OBJECT&quot;,&quot;relativeTransform&quot;:{&quot;translate&quot;:{&quot;x&quot;:-20.507795478051605,&quot;y&quot;:-97.61197335545403},&quot;rotate&quot;:-0.2201774407066676,&quot;skewX&quot;:0,&quot;scale&quot;:{&quot;x&quot;:0.20731214380936067,&quot;y&quot;:0.207312143809361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2&quot;}},&quot;34dbf796-49a7-4ab6-adb2-dfb7c143995c&quot;:{&quot;type&quot;:&quot;FIGURE_OBJECT&quot;,&quot;id&quot;:&quot;34dbf796-49a7-4ab6-adb2-dfb7c143995c&quot;,&quot;relativeTransform&quot;:{&quot;translate&quot;:{&quot;x&quot;:-97.31827780975603,&quot;y&quot;:179.09500275996288},&quot;rotate&quot;:0,&quot;skewX&quot;:0,&quot;scale&quot;:{&quot;x&quot;:1,&quot;y&quot;:1}},&quot;opacity&quot;:1,&quot;path&quot;:{&quot;type&quot;:&quot;POLY_LINE&quot;,&quot;points&quot;:[{&quot;x&quot;:-12.144126817834582,&quot;y&quot;:0},{&quot;x&quot;:-0.8333192585170209,&quot;y&quot;:0},{&quot;x&quot;:12.14412681783459,&quot;y&quot;:0}],&quot;closed&quot;:false,&quot;cornerRounding&quot;:{&quot;type&quot;:&quot;ARC_LENGTH&quot;,&quot;global&quot;:58.813885746365806}},&quot;pathStyles&quot;:[{&quot;type&quot;:&quot;FILL&quot;,&quot;fillStyle&quot;:&quot;transparent&quot;},{&quot;type&quot;:&quot;STROKE&quot;,&quot;strokeStyle&quot;:&quot;#232323&quot;,&quot;lineWidth&quot;:1.348508802440510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e10db81-2c63-4af8-9a80-2e62a491e20b&quot;,&quot;order&quot;:&quot;7&quot;}},&quot;40426b1f-f4a2-48f4-9ae7-77808da3515c&quot;:{&quot;id&quot;:&quot;40426b1f-f4a2-48f4-9ae7-77808da3515c&quot;,&quot;name&quot;:&quot;Adult (gender-neutral, lateral, taking pill) &quot;,&quot;displayName&quot;:&quot;&quot;,&quot;type&quot;:&quot;FIGURE_OBJECT&quot;,&quot;relativeTransform&quot;:{&quot;translate&quot;:{&quot;x&quot;:-221,&quot;y&quot;:-122},&quot;rotate&quot;:0,&quot;skewX&quot;:0,&quot;scale&quot;:{&quot;x&quot;:1,&quot;y&quot;:1}},&quot;image&quot;:{&quot;url&quot;:&quot;https://icons.cdn.biorender.com/biorender/672d005c9105801996905713/672ce05854021394a7d1b3c5.png&quot;,&quot;isPremium&quot;:false,&quot;isOrgIcon&quot;:false,&quot;size&quot;:{&quot;x&quot;:150,&quot;y&quot;:140.3485254691689},&quot;fallbackUrl&quot;:&quot;sources/icons/672d005c9105801996905713/672ce05854021394a7d1b3c5.svg&quot;},&quot;source&quot;:{&quot;id&quot;:&quot;672ce05854021394a7d1b3c5&quot;,&quot;version&quot;:&quot;20241107180047&quot;,&quot;type&quot;:&quot;ASSETS&quot;},&quot;isPremium&quot;:false,&quot;parent&quot;:{&quot;type&quot;:&quot;CHILD&quot;,&quot;parentId&quot;:&quot;228b698d-4cee-4aaf-8d74-c84d91114676&quot;,&quot;order&quot;:&quot;9995&quot;}},&quot;051254f3-c91c-46d4-904a-4f56f1f36c6c&quot;:{&quot;relativeTransform&quot;:{&quot;translate&quot;:{&quot;x&quot;:266.29771864996013,&quot;y&quot;:-129},&quot;rotate&quot;:0},&quot;type&quot;:&quot;FIGURE_OBJECT&quot;,&quot;id&quot;:&quot;051254f3-c91c-46d4-904a-4f56f1f36c6c&quot;,&quot;name&quot;:&quot;Blood vial (with blood and label, capped)&quot;,&quot;displayName&quot;:&quot;Blood vial (with blood and label, capped)&quot;,&quot;opacity&quot;:1,&quot;source&quot;:{&quot;id&quot;:&quot;5dbb01b84ef0b000810d2b0e&quot;,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7&quot;},&quot;isPremium&quot;:true},&quot;ed197ed7-7fe7-4847-881d-92ed223786f5&quot;:{&quot;type&quot;:&quot;FIGURE_OBJECT&quot;,&quot;id&quot;:&quot;ed197ed7-7fe7-4847-881d-92ed223786f5&quot;,&quot;name&quot;:&quot;Blood vial (labelled)&quot;,&quot;relativeTransform&quot;:{&quot;translate&quot;:{&quot;x&quot;:2.0318280249341756e-15,&quot;y&quot;:12.889965271685073},&quot;rotate&quot;:0,&quot;skewX&quot;:0,&quot;scale&quot;:{&quot;x&quot;:0.439929804614158,&quot;y&quot;:0.4399298046141579}},&quot;opacity&quot;:1,&quot;image&quot;:{&quot;url&quot;:&quot;https://res.cloudinary.com/dlcjuc3ej/image/upload/v1572535485/xokmqyvumsqposaheemj.svg#/keystone/api/icons/5dbafc93c9e7d80004b85b52/20191031152445/image/blood-vial-labelled.svg&quot;,&quot;fallbackUrl&quot;:&quot;https://res.cloudinary.com/dlcjuc3ej/image/upload/v1572535485/xokmqyvumsqposaheemj.svg#/keystone/api/icons/5dbafc93c9e7d80004b85b52/20191031152445/image/blood-vial-labelled.svg&quot;,&quot;size&quot;:{&quot;x&quot;:65,&quot;y&quot;:239},&quot;isPremium&quot;:false},&quot;source&quot;:{&quot;id&quot;:&quot;5dbafc93c9e7d80004b85b52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2&quot;}},&quot;0fbbfeea-2f9a-462e-b3dc-ddbe005602ac&quot;:{&quot;type&quot;:&quot;FIGURE_OBJECT&quot;,&quot;id&quot;:&quot;0fbbfeea-2f9a-462e-b3dc-ddbe005602ac&quot;,&quot;name&quot;:&quot;Blood vial cap&quot;,&quot;relativeTransform&quot;:{&quot;translate&quot;:{&quot;x&quot;:0,&quot;y&quot;:-48.08434964081768},&quot;rotate&quot;:0,&quot;skewX&quot;:0,&quot;scale&quot;:{&quot;x&quot;:0.4399298046141579,&quot;y&quot;:0.4399298046141579}},&quot;opacity&quot;:1,&quot;image&quot;:{&quot;url&quot;:&quot;https://icons.biorender.com/biorender/5dbafea2c9e7d80004b85b5f/20191031153357/image/blood-vial-cap.png&quot;,&quot;fallbackUrl&quot;:&quot;https://res.cloudinary.com/dlcjuc3ej/image/upload/v1572536037/xpaz3jnhluv07ckoqfe9.svg#/keystone/api/icons/5dbafea2c9e7d80004b85b5f/20191031153357/image/blood-vial-cap.svg&quot;,&quot;size&quot;:{&quot;x&quot;:65,&quot;y&quot;:79},&quot;isPremium&quot;:false},&quot;source&quot;:{&quot;id&quot;:&quot;5dbafea2c9e7d80004b85b5f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5&quot;}},&quot;7481b1fa-6cb6-48fe-a710-775100739e89&quot;:{&quot;relativeTransform&quot;:{&quot;translate&quot;:{&quot;x&quot;:-548.806,&quot;y&quot;:-80.596},&quot;rotate&quot;:0,&quot;skewX&quot;:0,&quot;scale&quot;:{&quot;x&quot;:1,&quot;y&quot;:1}},&quot;type&quot;:&quot;FIGURE_OBJECT&quot;,&quot;id&quot;:&quot;7481b1fa-6cb6-48fe-a710-775100739e89&quot;,&quot;parent&quot;:{&quot;type&quot;:&quot;CHILD&quot;,&quot;parentId&quot;:&quot;228b698d-4cee-4aaf-8d74-c84d91114676&quot;,&quot;order&quot;:&quot;9998&quot;},&quot;name&quot;:&quot;Clock&quot;,&quot;displayName&quot;:&quot;Clock&quot;,&quot;source&quot;:{&quot;id&quot;:&quot;61eb03a724d1c700a3a723ca&quot;,&quot;type&quot;:&quot;ASSETS&quot;},&quot;isPremium&quot;:true},&quot;b51a099c-1383-4790-a3a8-d93f5d4b8b5b&quot;:{&quot;type&quot;:&quot;FIGURE_OBJECT&quot;,&quot;id&quot;:&quot;b51a099c-1383-4790-a3a8-d93f5d4b8b5b&quot;,&quot;parent&quot;:{&quot;type&quot;:&quot;CHILD&quot;,&quot;parentId&quot;:&quot;7481b1fa-6cb6-48fe-a710-775100739e89&quot;,&quot;order&quot;:&quot;5&quot;},&quot;relativeTransform&quot;:{&quot;translate&quot;:{&quot;x&quot;:0,&quot;y&quot;:0},&quot;rotate&quot;:0}},&quot;e8f29d53-2ec1-4399-92a2-16534b58ccad&quot;:{&quot;type&quot;:&quot;FIGURE_OBJECT&quot;,&quot;id&quot;:&quot;e8f29d53-2ec1-4399-92a2-16534b58ccad&quot;,&quot;relativeTransform&quot;:{&quot;translate&quot;:{&quot;x&quot;:189.3573041196277,&quot;y&quot;:-154.8040334618941},&quot;rotate&quot;:0},&quot;opacity&quot;:1,&quot;path&quot;:{&quot;type&quot;:&quot;POLY_LINE&quot;,&quot;points&quot;:[{&quot;x&quot;:0,&quot;y&quot;:-12.657150968338991},{&quot;x&quot;:0,&quot;y&quot;:12.657150968338991}],&quot;closed&quot;:false},&quot;pathStyles&quot;:[{&quot;type&quot;:&quot;FILL&quot;,&quot;fillStyle&quot;:&quot;rgba(0,0,0,0)&quot;},{&quot;type&quot;:&quot;STROKE&quot;,&quot;strokeStyle&quot;:&quot;rgba(61, 61, 61, 1)&quot;,&quot;lineWidth&quot;:2.5,&quot;lineJoin&quot;:&quot;round&quot;,&quot;dashArray&quot;:[0]}],&quot;isLocked&quot;:false,&quot;parent&quot;:{&quot;type&quot;:&quot;CHILD&quot;,&quot;parentId&quot;:&quot;b51a099c-1383-4790-a3a8-d93f5d4b8b5b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0cde3c1e-db5d-48c6-8c78-d02bcb0ea33a&quot;:{&quot;type&quot;:&quot;FIGURE_OBJECT&quot;,&quot;id&quot;:&quot;0cde3c1e-db5d-48c6-8c78-d02bcb0ea33a&quot;,&quot;parent&quot;:{&quot;type&quot;:&quot;CROP&quot;,&quot;parentId&quot;:&quot;b51a099c-1383-4790-a3a8-d93f5d4b8b5b&quot;,&quot;order&quot;:&quot;5&quot;},&quot;relativeTransform&quot;:{&quot;translate&quot;:{&quot;x&quot;:189.3573041196277,&quot;y&quot;:-139.4040334618941},&quot;rotate&quot;:0,&quot;skewX&quot;:0,&quot;scale&quot;:{&quot;x&quot;:1.85,&quot;y&quot;:29.407150968338986}},&quot;path&quot;:{&quot;type&quot;:&quot;RECT&quot;,&quot;size&quot;:{&quot;x&quot;:2,&quot;y&quot;:2}},&quot;pathStyles&quot;:[{&quot;type&quot;:&quot;FILL&quot;,&quot;fillStyle&quot;:&quot;#fff&quot;}],&quot;isFrozen&quot;:true},&quot;7705654d-dbc6-46b6-bce6-6280dc15caf7&quot;:{&quot;type&quot;:&quot;FIGURE_OBJECT&quot;,&quot;id&quot;:&quot;7705654d-dbc6-46b6-bce6-6280dc15caf7&quot;,&quot;parent&quot;:{&quot;type&quot;:&quot;CHILD&quot;,&quot;parentId&quot;:&quot;7481b1fa-6cb6-48fe-a710-775100739e89&quot;,&quot;order&quot;:&quot;7&quot;},&quot;relativeTransform&quot;:{&quot;translate&quot;:{&quot;x&quot;:0,&quot;y&quot;:0},&quot;rotate&quot;:0}},&quot;25822147-62ea-4acf-a377-5ceec3b33d2c&quot;:{&quot;type&quot;:&quot;FIGURE_OBJECT&quot;,&quot;id&quot;:&quot;25822147-62ea-4acf-a377-5ceec3b33d2c&quot;,&quot;relativeTransform&quot;:{&quot;translate&quot;:{&quot;x&quot;:205.1143635164609,&quot;y&quot;:-139.4474797871799},&quot;rotate&quot;:1.5707963267948966},&quot;opacity&quot;:1,&quot;path&quot;:{&quot;type&quot;:&quot;POLY_LINE&quot;,&quot;points&quot;:[{&quot;x&quot;:-0.2074942849213386,&quot;y&quot;:-6.6398167056200155},{&quot;x&quot;:0,&quot;y&quot;:12.657150968338991}],&quot;closed&quot;:false},&quot;pathStyles&quot;:[{&quot;type&quot;:&quot;FILL&quot;,&quot;fillStyle&quot;:&quot;rgba(0,0,0,0)&quot;},{&quot;type&quot;:&quot;STROKE&quot;,&quot;strokeStyle&quot;:&quot;rgba(61, 61, 61, 1)&quot;,&quot;lineWidth&quot;:2.5,&quot;lineJoin&quot;:&quot;round&quot;,&quot;dashArray&quot;:[0]}],&quot;isLocked&quot;:false,&quot;parent&quot;:{&quot;type&quot;:&quot;CHILD&quot;,&quot;parentId&quot;:&quot;7705654d-dbc6-46b6-bce6-6280dc15caf7&quot;,&quot;order&quot;:&quot;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Start&quot;:{&quot;type&quot;:&quot;PATH&quot;,&quot;units&quot;:{&quot;type&quot;:&quot;STROKE_WIDTH&quot;,&quot;scale&quot;:1},&quot;orient&quot;:{&quot;type&quot;:&quot;AUTO_START_REVERSE&quot;},&quot;name&quot;:&quot;rounded-end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-0.5,&quot;y&quot;:0,&quot;isEndPoint&quot;:true},{&quot;x&quot;:-0.49999999999999994,&quot;y&quot;:0.2761423749153967,&quot;isEndPoint&quot;:false},{&quot;x&quot;:-0.2761423749153966,&quot;y&quot;:0.5,&quot;isEndPoint&quot;:false},{&quot;x&quot;:3.061616997868383e-17,&quot;y&quot;:0.5,&quot;isEndPoint&quot;:true},{&quot;x&quot;:0.2761423749153967,&quot;y&quot;:0.5,&quot;isEndPoint&quot;:false},{&quot;x&quot;:0.5,&quot;y&quot;:0.27614237491539667,&quot;isEndPoint&quot;:false},{&quot;x&quot;:0.5,&quot;y&quot;:0,&quot;isEndPoint&quot;:true},{&quot;x&quot;:0.5,&quot;y&quot;:-0.27614237491539667,&quot;isEndPoint&quot;:false},{&quot;x&quot;:0.2761423749153967,&quot;y&quot;:-0.5,&quot;isEndPoint&quot;:false},{&quot;x&quot;:3.061616997868383e-17,&quot;y&quot;:-0.5,&quot;isEndPoint&quot;:true},{&quot;x&quot;:-0.2761423749153966,&quot;y&quot;:-0.5,&quot;isEndPoint&quot;:false},{&quot;x&quot;:-0.49999999999999994,&quot;y&quot;:-0.2761423749153967,&quot;isEndPoint&quot;:false},{&quot;x&quot;:-0.5,&quot;y&quot;:-6.123233995736766e-17,&quot;isEndPoint&quot;:true}],&quot;closed&quot;:false}},&quot;pathStyles&quot;:[{&quot;type&quot;:&quot;FILL&quot;,&quot;fillStyle&quot;:&quot;context-stroke-flat&quot;}]}}},&quot;8ead36af-d5c0-4972-b481-c4fdae9ed34c&quot;:{&quot;type&quot;:&quot;FIGURE_OBJECT&quot;,&quot;id&quot;:&quot;8ead36af-d5c0-4972-b481-c4fdae9ed34c&quot;,&quot;parent&quot;:{&quot;type&quot;:&quot;CROP&quot;,&quot;parentId&quot;:&quot;7705654d-dbc6-46b6-bce6-6280dc15caf7&quot;,&quot;order&quot;:&quot;5&quot;},&quot;relativeTransform&quot;:{&quot;translate&quot;:{&quot;x&quot;:189.8056963851014,&quot;y&quot;:-139.55122692964056},&quot;rotate&quot;:0,&quot;skewX&quot;:0,&quot;scale&quot;:{&quot;x&quot;:23.496610265749162,&quot;y&quot;:1.6518735712303312}},&quot;path&quot;:{&quot;type&quot;:&quot;RECT&quot;,&quot;size&quot;:{&quot;x&quot;:2,&quot;y&quot;:2}},&quot;pathStyles&quot;:[{&quot;type&quot;:&quot;FILL&quot;,&quot;fillStyle&quot;:&quot;#fff&quot;}],&quot;isFrozen&quot;:true},&quot;e68872fb-aab0-4c06-9100-f0883069a56c&quot;:{&quot;id&quot;:&quot;e68872fb-aab0-4c06-9100-f0883069a56c&quot;,&quot;name&quot;:&quot;Clock (no hands)&quot;,&quot;type&quot;:&quot;FIGURE_OBJECT&quot;,&quot;relativeTransform&quot;:{&quot;translate&quot;:{&quot;x&quot;:189.80600000000004,&quot;y&quot;:-139.404},&quot;rotate&quot;:0,&quot;skewX&quot;:0,&quot;scale&quot;:{&quot;x&quot;:1,&quot;y&quot;:1}},&quot;image&quot;:{&quot;url&quot;:&quot;https://icons.biorender.com/biorender/61eafb6fa57cec0029a1480b/20220121183627/image/clock-no-hands-1.png&quot;,&quot;fallbackUrl&quot;:&quot;https://res.cloudinary.com/dlcjuc3ej/image/upload/v1642790187/jnm2u1bo1dpkmdmlx92k.svg#/keystone/api/icons/61eafb6fa57cec0029a1480b/20220121183627/image/clock-no-hands-1.svg&quot;,&quot;isPremium&quot;:false,&quot;isPacked&quot;:true,&quot;size&quot;:{&quot;x&quot;:100,&quot;y&quot;:100}},&quot;source&quot;:{&quot;id&quot;:&quot;61eafb6fa57cec0029a1480b&quot;,&quot;type&quot;:&quot;ASSETS&quot;},&quot;isPremium&quot;:false,&quot;parent&quot;:{&quot;type&quot;:&quot;CHILD&quot;,&quot;parentId&quot;:&quot;7481b1fa-6cb6-48fe-a710-775100739e89&quot;,&quot;order&quot;:&quot;2&quot;}},&quot;8ec2639d-7aa5-4bae-9926-529cfcbfacfa&quot;:{&quot;type&quot;:&quot;FIGURE_OBJECT&quot;,&quot;id&quot;:&quot;8ec2639d-7aa5-4bae-9926-529cfcbfacfa&quot;,&quot;relativeTransform&quot;:{&quot;translate&quot;:{&quot;x&quot;:-356.2141448486328,&quot;y&quot;:-216.85584146728516},&quot;rotate&quot;:0,&quot;skewX&quot;:0,&quot;scale&quot;:{&quot;x&quot;:0.79,&quot;y&quot;:0.79}},&quot;opacity&quot;:1,&quot;source&quot;:{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9&quot;}},&quot;42beb668-011a-4f33-acce-f24f3f00b276&quot;:{&quot;type&quot;:&quot;FIGURE_OBJECT&quot;,&quot;id&quot;:&quot;42beb668-011a-4f33-acce-f24f3f00b276&quot;,&quot;relativeTransform&quot;:{&quot;translate&quot;:{&quot;x&quot;:9.568657805025573,&quot;y&quot;:67.98753325297047},&quot;rotate&quot;:0,&quot;skewX&quot;:0,&quot;scale&quot;:{&quot;x&quot;:1,&quot;y&quot;:1}},&quot;opacity&quot;:1,&quot;path&quot;:{&quot;type&quot;:&quot;POLY_LINE&quot;,&quot;points&quot;:[{&quot;x&quot;:-57.21865780502557,&quot;y&quot;:5.222466747029529},{&quot;x&quot;:3.447629105299715,&quot;y&quot;:14.727387500866172},{&quot;x&quot;:57.21865780502558,&quot;y&quot;:-18.375794573561436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1&quot;}},&quot;c3965932-a251-46c9-91ee-694c432c3a6b&quot;:{&quot;type&quot;:&quot;FIGURE_OBJECT&quot;,&quot;id&quot;:&quot;c3965932-a251-46c9-91ee-694c432c3a6b&quot;,&quot;relativeTransform&quot;:{&quot;translate&quot;:{&quot;x&quot;:63.642415150172965,&quot;y&quot;:-22.603506741225722},&quot;rotate&quot;:0,&quot;skewX&quot;:0,&quot;scale&quot;:{&quot;x&quot;:1,&quot;y&quot;:1}},&quot;opacity&quot;:1,&quot;path&quot;:{&quot;type&quot;:&quot;POLY_LINE&quot;,&quot;points&quot;:[{&quot;x&quot;:11.87758484982703,&quot;y&quot;:59.07350674122572},{&quot;x&quot;:16.80114955627178,&quot;y&quot;:-8.177406785637139},{&quot;x&quot;:-22.788566480644,&quot;y&quot;:-59.07350674122572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2&quot;}},&quot;f2defbbd-11ca-4b6c-8dcb-e22638ad41c8&quot;:{&quot;type&quot;:&quot;FIGURE_OBJECT&quot;,&quot;id&quot;:&quot;f2defbbd-11ca-4b6c-8dcb-e22638ad41c8&quot;,&quot;relativeTransform&quot;:{&quot;translate&quot;:{&quot;x&quot;:-33.74439927369357,&quot;y&quot;:-69.20847869470347},&quot;rotate&quot;:0,&quot;skewX&quot;:0,&quot;scale&quot;:{&quot;x&quot;:1,&quot;y&quot;:1}},&quot;opacity&quot;:1,&quot;path&quot;:{&quot;type&quot;:&quot;POLY_LINE&quot;,&quot;points&quot;:[{&quot;x&quot;:50.74439927369357,&quot;y&quot;:-21.261521305296526},{&quot;x&quot;:-10.393001779168841,&quot;y&quot;:-15.722465712878815},{&quot;x&quot;:-50.74439927369357,&quot;y&quot;:25.312225478436844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5&quot;}},&quot;7efad75f-dc2a-4504-85a2-b45203b45ee1&quot;:{&quot;type&quot;:&quot;FIGURE_OBJECT&quot;,&quot;id&quot;:&quot;7efad75f-dc2a-4504-85a2-b45203b45ee1&quot;,&quot;relativeTransform&quot;:{&quot;translate&quot;:{&quot;x&quot;:-77.75747291427902,&quot;y&quot;:19.107910461425778},&quot;rotate&quot;:0,&quot;skewX&quot;:0,&quot;scale&quot;:{&quot;x&quot;:1,&quot;y&quot;:1}},&quot;opacity&quot;:1,&quot;path&quot;:{&quot;type&quot;:&quot;POLY_LINE&quot;,&quot;points&quot;:[{&quot;x&quot;:-12.812527085720973,&quot;y&quot;:-47.22791046142578},{&quot;x&quot;:-11.00116428512284,&quot;y&quot;:4.328242034912108},{&quot;x&quot;:16.80452567917159,&quot;y&quot;:47.22791046142578}],&quot;closed&quot;:false},&quot;pathStyles&quot;:[{&quot;type&quot;:&quot;FILL&quot;,&quot;fillStyle&quot;:&quot;rgba(0,0,0,0)&quot;},{&quot;type&quot;:&quot;STROKE&quot;,&quot;strokeStyle&quot;:&quot;#232323&quot;,&quot;lineWidth&quot;:3.34,&quot;lineJoin&quot;:&quot;round&quot;,&quot;dashArray&quot;:[0,0]}],&quot;pathSmoothing&quot;:{&quot;type&quot;:&quot;CATMULL_SMOOTHING&quot;,&quot;smoothing&quot;:0.2},&quot;pathMarkers&quot;:{&quot;markerEnd&quot;:{&quot;type&quot;:&quot;PATH&quot;,&quot;units&quot;:{&quot;type&quot;:&quot;STROKE_WIDTH&quot;,&quot;scale&quot;:0.6790419161676646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ec2639d-7aa5-4bae-9926-529cfcbfacfa&quot;,&quot;order&quot;:&quot;7&quot;}},&quot;101f89c8-8037-4165-a066-69a254ec3dfd&quot;:{&quot;id&quot;:&quot;101f89c8-8037-4165-a066-69a254ec3dfd&quot;,&quot;name&quot;:&quot;Calendar (symbol)&quot;,&quot;displayName&quot;:&quot;&quot;,&quot;type&quot;:&quot;FIGURE_OBJECT&quot;,&quot;relativeTransform&quot;:{&quot;translate&quot;:{&quot;x&quot;:-191,&quot;y&quot;:-256},&quot;rotate&quot;:0,&quot;skewX&quot;:0,&quot;scale&quot;:{&quot;x&quot;:1,&quot;y&quot;:1}},&quot;image&quot;:{&quot;url&quot;:&quot;https://icons.cdn.biorender.com/biorender/608c5188f4c35b0027d51951/20210430185154/image/608c5188f4c35b0027d51951.png&quot;,&quot;isPremium&quot;:false,&quot;isOrgIcon&quot;:false,&quot;size&quot;:{&quot;x&quot;:100,&quot;y&quot;:100}},&quot;source&quot;:{&quot;id&quot;:&quot;608c5188f4c35b0027d51951&quot;,&quot;version&quot;:&quot;20210430185154&quot;,&quot;type&quot;:&quot;ASSETS&quot;},&quot;isPremium&quot;:false,&quot;parent&quot;:{&quot;type&quot;:&quot;CHILD&quot;,&quot;parentId&quot;:&quot;228b698d-4cee-4aaf-8d74-c84d91114676&quot;,&quot;order&quot;:&quot;99995&quot;}},&quot;4bd4f57d-c5ae-474d-895d-a06f6d618876&quot;:{&quot;id&quot;:&quot;4bd4f57d-c5ae-474d-895d-a06f6d618876&quot;,&quot;name&quot;:&quot;Target identification (DNA, symbol)&quot;,&quot;displayName&quot;:&quot;&quot;,&quot;type&quot;:&quot;FIGURE_OBJECT&quot;,&quot;relativeTransform&quot;:{&quot;translate&quot;:{&quot;x&quot;:-14,&quot;y&quot;:-251},&quot;rotate&quot;:0,&quot;skewX&quot;:0,&quot;scale&quot;:{&quot;x&quot;:1,&quot;y&quot;:1}},&quot;image&quot;:{&quot;url&quot;:&quot;https://icons.cdn.biorender.com/biorender/67f56a8f32668bc7e42e0510/67f56a6432668bc7e42e04e4.png&quot;,&quot;isPremium&quot;:false,&quot;isOrgIcon&quot;:false,&quot;size&quot;:{&quot;x&quot;:100,&quot;y&quot;:100},&quot;fallbackUrl&quot;:&quot;sources/icons/67f56a8f32668bc7e42e0510/67f56a6432668bc7e42e04e4.svg&quot;},&quot;source&quot;:{&quot;id&quot;:&quot;67f56a6432668bc7e42e04e4&quot;,&quot;version&quot;:&quot;20250408182717&quot;,&quot;type&quot;:&quot;ASSETS&quot;},&quot;isPremium&quot;:false,&quot;parent&quot;:{&quot;type&quot;:&quot;CHILD&quot;,&quot;parentId&quot;:&quot;228b698d-4cee-4aaf-8d74-c84d91114676&quot;,&quot;order&quot;:&quot;99997&quot;}}}}"/>
  <p:tag name="TITLE" val="Untitled"/>
  <p:tag name="CREATORNAME" val="Samson Cantor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7785200"/>
  <p:tag name="VERSION" val="1773777157378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}}"/>
  <p:tag name="TITLE" val="Untitled"/>
  <p:tag name="CREATORNAME" val="Samson Cantor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7146468"/>
  <p:tag name="VERSION" val="1773777143216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260,&quot;y&quot;:6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}}"/>
  <p:tag name="TITLE" val="Untitled"/>
  <p:tag name="CREATORNAME" val="Samson Cantor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,&quot;715bbc95-2221-48e5-a0b2-e1ae84faa96a&quot;:{&quot;id&quot;:&quot;715bbc95-2221-48e5-a0b2-e1ae84faa96a&quot;,&quot;name&quot;:&quot;Glucose meter&quot;,&quot;displayName&quot;:&quot;&quot;,&quot;type&quot;:&quot;FIGURE_OBJECT&quot;,&quot;relativeTransform&quot;:{&quot;translate&quot;:{&quot;x&quot;:-374.8627450980392,&quot;y&quot;:127.5},&quot;rotate&quot;:0,&quot;skewX&quot;:0,&quot;scale&quot;:{&quot;x&quot;:0.2551633986928105,&quot;y&quot;:0.2551633986928105}},&quot;image&quot;:{&quot;url&quot;:&quot;https://icons.cdn.biorender.com/biorender/5cc36f64df35f43300d5ab9e/20190426205306/image/5cc36f64df35f43300d5ab9e.png&quot;,&quot;isPremium&quot;:false,&quot;isOrgIcon&quot;:false,&quot;size&quot;:{&quot;x&quot;:150,&quot;y&quot;:310.13513513513516}},&quot;source&quot;:{&quot;id&quot;:&quot;5cc36f64df35f43300d5ab9e&quot;,&quot;version&quot;:&quot;20190426205306&quot;,&quot;type&quot;:&quot;ASSETS&quot;},&quot;isPremium&quot;:false,&quot;parent&quot;:{&quot;type&quot;:&quot;CHILD&quot;,&quot;parentId&quot;:&quot;228b698d-4cee-4aaf-8d74-c84d91114676&quot;,&quot;order&quot;:&quot;97&quot;}},&quot;5f9c25af-4e61-4d01-a7f9-bc96f00ec0a3&quot;:{&quot;id&quot;:&quot;5f9c25af-4e61-4d01-a7f9-bc96f00ec0a3&quot;,&quot;name&quot;:&quot;Child 3 (head, gender-neutral, stage I obesity, anterior)&quot;,&quot;displayName&quot;:&quot;&quot;,&quot;type&quot;:&quot;FIGURE_OBJECT&quot;,&quot;relativeTransform&quot;:{&quot;translate&quot;:{&quot;x&quot;:-294,&quot;y&quot;:145},&quot;rotate&quot;:0,&quot;skewX&quot;:0,&quot;scale&quot;:{&quot;x&quot;:1,&quot;y&quot;:1}},&quot;image&quot;:{&quot;url&quot;:&quot;https://icons.cdn.biorender.com/biorender/671a9e69bdca4c36b346d6be/671a9e50bdca4c36b346d679.png&quot;,&quot;isPremium&quot;:true,&quot;isOrgIcon&quot;:false,&quot;size&quot;:{&quot;x&quot;:150,&quot;y&quot;:140.3485254691689},&quot;fallbackUrl&quot;:&quot;sources/icons/671a9e69bdca4c36b346d6be/671a9e50bdca4c36b346d679.svg&quot;},&quot;source&quot;:{&quot;id&quot;:&quot;671a9e50bdca4c36b346d679&quot;,&quot;version&quot;:&quot;20241024192203&quot;,&quot;type&quot;:&quot;ASSETS&quot;},&quot;isPremium&quot;:true,&quot;parent&quot;:{&quot;type&quot;:&quot;CHILD&quot;,&quot;parentId&quot;:&quot;228b698d-4cee-4aaf-8d74-c84d91114676&quot;,&quot;order&quot;:&quot;98&quot;}},&quot;3bbfb5a3-190d-4c8e-8632-87cfbfcbc871&quot;:{&quot;relativeTransform&quot;:{&quot;translate&quot;:{&quot;x&quot;:-149.81948063774848,&quot;y&quot;:364.7558646383225},&quot;rotate&quot;:0,&quot;skewX&quot;:0,&quot;scale&quot;:{&quot;x&quot;:1,&quot;y&quot;:1}},&quot;type&quot;:&quot;FIGURE_OBJECT&quot;,&quot;id&quot;:&quot;3bbfb5a3-190d-4c8e-8632-87cfbfcbc871&quot;,&quot;parent&quot;:{&quot;type&quot;:&quot;CHILD&quot;,&quot;parentId&quot;:&quot;228b698d-4cee-4aaf-8d74-c84d91114676&quot;,&quot;order&quot;:&quot;99&quot;},&quot;name&quot;:&quot;Pill cluster&quot;,&quot;displayName&quot;:&quot;Pill cluster&quot;,&quot;source&quot;:{&quot;id&quot;:&quot;608aeff9ac44b300a20aaf63&quot;,&quot;type&quot;:&quot;ASSETS&quot;},&quot;isPremium&quot;:true},&quot;69882f09-baa4-49ed-abcd-6bf96fb71bd7&quot;:{&quot;id&quot;:&quot;69882f09-baa4-49ed-abcd-6bf96fb71bd7&quot;,&quot;name&quot;:&quot;Pill&quot;,&quot;type&quot;:&quot;FIGURE_OBJECT&quot;,&quot;relativeTransform&quot;:{&quot;translate&quot;:{&quot;x&quot;:-54.567779158393485,&quot;y&quot;:-259.7289704286371},&quot;rotate&quot;:-0.22017744070666753,&quot;skewX&quot;:0,&quot;scale&quot;:{&quot;x&quot;:0.55162259114342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2&quot;}},&quot;ffc78527-3a89-4f6b-b297-88c031402b45&quot;:{&quot;id&quot;:&quot;ffc78527-3a89-4f6b-b297-88c031402b45&quot;,&quot;name&quot;:&quot;Pill&quot;,&quot;type&quot;:&quot;FIGURE_OBJECT&quot;,&quot;relativeTransform&quot;:{&quot;translate&quot;:{&quot;x&quot;:-38.0779636962714,&quot;y&quot;:-232.27741754225076},&quot;rotate&quot;:2.731657600636832,&quot;skewX&quot;:9.12149764969962e-17,&quot;scale&quot;:{&quot;x&quot;:0.551622591143428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5&quot;},&quot;opacity&quot;:0.78},&quot;ee11c06a-3576-4aa5-bb01-3a4c719cd33b&quot;:{&quot;id&quot;:&quot;ee11c06a-3576-4aa5-bb01-3a4c719cd33b&quot;,&quot;name&quot;:&quot;Pill&quot;,&quot;type&quot;:&quot;FIGURE_OBJECT&quot;,&quot;relativeTransform&quot;:{&quot;translate&quot;:{&quot;x&quot;:-52.58371747724082,&quot;y&quot;:-214.37741536307334},&quot;rotate&quot;:-7.642229304742056e-17,&quot;skewX&quot;:-7.642229304742057e-17,&quot;scale&quot;:{&quot;x&quot;:0.5516225911434285,&quot;y&quot;:0.5516225911434287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7&quot;}}}}"/>
  <p:tag name="TRANSPARENTBACKGROUND" val="true"/>
  <p:tag name="VERSION" val="1773779411388"/>
  <p:tag name="TITLE" val="Untitled"/>
  <p:tag name="CREATORNAME" val="Samson Cantor"/>
  <p:tag name="DATEINSERTED" val="1773779668605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7785200"/>
  <p:tag name="VERSION" val="1773777157378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}}"/>
  <p:tag name="TITLE" val="Untitled"/>
  <p:tag name="CREATORNAME" val="Samson Cantor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7785200"/>
  <p:tag name="VERSION" val="1773777157378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}}"/>
  <p:tag name="TITLE" val="Untitled"/>
  <p:tag name="CREATORNAME" val="Samson Cantor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TRANSPARENTBACKGROUND" val="true"/>
  <p:tag name="DATEINSERTED" val="1773778854878"/>
  <p:tag name="VERSION" val="1773777157378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}}"/>
  <p:tag name="TITLE" val="Untitled"/>
  <p:tag name="CREATORNAME" val="Samson Cantor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b9a69869ef7a40efd06ae0"/>
  <p:tag name="BIOJSON" val="{&quot;id&quot;:&quot;0f727b71-3857-49bf-a999-d1fadd42b4ad&quot;,&quot;objects&quot;:{&quot;0f727b71-3857-49bf-a999-d1fadd42b4ad&quot;:{&quot;id&quot;:&quot;0f727b71-3857-49bf-a999-d1fadd42b4ad&quot;,&quot;type&quot;:&quot;FIGURE_OBJECT&quot;,&quot;document&quot;:{&quot;type&quot;:&quot;DOCUMENT_GROUP&quot;,&quot;canvasType&quot;:&quot;FIGURE&quot;,&quot;units&quot;:&quot;in&quot;}},&quot;f30e10e8-7ee7-4c4f-a8ce-b30a29078bdd&quot;:{&quot;id&quot;:&quot;f30e10e8-7ee7-4c4f-a8ce-b30a29078bd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0f727b71-3857-49bf-a999-d1fadd42b4ad&quot;,&quot;type&quot;:&quot;FRAME&quot;,&quot;order&quot;:&quot;5&quot;}},&quot;228b698d-4cee-4aaf-8d74-c84d91114676&quot;:{&quot;id&quot;:&quot;228b698d-4cee-4aaf-8d74-c84d91114676&quot;,&quot;type&quot;:&quot;FIGURE_OBJECT&quot;,&quot;document&quot;:{&quot;type&quot;:&quot;FIGURE&quot;,&quot;canvasType&quot;:&quot;FIGURE&quot;,&quot;units&quot;:&quot;in&quot;},&quot;parent&quot;:{&quot;parentId&quot;:&quot;0f727b71-3857-49bf-a999-d1fadd42b4ad&quot;,&quot;type&quot;:&quot;DOCUMENT&quot;,&quot;order&quot;:&quot;5&quot;}},&quot;46f9fec0-59ad-4cfc-9fba-384f2cdc96a8&quot;:{&quot;id&quot;:&quot;46f9fec0-59ad-4cfc-9fba-384f2cdc96a8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228b698d-4cee-4aaf-8d74-c84d91114676&quot;,&quot;order&quot;:&quot;5&quot;}},&quot;34859353-ac85-4cde-829f-f4f2b84c1cb6&quot;:{&quot;id&quot;:&quot;34859353-ac85-4cde-829f-f4f2b84c1cb6&quot;,&quot;type&quot;:&quot;FIGURE_OBJECT&quot;,&quot;guide&quot;:{&quot;type&quot;:&quot;GRID&quot;,&quot;distance&quot;:0.5,&quot;units&quot;:&quot;in&quot;},&quot;parent&quot;:{&quot;parentId&quot;:&quot;0f727b71-3857-49bf-a999-d1fadd42b4ad&quot;,&quot;type&quot;:&quot;GUIDE&quot;,&quot;order&quot;:&quot;5&quot;}},&quot;2f970fd3-ecfb-458c-933e-26ee3ded3c9b&quot;:{&quot;id&quot;:&quot;2f970fd3-ecfb-458c-933e-26ee3ded3c9b&quot;,&quot;name&quot;:&quot;Liver&quot;,&quot;displayName&quot;:&quot;&quot;,&quot;type&quot;:&quot;FIGURE_OBJECT&quot;,&quot;relativeTransform&quot;:{&quot;translate&quot;:{&quot;x&quot;:10,&quot;y&quot;:10},&quot;scale&quot;:{&quot;x&quot;:1,&quot;y&quot;:1},&quot;rotate&quot;:0,&quot;skewX&quot;:0},&quot;image&quot;:{&quot;url&quot;:&quot;https://icons.cdn.biorender.com/biorender/5db9d9c7c9e7d80004b85ab3/20191030184544/image/5db9d9c7c9e7d80004b85ab3.png&quot;,&quot;isPremium&quot;:false,&quot;isOrgIcon&quot;:false,&quot;size&quot;:{&quot;x&quot;:125,&quot;y&quot;:84.63541666666666}},&quot;source&quot;:{&quot;id&quot;:&quot;5db9d9c7c9e7d80004b85ab3&quot;,&quot;version&quot;:&quot;20191030184544&quot;,&quot;type&quot;:&quot;ASSETS&quot;},&quot;isPremium&quot;:false,&quot;parent&quot;:{&quot;type&quot;:&quot;CHILD&quot;,&quot;parentId&quot;:&quot;228b698d-4cee-4aaf-8d74-c84d91114676&quot;,&quot;order&quot;:&quot;5&quot;}},&quot;80d47902-96bd-4b13-9f83-294c1979bee9&quot;:{&quot;id&quot;:&quot;80d47902-96bd-4b13-9f83-294c1979bee9&quot;,&quot;name&quot;:&quot;Genomics (symbol) 1&quot;,&quot;displayName&quot;:&quot;&quot;,&quot;type&quot;:&quot;FIGURE_OBJECT&quot;,&quot;relativeTransform&quot;:{&quot;translate&quot;:{&quot;x&quot;:-145,&quot;y&quot;:11},&quot;rotate&quot;:0,&quot;skewX&quot;:0,&quot;scale&quot;:{&quot;x&quot;:1,&quot;y&quot;:1}},&quot;image&quot;:{&quot;url&quot;:&quot;https://icons.cdn.biorender.com/biorender/67f41ad45789a559ab3abca2/20250407183712/image/67f41ad45789a559ab3abca2.png&quot;,&quot;isPremium&quot;:false,&quot;isOrgIcon&quot;:false,&quot;size&quot;:{&quot;x&quot;:100,&quot;y&quot;:100}},&quot;source&quot;:{&quot;id&quot;:&quot;67f41ad45789a559ab3abca2&quot;,&quot;version&quot;:&quot;20250407183712&quot;,&quot;type&quot;:&quot;ASSETS&quot;},&quot;isPremium&quot;:false,&quot;parent&quot;:{&quot;type&quot;:&quot;CHILD&quot;,&quot;parentId&quot;:&quot;228b698d-4cee-4aaf-8d74-c84d91114676&quot;,&quot;order&quot;:&quot;7&quot;}},&quot;6d7641c4-2390-40ac-9d76-1c9b681f4394&quot;:{&quot;id&quot;:&quot;6d7641c4-2390-40ac-9d76-1c9b681f4394&quot;,&quot;name&quot;:&quot;DNA (medium)&quot;,&quot;displayName&quot;:&quot;&quot;,&quot;type&quot;:&quot;FIGURE_OBJECT&quot;,&quot;relativeTransform&quot;:{&quot;translate&quot;:{&quot;x&quot;:-309,&quot;y&quot;:15},&quot;rotate&quot;:0,&quot;skewX&quot;:0,&quot;scale&quot;:{&quot;x&quot;:1,&quot;y&quot;:1}},&quot;image&quot;:{&quot;url&quot;:&quot;https://icons.cdn.biorender.com/biorender/5b6b4b7ac820301400b3384b/20180808195908/image/5b6b4b7ac820301400b3384b.png&quot;,&quot;isPremium&quot;:false,&quot;isOrgIcon&quot;:false,&quot;size&quot;:{&quot;x&quot;:200,&quot;y&quot;:50.285714285714285}},&quot;source&quot;:{&quot;id&quot;:&quot;5b6b4b7ac820301400b3384b&quot;,&quot;version&quot;:&quot;20180808195908&quot;,&quot;type&quot;:&quot;ASSETS&quot;},&quot;isPremium&quot;:false,&quot;parent&quot;:{&quot;type&quot;:&quot;CHILD&quot;,&quot;parentId&quot;:&quot;228b698d-4cee-4aaf-8d74-c84d91114676&quot;,&quot;order&quot;:&quot;8&quot;}},&quot;587e0e58-70e3-442e-9572-caacf72095e7&quot;:{&quot;relativeTransform&quot;:{&quot;translate&quot;:{&quot;x&quot;:210.73360704167055,&quot;y&quot;:78.60849178065136},&quot;rotate&quot;:0,&quot;skewX&quot;:0,&quot;scale&quot;:{&quot;x&quot;:1,&quot;y&quot;:1}},&quot;type&quot;:&quot;FIGURE_OBJECT&quot;,&quot;id&quot;:&quot;587e0e58-70e3-442e-9572-caacf72095e7&quot;,&quot;parent&quot;:{&quot;type&quot;:&quot;CHILD&quot;,&quot;parentId&quot;:&quot;228b698d-4cee-4aaf-8d74-c84d91114676&quot;,&quot;order&quot;:&quot;9&quot;},&quot;name&quot;:&quot;DNA (short, with base pair)&quot;,&quot;displayName&quot;:&quot;DNA (short, with base pair)&quot;,&quot;source&quot;:{&quot;id&quot;:&quot;6061181f6639c800a68b5cc1&quot;,&quot;type&quot;:&quot;ASSETS&quot;},&quot;isPremium&quot;:true},&quot;4d71ca4d-0bdf-4169-9410-009b149faf6a&quot;:{&quot;id&quot;:&quot;4d71ca4d-0bdf-4169-9410-009b149faf6a&quot;,&quot;name&quot;:&quot;DNA (short)&quot;,&quot;type&quot;:&quot;FIGURE_OBJECT&quot;,&quot;relativeTransform&quot;:{&quot;translate&quot;:{&quot;x&quot;:-61.73360704167056,&quot;y&quot;:-68.2023623868352},&quot;rotate&quot;:0,&quot;skewX&quot;:0,&quot;scale&quot;:{&quot;x&quot;:0.9903967891723838,&quot;y&quot;:0.9903967891723837}},&quot;image&quot;:{&quot;url&quot;:&quot;https://icons.biorender.com/biorender/5b6b4b76c820301400b3383e/dna-short.png&quot;,&quot;fallbackUrl&quot;:&quot;https://res.cloudinary.com/dlcjuc3ej/image/upload/v1533758321/jrtaauzhphm4l0owima3.svg#/keystone/api/icons/5b6b4b76c820301400b3383e/dna-short.svg&quot;,&quot;isPremium&quot;:false,&quot;isPacked&quot;:true,&quot;size&quot;:{&quot;x&quot;:100,&quot;y&quot;:48.275862068965516}},&quot;source&quot;:{&quot;id&quot;:&quot;5b6b4b57c820301400b3383c&quot;,&quot;type&quot;:&quot;ASSETS&quot;},&quot;parent&quot;:{&quot;type&quot;:&quot;CHILD&quot;,&quot;parentId&quot;:&quot;587e0e58-70e3-442e-9572-caacf72095e7&quot;,&quot;order&quot;:&quot;2&quot;},&quot;opacity&quot;:0.7},&quot;38b427d8-d849-427f-b812-270461154701&quot;:{&quot;id&quot;:&quot;38b427d8-d849-427f-b812-270461154701&quot;,&quot;name&quot;:&quot;Nucleotide (single, curved 2)&quot;,&quot;type&quot;:&quot;FIGURE_OBJECT&quot;,&quot;relativeTransform&quot;:{&quot;translate&quot;:{&quot;x&quot;:-67.39937996167774,&quot;y&quot;:-77.88283189430598},&quot;rotate&quot;:0,&quot;skewX&quot;:0,&quot;scale&quot;:{&quot;x&quot;:0.2832476602839686,&quot;y&quot;:0.2832476602839685}},&quot;image&quot;:{&quot;url&quot;:&quot;https://icons.biorender.com/biorender/605e51352199d00028eca4e1/20210326213050/image/nucleotide-single-curved-2.png&quot;,&quot;fallbackUrl&quot;:&quot;https://res.cloudinary.com/dlcjuc3ej/image/upload/v1616794250/hnfz0y3jzd4mzwpiffys.svg#/keystone/api/icons/605e51352199d00028eca4e1/20210326213050/image/nucleotide-single-curved-2.svg&quot;,&quot;isPremium&quot;:false,&quot;isPacked&quot;:true,&quot;size&quot;:{&quot;x&quot;:50,&quot;y&quot;:95.45454545454545}},&quot;source&quot;:{&quot;id&quot;:&quot;605e51352199d00028eca4e1&quot;,&quot;type&quot;:&quot;ASSETS&quot;},&quot;parent&quot;:{&quot;type&quot;:&quot;CHILD&quot;,&quot;parentId&quot;:&quot;587e0e58-70e3-442e-9572-caacf72095e7&quot;,&quot;order&quot;:&quot;5&quot;}},&quot;35fd916c-eea0-4c36-a5ff-fc3eeb53fd0e&quot;:{&quot;id&quot;:&quot;35fd916c-eea0-4c36-a5ff-fc3eeb53fd0e&quot;,&quot;name&quot;:&quot;Nucleotide (single, curved)&quot;,&quot;type&quot;:&quot;FIGURE_OBJECT&quot;,&quot;relativeTransform&quot;:{&quot;translate&quot;:{&quot;x&quot;:-67.43704226552022,&quot;y&quot;:-56.051873123309235},&quot;rotate&quot;:-3.141592653589793,&quot;skewX&quot;:-1.900157576055225e-32,&quot;scale&quot;:{&quot;x&quot;:0.28475438953847326,&quot;y&quot;:0.28475438953847326}},&quot;image&quot;:{&quot;url&quot;:&quot;https://icons.biorender.com/biorender/605e51222199d00028eca4d9/nucleotide-single-curved.png&quot;,&quot;fallbackUrl&quot;:&quot;https://res.cloudinary.com/dlcjuc3ej/image/upload/v1616793885/jwsrpj7ttwhtvizmvlcr.svg#/keystone/api/icons/605e51222199d00028eca4d9/nucleotide-single-curved.svg&quot;,&quot;isPremium&quot;:false,&quot;isPacked&quot;:true,&quot;size&quot;:{&quot;x&quot;:50,&quot;y&quot;:90.9090909090909}},&quot;source&quot;:{&quot;id&quot;:&quot;605e502f2199d00028eca4c4&quot;,&quot;type&quot;:&quot;ASSETS&quot;},&quot;parent&quot;:{&quot;type&quot;:&quot;CHILD&quot;,&quot;parentId&quot;:&quot;587e0e58-70e3-442e-9572-caacf72095e7&quot;,&quot;order&quot;:&quot;7&quot;}},&quot;a0e338ee-45e4-4dfc-8de5-30023167aa20&quot;:{&quot;id&quot;:&quot;a0e338ee-45e4-4dfc-8de5-30023167aa20&quot;,&quot;name&quot;:&quot;Metabolism (ADMET, symbol)&quot;,&quot;displayName&quot;:&quot;&quot;,&quot;type&quot;:&quot;FIGURE_OBJECT&quot;,&quot;relativeTransform&quot;:{&quot;translate&quot;:{&quot;x&quot;:309,&quot;y&quot;:5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5&quot;}},&quot;715bbc95-2221-48e5-a0b2-e1ae84faa96a&quot;:{&quot;id&quot;:&quot;715bbc95-2221-48e5-a0b2-e1ae84faa96a&quot;,&quot;name&quot;:&quot;Glucose meter&quot;,&quot;displayName&quot;:&quot;&quot;,&quot;type&quot;:&quot;FIGURE_OBJECT&quot;,&quot;relativeTransform&quot;:{&quot;translate&quot;:{&quot;x&quot;:-374.8627450980392,&quot;y&quot;:127.5},&quot;rotate&quot;:0,&quot;skewX&quot;:0,&quot;scale&quot;:{&quot;x&quot;:0.2551633986928105,&quot;y&quot;:0.2551633986928105}},&quot;image&quot;:{&quot;url&quot;:&quot;https://icons.cdn.biorender.com/biorender/5cc36f64df35f43300d5ab9e/20190426205306/image/5cc36f64df35f43300d5ab9e.png&quot;,&quot;isPremium&quot;:false,&quot;isOrgIcon&quot;:false,&quot;size&quot;:{&quot;x&quot;:150,&quot;y&quot;:310.13513513513516}},&quot;source&quot;:{&quot;id&quot;:&quot;5cc36f64df35f43300d5ab9e&quot;,&quot;version&quot;:&quot;20190426205306&quot;,&quot;type&quot;:&quot;ASSETS&quot;},&quot;isPremium&quot;:false,&quot;parent&quot;:{&quot;type&quot;:&quot;CHILD&quot;,&quot;parentId&quot;:&quot;228b698d-4cee-4aaf-8d74-c84d91114676&quot;,&quot;order&quot;:&quot;97&quot;}},&quot;5f9c25af-4e61-4d01-a7f9-bc96f00ec0a3&quot;:{&quot;id&quot;:&quot;5f9c25af-4e61-4d01-a7f9-bc96f00ec0a3&quot;,&quot;name&quot;:&quot;Child 3 (head, gender-neutral, stage I obesity, anterior)&quot;,&quot;displayName&quot;:&quot;&quot;,&quot;type&quot;:&quot;FIGURE_OBJECT&quot;,&quot;relativeTransform&quot;:{&quot;translate&quot;:{&quot;x&quot;:-294,&quot;y&quot;:145},&quot;rotate&quot;:0,&quot;skewX&quot;:0,&quot;scale&quot;:{&quot;x&quot;:1,&quot;y&quot;:1}},&quot;image&quot;:{&quot;url&quot;:&quot;https://icons.cdn.biorender.com/biorender/671a9e69bdca4c36b346d6be/671a9e50bdca4c36b346d679.png&quot;,&quot;isPremium&quot;:true,&quot;isOrgIcon&quot;:false,&quot;size&quot;:{&quot;x&quot;:150,&quot;y&quot;:140.3485254691689},&quot;fallbackUrl&quot;:&quot;sources/icons/671a9e69bdca4c36b346d6be/671a9e50bdca4c36b346d679.svg&quot;},&quot;source&quot;:{&quot;id&quot;:&quot;671a9e50bdca4c36b346d679&quot;,&quot;version&quot;:&quot;20241024192203&quot;,&quot;type&quot;:&quot;ASSETS&quot;},&quot;isPremium&quot;:true,&quot;parent&quot;:{&quot;type&quot;:&quot;CHILD&quot;,&quot;parentId&quot;:&quot;228b698d-4cee-4aaf-8d74-c84d91114676&quot;,&quot;order&quot;:&quot;98&quot;}},&quot;3bbfb5a3-190d-4c8e-8632-87cfbfcbc871&quot;:{&quot;relativeTransform&quot;:{&quot;translate&quot;:{&quot;x&quot;:-149.81948063774848,&quot;y&quot;:364.7558646383225},&quot;rotate&quot;:0,&quot;skewX&quot;:0,&quot;scale&quot;:{&quot;x&quot;:1,&quot;y&quot;:1}},&quot;type&quot;:&quot;FIGURE_OBJECT&quot;,&quot;id&quot;:&quot;3bbfb5a3-190d-4c8e-8632-87cfbfcbc871&quot;,&quot;parent&quot;:{&quot;type&quot;:&quot;CHILD&quot;,&quot;parentId&quot;:&quot;228b698d-4cee-4aaf-8d74-c84d91114676&quot;,&quot;order&quot;:&quot;99&quot;},&quot;name&quot;:&quot;Pill cluster&quot;,&quot;displayName&quot;:&quot;Pill cluster&quot;,&quot;source&quot;:{&quot;id&quot;:&quot;608aeff9ac44b300a20aaf63&quot;,&quot;type&quot;:&quot;ASSETS&quot;},&quot;isPremium&quot;:true},&quot;69882f09-baa4-49ed-abcd-6bf96fb71bd7&quot;:{&quot;id&quot;:&quot;69882f09-baa4-49ed-abcd-6bf96fb71bd7&quot;,&quot;name&quot;:&quot;Pill&quot;,&quot;type&quot;:&quot;FIGURE_OBJECT&quot;,&quot;relativeTransform&quot;:{&quot;translate&quot;:{&quot;x&quot;:-54.567779158393485,&quot;y&quot;:-259.7289704286371},&quot;rotate&quot;:-0.22017744070666753,&quot;skewX&quot;:0,&quot;scale&quot;:{&quot;x&quot;:0.55162259114342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2&quot;}},&quot;ffc78527-3a89-4f6b-b297-88c031402b45&quot;:{&quot;id&quot;:&quot;ffc78527-3a89-4f6b-b297-88c031402b45&quot;,&quot;name&quot;:&quot;Pill&quot;,&quot;type&quot;:&quot;FIGURE_OBJECT&quot;,&quot;relativeTransform&quot;:{&quot;translate&quot;:{&quot;x&quot;:-38.0779636962714,&quot;y&quot;:-232.27741754225076},&quot;rotate&quot;:2.731657600636832,&quot;skewX&quot;:9.12149764969962e-17,&quot;scale&quot;:{&quot;x&quot;:0.5516225911434288,&quot;y&quot;:0.5516225911434288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5&quot;},&quot;opacity&quot;:0.78},&quot;ee11c06a-3576-4aa5-bb01-3a4c719cd33b&quot;:{&quot;id&quot;:&quot;ee11c06a-3576-4aa5-bb01-3a4c719cd33b&quot;,&quot;name&quot;:&quot;Pill&quot;,&quot;type&quot;:&quot;FIGURE_OBJECT&quot;,&quot;relativeTransform&quot;:{&quot;translate&quot;:{&quot;x&quot;:-52.58371747724082,&quot;y&quot;:-214.37741536307334},&quot;rotate&quot;:-7.642229304742056e-17,&quot;skewX&quot;:-7.642229304742057e-17,&quot;scale&quot;:{&quot;x&quot;:0.5516225911434285,&quot;y&quot;:0.5516225911434287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3bbfb5a3-190d-4c8e-8632-87cfbfcbc871&quot;,&quot;order&quot;:&quot;7&quot;}},&quot;dbf3c7e6-af9c-4614-aaa1-0ec60faa16bc&quot;:{&quot;id&quot;:&quot;dbf3c7e6-af9c-4614-aaa1-0ec60faa16bc&quot;,&quot;name&quot;:&quot;Absorption (ADMET, symbol)&quot;,&quot;displayName&quot;:&quot;&quot;,&quot;type&quot;:&quot;FIGURE_OBJECT&quot;,&quot;relativeTransform&quot;:{&quot;translate&quot;:{&quot;x&quot;:-86,&quot;y&quot;:-114.67426273458443},&quot;rotate&quot;:0,&quot;skewX&quot;:0,&quot;scale&quot;:{&quot;x&quot;:1,&quot;y&quot;:1}},&quot;image&quot;:{&quot;url&quot;:&quot;https://icons.cdn.biorender.com/biorender/67f5906e8036a7aacbd4cedb/20250408211342/image/67f5906e8036a7aacbd4cedb.png&quot;,&quot;isPremium&quot;:false,&quot;isOrgIcon&quot;:false,&quot;size&quot;:{&quot;x&quot;:100,&quot;y&quot;:100}},&quot;source&quot;:{&quot;id&quot;:&quot;67f5906e8036a7aacbd4cedb&quot;,&quot;version&quot;:&quot;20250408211342&quot;,&quot;type&quot;:&quot;ASSETS&quot;},&quot;isPremium&quot;:false,&quot;parent&quot;:{&quot;type&quot;:&quot;CHILD&quot;,&quot;parentId&quot;:&quot;228b698d-4cee-4aaf-8d74-c84d91114676&quot;,&quot;order&quot;:&quot;995&quot;}},&quot;64a73b3b-f713-499c-8bb0-94022021977b&quot;:{&quot;id&quot;:&quot;64a73b3b-f713-499c-8bb0-94022021977b&quot;,&quot;name&quot;:&quot;Metabolism (ADMET, symbol)&quot;,&quot;displayName&quot;:&quot;&quot;,&quot;type&quot;:&quot;FIGURE_OBJECT&quot;,&quot;relativeTransform&quot;:{&quot;translate&quot;:{&quot;x&quot;:25,&quot;y&quot;:-116.67426273458443},&quot;rotate&quot;:0,&quot;skewX&quot;:0,&quot;scale&quot;:{&quot;x&quot;:1,&quot;y&quot;:1}},&quot;image&quot;:{&quot;url&quot;:&quot;https://icons.cdn.biorender.com/biorender/67f594d28036a7aacbd4d172/20250408212856/image/67f594d28036a7aacbd4d172.png&quot;,&quot;isPremium&quot;:false,&quot;isOrgIcon&quot;:false,&quot;size&quot;:{&quot;x&quot;:100,&quot;y&quot;:77.75}},&quot;source&quot;:{&quot;id&quot;:&quot;67f594d28036a7aacbd4d172&quot;,&quot;version&quot;:&quot;20250408212856&quot;,&quot;type&quot;:&quot;ASSETS&quot;},&quot;isPremium&quot;:false,&quot;parent&quot;:{&quot;type&quot;:&quot;CHILD&quot;,&quot;parentId&quot;:&quot;228b698d-4cee-4aaf-8d74-c84d91114676&quot;,&quot;order&quot;:&quot;997&quot;}},&quot;ac397bb5-a291-43a5-8402-3dd47a8fd2de&quot;:{&quot;id&quot;:&quot;ac397bb5-a291-43a5-8402-3dd47a8fd2de&quot;,&quot;name&quot;:&quot;Excretion (ADMET, symbol)&quot;,&quot;displayName&quot;:&quot;&quot;,&quot;type&quot;:&quot;FIGURE_OBJECT&quot;,&quot;relativeTransform&quot;:{&quot;translate&quot;:{&quot;x&quot;:124,&quot;y&quot;:-117.67426273458443},&quot;rotate&quot;:0,&quot;skewX&quot;:0,&quot;scale&quot;:{&quot;x&quot;:1,&quot;y&quot;:1}},&quot;image&quot;:{&quot;url&quot;:&quot;https://icons.cdn.biorender.com/biorender/67f5952f8036a7aacbd4d1e9/20250408212945/image/67f5952f8036a7aacbd4d1e9.png&quot;,&quot;isPremium&quot;:false,&quot;isOrgIcon&quot;:false,&quot;size&quot;:{&quot;x&quot;:100,&quot;y&quot;:100}},&quot;source&quot;:{&quot;id&quot;:&quot;67f5952f8036a7aacbd4d1e9&quot;,&quot;version&quot;:&quot;20250408212945&quot;,&quot;type&quot;:&quot;ASSETS&quot;},&quot;isPremium&quot;:false,&quot;parent&quot;:{&quot;type&quot;:&quot;CHILD&quot;,&quot;parentId&quot;:&quot;228b698d-4cee-4aaf-8d74-c84d91114676&quot;,&quot;order&quot;:&quot;998&quot;}},&quot;be10db81-2c63-4af8-9a80-2e62a491e20b&quot;:{&quot;relativeTransform&quot;:{&quot;translate&quot;:{&quot;x&quot;:195.54388195061262,&quot;y&quot;:-34.44402995059181},&quot;rotate&quot;:0,&quot;skewX&quot;:0,&quot;scale&quot;:{&quot;x&quot;:1,&quot;y&quot;:1}},&quot;type&quot;:&quot;FIGURE_OBJECT&quot;,&quot;id&quot;:&quot;be10db81-2c63-4af8-9a80-2e62a491e20b&quot;,&quot;parent&quot;:{&quot;type&quot;:&quot;CHILD&quot;,&quot;parentId&quot;:&quot;228b698d-4cee-4aaf-8d74-c84d91114676&quot;,&quot;order&quot;:&quot;999&quot;},&quot;name&quot;:&quot;Adult male head (lateral, taking oral medication)&quot;,&quot;displayName&quot;:&quot;Adult male head (lateral, taking oral medication)&quot;,&quot;source&quot;:{&quot;id&quot;:&quot;63bc4d3e69764ef572715e51&quot;,&quot;type&quot;:&quot;ASSETS&quot;},&quot;isPremium&quot;:true},&quot;5ea02427-5ca5-48b7-ba18-a6b04e8fa193&quot;:{&quot;id&quot;:&quot;5ea02427-5ca5-48b7-ba18-a6b04e8fa193&quot;,&quot;name&quot;:&quot;Adult male head (lateral, open mouth)&quot;,&quot;displayName&quot;:&quot;&quot;,&quot;type&quot;:&quot;FIGURE_OBJECT&quot;,&quot;relativeTransform&quot;:{&quot;translate&quot;:{&quot;x&quot;:-44.69765631434586,&quot;y&quot;:181.4440299505918},&quot;rotate&quot;:0,&quot;skewX&quot;:0,&quot;scale&quot;:{&quot;x&quot;:1,&quot;y&quot;:1}},&quot;image&quot;:{&quot;url&quot;:&quot;https://icons.biorender.com/biorender/5ecd2dd9fc86fd00280efee8/20200526150009/image/adult-male-head-lateral-open-mouth.png&quot;,&quot;fallbackUrl&quot;:&quot;https://res.cloudinary.com/dlcjuc3ej/image/upload/v1590505209/cy467owkhsyjy1wjgwgy.svg#/keystone/api/icons/5ecd2dd9fc86fd00280efee8/20200526150009/image/adult-male-head-lateral-open-mouth.svg&quot;,&quot;isPremium&quot;:true,&quot;size&quot;:{&quot;x&quot;:100,&quot;y&quot;:145.95744680851064}},&quot;source&quot;:{&quot;id&quot;:&quot;5ecd2dd9fc86fd00280efee8&quot;,&quot;type&quot;:&quot;ASSETS&quot;},&quot;isPremium&quot;:true,&quot;parent&quot;:{&quot;type&quot;:&quot;CHILD&quot;,&quot;parentId&quot;:&quot;be10db81-2c63-4af8-9a80-2e62a491e20b&quot;,&quot;order&quot;:&quot;2&quot;}},&quot;2d92d51c-362e-4192-a6f0-afdf04b10350&quot;:{&quot;relativeTransform&quot;:{&quot;translate&quot;:{&quot;x&quot;:-108.89939975206015,&quot;y&quot;:269.268809325843},&quot;rotate&quot;:0,&quot;skewX&quot;:0,&quot;scale&quot;:{&quot;x&quot;:1,&quot;y&quot;:1}},&quot;type&quot;:&quot;FIGURE_OBJECT&quot;,&quot;id&quot;:&quot;2d92d51c-362e-4192-a6f0-afdf04b10350&quot;,&quot;parent&quot;:{&quot;type&quot;:&quot;CHILD&quot;,&quot;parentId&quot;:&quot;be10db81-2c63-4af8-9a80-2e62a491e20b&quot;,&quot;order&quot;:&quot;5&quot;},&quot;name&quot;:&quot;Pill cluster&quot;,&quot;displayName&quot;:&quot;Pill cluster&quot;,&quot;source&quot;:{&quot;id&quot;:&quot;608aeff9ac44b300a20aaf63&quot;,&quot;type&quot;:&quot;ASSETS&quot;},&quot;isPremium&quot;:true},&quot;bd97b65a-b41e-46e2-b85d-b1bdb8a18e50&quot;:{&quot;id&quot;:&quot;bd97b65a-b41e-46e2-b85d-b1bdb8a18e50&quot;,&quot;name&quot;:&quot;Pill&quot;,&quot;type&quot;:&quot;FIGURE_OBJECT&quot;,&quot;relativeTransform&quot;:{&quot;translate&quot;:{&quot;x&quot;:-14.310552926061176,&quot;y&quot;:-87.29506398454491},&quot;rotate&quot;:2.731657600636832,&quot;skewX&quot;:8.072550417700369e-17,&quot;scale&quot;:{&quot;x&quot;:0.20731214380936094,&quot;y&quot;:0.20731214380936125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5&quot;},&quot;opacity&quot;:0.78},&quot;2bd74ecf-0680-441a-ba07-3bf38a42c93e&quot;:{&quot;id&quot;:&quot;2bd74ecf-0680-441a-ba07-3bf38a42c93e&quot;,&quot;name&quot;:&quot;Pill&quot;,&quot;type&quot;:&quot;FIGURE_OBJECT&quot;,&quot;relativeTransform&quot;:{&quot;translate&quot;:{&quot;x&quot;:-19.762140591588093,&quot;y&quot;:-80.56784163082403},&quot;rotate&quot;:-7.642229304742056e-17,&quot;skewX&quot;:-7.642229304742064e-17,&quot;scale&quot;:{&quot;x&quot;:0.20731214380936086,&quot;y&quot;:0.2073121438093609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7&quot;}},&quot;4e9da238-c226-4237-9fff-754465ad1147&quot;:{&quot;id&quot;:&quot;4e9da238-c226-4237-9fff-754465ad1147&quot;,&quot;name&quot;:&quot;Pill&quot;,&quot;type&quot;:&quot;FIGURE_OBJECT&quot;,&quot;relativeTransform&quot;:{&quot;translate&quot;:{&quot;x&quot;:-20.507795478051605,&quot;y&quot;:-97.61197335545403},&quot;rotate&quot;:-0.2201774407066676,&quot;skewX&quot;:0,&quot;scale&quot;:{&quot;x&quot;:0.20731214380936067,&quot;y&quot;:0.2073121438093612}},&quot;image&quot;:{&quot;url&quot;:&quot;https://icons.biorender.com/biorender/5b9ffc15ea6f7814001db3db/pill.png&quot;,&quot;fallbackUrl&quot;:&quot;https://res.cloudinary.com/dlcjuc3ej/image/upload/v1537211407/onfiqfpvpwcid6i6h7r0.svg#/keystone/api/icons/5b9ffc15ea6f7814001db3db/pill.svg&quot;,&quot;isPremium&quot;:false,&quot;isPacked&quot;:true,&quot;size&quot;:{&quot;x&quot;:100,&quot;y&quot;:38.32116788321168}},&quot;source&quot;:{&quot;id&quot;:&quot;5a4d1669a3625100144d1491&quot;,&quot;type&quot;:&quot;ASSETS&quot;},&quot;parent&quot;:{&quot;type&quot;:&quot;CHILD&quot;,&quot;parentId&quot;:&quot;2d92d51c-362e-4192-a6f0-afdf04b10350&quot;,&quot;order&quot;:&quot;2&quot;}},&quot;34dbf796-49a7-4ab6-adb2-dfb7c143995c&quot;:{&quot;type&quot;:&quot;FIGURE_OBJECT&quot;,&quot;id&quot;:&quot;34dbf796-49a7-4ab6-adb2-dfb7c143995c&quot;,&quot;relativeTransform&quot;:{&quot;translate&quot;:{&quot;x&quot;:-97.31827780975603,&quot;y&quot;:179.09500275996288},&quot;rotate&quot;:0,&quot;skewX&quot;:0,&quot;scale&quot;:{&quot;x&quot;:1,&quot;y&quot;:1}},&quot;opacity&quot;:1,&quot;path&quot;:{&quot;type&quot;:&quot;POLY_LINE&quot;,&quot;points&quot;:[{&quot;x&quot;:-12.144126817834582,&quot;y&quot;:0},{&quot;x&quot;:-0.8333192585170209,&quot;y&quot;:0},{&quot;x&quot;:12.14412681783459,&quot;y&quot;:0}],&quot;closed&quot;:false,&quot;cornerRounding&quot;:{&quot;type&quot;:&quot;ARC_LENGTH&quot;,&quot;global&quot;:58.813885746365806}},&quot;pathStyles&quot;:[{&quot;type&quot;:&quot;FILL&quot;,&quot;fillStyle&quot;:&quot;transparent&quot;},{&quot;type&quot;:&quot;STROKE&quot;,&quot;strokeStyle&quot;:&quot;#232323&quot;,&quot;lineWidth&quot;:1.348508802440510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e10db81-2c63-4af8-9a80-2e62a491e20b&quot;,&quot;order&quot;:&quot;7&quot;}},&quot;40426b1f-f4a2-48f4-9ae7-77808da3515c&quot;:{&quot;id&quot;:&quot;40426b1f-f4a2-48f4-9ae7-77808da3515c&quot;,&quot;name&quot;:&quot;Adult (gender-neutral, lateral, taking pill) &quot;,&quot;displayName&quot;:&quot;&quot;,&quot;type&quot;:&quot;FIGURE_OBJECT&quot;,&quot;relativeTransform&quot;:{&quot;translate&quot;:{&quot;x&quot;:-221,&quot;y&quot;:-122},&quot;rotate&quot;:0,&quot;skewX&quot;:0,&quot;scale&quot;:{&quot;x&quot;:1,&quot;y&quot;:1}},&quot;image&quot;:{&quot;url&quot;:&quot;https://icons.cdn.biorender.com/biorender/672d005c9105801996905713/672ce05854021394a7d1b3c5.png&quot;,&quot;isPremium&quot;:false,&quot;isOrgIcon&quot;:false,&quot;size&quot;:{&quot;x&quot;:150,&quot;y&quot;:140.3485254691689},&quot;fallbackUrl&quot;:&quot;sources/icons/672d005c9105801996905713/672ce05854021394a7d1b3c5.svg&quot;},&quot;source&quot;:{&quot;id&quot;:&quot;672ce05854021394a7d1b3c5&quot;,&quot;version&quot;:&quot;20241107180047&quot;,&quot;type&quot;:&quot;ASSETS&quot;},&quot;isPremium&quot;:false,&quot;parent&quot;:{&quot;type&quot;:&quot;CHILD&quot;,&quot;parentId&quot;:&quot;228b698d-4cee-4aaf-8d74-c84d91114676&quot;,&quot;order&quot;:&quot;9995&quot;}},&quot;051254f3-c91c-46d4-904a-4f56f1f36c6c&quot;:{&quot;relativeTransform&quot;:{&quot;translate&quot;:{&quot;x&quot;:266.29771864996013,&quot;y&quot;:-129},&quot;rotate&quot;:0},&quot;type&quot;:&quot;FIGURE_OBJECT&quot;,&quot;id&quot;:&quot;051254f3-c91c-46d4-904a-4f56f1f36c6c&quot;,&quot;name&quot;:&quot;Blood vial (with blood and label, capped)&quot;,&quot;displayName&quot;:&quot;Blood vial (with blood and label, capped)&quot;,&quot;opacity&quot;:1,&quot;source&quot;:{&quot;id&quot;:&quot;5dbb01b84ef0b000810d2b0e&quot;,&quot;type&quot;:&quot;ASSETS&quot;},&quot;pathStyles&quot;:[{&quot;type&quot;:&quot;FILL&quot;,&quot;fillStyle&quot;:&quot;rgb(0,0,0)&quot;}],&quot;isLocked&quot;:false,&quot;parent&quot;:{&quot;type&quot;:&quot;CHILD&quot;,&quot;parentId&quot;:&quot;228b698d-4cee-4aaf-8d74-c84d91114676&quot;,&quot;order&quot;:&quot;9997&quot;},&quot;isPremium&quot;:true},&quot;ed197ed7-7fe7-4847-881d-92ed223786f5&quot;:{&quot;type&quot;:&quot;FIGURE_OBJECT&quot;,&quot;id&quot;:&quot;ed197ed7-7fe7-4847-881d-92ed223786f5&quot;,&quot;name&quot;:&quot;Blood vial (labelled)&quot;,&quot;relativeTransform&quot;:{&quot;translate&quot;:{&quot;x&quot;:2.0318280249341756e-15,&quot;y&quot;:12.889965271685073},&quot;rotate&quot;:0,&quot;skewX&quot;:0,&quot;scale&quot;:{&quot;x&quot;:0.439929804614158,&quot;y&quot;:0.4399298046141579}},&quot;opacity&quot;:1,&quot;image&quot;:{&quot;url&quot;:&quot;https://res.cloudinary.com/dlcjuc3ej/image/upload/v1572535485/xokmqyvumsqposaheemj.svg#/keystone/api/icons/5dbafc93c9e7d80004b85b52/20191031152445/image/blood-vial-labelled.svg&quot;,&quot;fallbackUrl&quot;:&quot;https://res.cloudinary.com/dlcjuc3ej/image/upload/v1572535485/xokmqyvumsqposaheemj.svg#/keystone/api/icons/5dbafc93c9e7d80004b85b52/20191031152445/image/blood-vial-labelled.svg&quot;,&quot;size&quot;:{&quot;x&quot;:65,&quot;y&quot;:239},&quot;isPremium&quot;:false},&quot;source&quot;:{&quot;id&quot;:&quot;5dbafc93c9e7d80004b85b52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2&quot;}},&quot;0fbbfeea-2f9a-462e-b3dc-ddbe005602ac&quot;:{&quot;type&quot;:&quot;FIGURE_OBJECT&quot;,&quot;id&quot;:&quot;0fbbfeea-2f9a-462e-b3dc-ddbe005602ac&quot;,&quot;name&quot;:&quot;Blood vial cap&quot;,&quot;relativeTransform&quot;:{&quot;translate&quot;:{&quot;x&quot;:0,&quot;y&quot;:-48.08434964081768},&quot;rotate&quot;:0,&quot;skewX&quot;:0,&quot;scale&quot;:{&quot;x&quot;:0.4399298046141579,&quot;y&quot;:0.4399298046141579}},&quot;opacity&quot;:1,&quot;image&quot;:{&quot;url&quot;:&quot;https://icons.biorender.com/biorender/5dbafea2c9e7d80004b85b5f/20191031153357/image/blood-vial-cap.png&quot;,&quot;fallbackUrl&quot;:&quot;https://res.cloudinary.com/dlcjuc3ej/image/upload/v1572536037/xpaz3jnhluv07ckoqfe9.svg#/keystone/api/icons/5dbafea2c9e7d80004b85b5f/20191031153357/image/blood-vial-cap.svg&quot;,&quot;size&quot;:{&quot;x&quot;:65,&quot;y&quot;:79},&quot;isPremium&quot;:false},&quot;source&quot;:{&quot;id&quot;:&quot;5dbafea2c9e7d80004b85b5f&quot;,&quot;type&quot;:&quot;ASSETS&quot;},&quot;pathStyles&quot;:[{&quot;type&quot;:&quot;FILL&quot;,&quot;fillStyle&quot;:&quot;rgb(0,0,0)&quot;}],&quot;isLocked&quot;:false,&quot;parent&quot;:{&quot;type&quot;:&quot;CHILD&quot;,&quot;parentId&quot;:&quot;051254f3-c91c-46d4-904a-4f56f1f36c6c&quot;,&quot;order&quot;:&quot;5&quot;}}}}"/>
  <p:tag name="TRANSPARENTBACKGROUND" val="true"/>
  <p:tag name="VERSION" val="1773844591560"/>
  <p:tag name="TITLE" val="Untitled"/>
  <p:tag name="CREATORNAME" val="Samson Cantor"/>
  <p:tag name="DATEINSERTED" val="1773845001059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4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A30B9224-AFF9-43AB-BB2C-6E027D658427}">
  <we:reference id="c22bf5f7-55ef-4467-ac55-88a268666587" version="1.0.0.5" store="EXCatalog" storeType="EXCatalog"/>
  <we:alternateReferences>
    <we:reference id="WA200006038" version="1.0.0.5" store="en-US" storeType="OMEX"/>
  </we:alternateReferences>
  <we:properties>
    <we:property name="has-user-completed-add" value="true"/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094</TotalTime>
  <Words>166</Words>
  <Application>Microsoft Office PowerPoint</Application>
  <PresentationFormat>Widescreen</PresentationFormat>
  <Paragraphs>4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ntor, Samson (NIH/NIDDK) [F]</dc:creator>
  <cp:lastModifiedBy>Cantor, Samson (NIH/NIDDK) [F]</cp:lastModifiedBy>
  <cp:revision>16</cp:revision>
  <dcterms:created xsi:type="dcterms:W3CDTF">2026-03-17T17:54:04Z</dcterms:created>
  <dcterms:modified xsi:type="dcterms:W3CDTF">2026-05-26T17:26:46Z</dcterms:modified>
</cp:coreProperties>
</file>